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 autoCompressPictures="0">
  <p:sldMasterIdLst>
    <p:sldMasterId id="2147483660" r:id="rId1"/>
  </p:sldMasterIdLst>
  <p:notesMasterIdLst>
    <p:notesMasterId r:id="rId6"/>
  </p:notesMasterIdLst>
  <p:sldIdLst>
    <p:sldId id="292" r:id="rId2"/>
    <p:sldId id="294" r:id="rId3"/>
    <p:sldId id="296" r:id="rId4"/>
    <p:sldId id="295" r:id="rId5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727" userDrawn="1">
          <p15:clr>
            <a:srgbClr val="A4A3A4"/>
          </p15:clr>
        </p15:guide>
        <p15:guide id="2" pos="2925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2" name="作成者" initials="A" lastIdx="1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8EC20E35-A176-4012-BC5E-935CFFF8708E}" styleName="スタイル (中間)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6485"/>
    <p:restoredTop sz="95461" autoAdjust="0"/>
  </p:normalViewPr>
  <p:slideViewPr>
    <p:cSldViewPr snapToGrid="0" snapToObjects="1" showGuides="1">
      <p:cViewPr varScale="1">
        <p:scale>
          <a:sx n="110" d="100"/>
          <a:sy n="110" d="100"/>
        </p:scale>
        <p:origin x="904" y="176"/>
      </p:cViewPr>
      <p:guideLst>
        <p:guide orient="horz" pos="2727"/>
        <p:guide pos="292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8061DC5-8FED-4C37-922B-647ACC4DF3EB}" type="datetimeFigureOut">
              <a:rPr kumimoji="1" lang="ja-JP" altLang="en-US" smtClean="0"/>
              <a:t>2020/2/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E53ADC5-D5D9-4A20-BDED-106C17C929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68868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ja-JP" altLang="en-US" dirty="0"/>
              <a:t>サンプル数 指定時点の生存率 </a:t>
            </a:r>
            <a:r>
              <a:rPr kumimoji="1" lang="en-US" altLang="ja-JP" dirty="0"/>
              <a:t>95%</a:t>
            </a:r>
            <a:r>
              <a:rPr kumimoji="1" lang="ja-JP" altLang="en-US" dirty="0"/>
              <a:t>信頼区間 生存期間中央値 </a:t>
            </a:r>
            <a:r>
              <a:rPr kumimoji="1" lang="en-US" altLang="ja-JP" dirty="0"/>
              <a:t>95%</a:t>
            </a:r>
            <a:r>
              <a:rPr kumimoji="1" lang="ja-JP" altLang="en-US" dirty="0"/>
              <a:t>信頼区間</a:t>
            </a:r>
          </a:p>
          <a:p>
            <a:r>
              <a:rPr kumimoji="1" lang="en-US" altLang="ja-JP" dirty="0"/>
              <a:t>1         90             &lt;NA&gt;        &lt;NA&gt;            129      70-200</a:t>
            </a:r>
          </a:p>
          <a:p>
            <a:endParaRPr kumimoji="1" lang="en-US" altLang="ja-JP" dirty="0"/>
          </a:p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9AC9C71-05C4-4F55-9259-17F6FF18A169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772774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             </a:t>
            </a:r>
            <a:r>
              <a:rPr kumimoji="1" lang="ja-JP" altLang="en-US"/>
              <a:t>サンプル数 指定時点の生存率 </a:t>
            </a:r>
            <a:r>
              <a:rPr kumimoji="1" lang="en-US" altLang="ja-JP" dirty="0"/>
              <a:t>95%</a:t>
            </a:r>
            <a:r>
              <a:rPr kumimoji="1" lang="ja-JP" altLang="en-US"/>
              <a:t>信頼区間 生存期間中央値 </a:t>
            </a:r>
            <a:r>
              <a:rPr kumimoji="1" lang="en-US" altLang="ja-JP" dirty="0"/>
              <a:t>95%</a:t>
            </a:r>
            <a:r>
              <a:rPr kumimoji="1" lang="ja-JP" altLang="en-US"/>
              <a:t>信頼区間</a:t>
            </a:r>
          </a:p>
          <a:p>
            <a:r>
              <a:rPr kumimoji="1" lang="ja-JP" altLang="en-US"/>
              <a:t>初回</a:t>
            </a:r>
            <a:r>
              <a:rPr kumimoji="1" lang="en-US" altLang="ja-JP" dirty="0"/>
              <a:t>=0         15               NA          NA            260       26-NA</a:t>
            </a:r>
          </a:p>
          <a:p>
            <a:r>
              <a:rPr kumimoji="1" lang="ja-JP" altLang="en-US"/>
              <a:t>初回</a:t>
            </a:r>
            <a:r>
              <a:rPr kumimoji="1" lang="en-US" altLang="ja-JP" dirty="0"/>
              <a:t>=1          6               NA          NA            476       37-NA</a:t>
            </a:r>
          </a:p>
          <a:p>
            <a:r>
              <a:rPr kumimoji="1" lang="ja-JP" altLang="en-US"/>
              <a:t>初回</a:t>
            </a:r>
            <a:r>
              <a:rPr kumimoji="1" lang="en-US" altLang="ja-JP" dirty="0"/>
              <a:t>=2          6               NA          NA             NA      114-NA</a:t>
            </a:r>
          </a:p>
          <a:p>
            <a:r>
              <a:rPr kumimoji="1" lang="en-US" altLang="ja-JP" dirty="0"/>
              <a:t>          P</a:t>
            </a:r>
            <a:r>
              <a:rPr kumimoji="1" lang="ja-JP" altLang="en-US"/>
              <a:t>値</a:t>
            </a:r>
          </a:p>
          <a:p>
            <a:r>
              <a:rPr kumimoji="1" lang="ja-JP" altLang="en-US"/>
              <a:t>初回</a:t>
            </a:r>
            <a:r>
              <a:rPr kumimoji="1" lang="en-US" altLang="ja-JP" dirty="0"/>
              <a:t>=0 0.0918</a:t>
            </a:r>
          </a:p>
          <a:p>
            <a:r>
              <a:rPr kumimoji="1" lang="ja-JP" altLang="en-US"/>
              <a:t>初回</a:t>
            </a:r>
            <a:r>
              <a:rPr kumimoji="1" lang="en-US" altLang="ja-JP" dirty="0"/>
              <a:t>=1       </a:t>
            </a:r>
          </a:p>
          <a:p>
            <a:r>
              <a:rPr kumimoji="1" lang="ja-JP" altLang="en-US"/>
              <a:t>初回</a:t>
            </a:r>
            <a:r>
              <a:rPr kumimoji="1" lang="en-US" altLang="ja-JP" dirty="0"/>
              <a:t>=2</a:t>
            </a:r>
          </a:p>
          <a:p>
            <a:endParaRPr kumimoji="1" lang="en-US" altLang="ja-JP" dirty="0"/>
          </a:p>
          <a:p>
            <a:endParaRPr kumimoji="1" lang="en-US" altLang="ja-JP" dirty="0"/>
          </a:p>
          <a:p>
            <a:r>
              <a:rPr kumimoji="1" lang="ja-JP" altLang="en-US"/>
              <a:t>サンプル数 指定時点の生存率 </a:t>
            </a:r>
            <a:r>
              <a:rPr kumimoji="1" lang="en-US" altLang="ja-JP" dirty="0"/>
              <a:t>95%</a:t>
            </a:r>
            <a:r>
              <a:rPr kumimoji="1" lang="ja-JP" altLang="en-US"/>
              <a:t>信頼区間 生存期間中央値</a:t>
            </a:r>
          </a:p>
          <a:p>
            <a:r>
              <a:rPr kumimoji="1" lang="ja-JP" altLang="en-US"/>
              <a:t>二次治療以降</a:t>
            </a:r>
            <a:r>
              <a:rPr kumimoji="1" lang="en-US" altLang="ja-JP" dirty="0"/>
              <a:t>=0         78               NA          NA             92</a:t>
            </a:r>
          </a:p>
          <a:p>
            <a:r>
              <a:rPr kumimoji="1" lang="ja-JP" altLang="en-US"/>
              <a:t>二次治療以降</a:t>
            </a:r>
            <a:r>
              <a:rPr kumimoji="1" lang="en-US" altLang="ja-JP" dirty="0"/>
              <a:t>=1         10               NA          NA            326</a:t>
            </a:r>
          </a:p>
          <a:p>
            <a:r>
              <a:rPr kumimoji="1" lang="ja-JP" altLang="en-US"/>
              <a:t>二次治療以降</a:t>
            </a:r>
            <a:r>
              <a:rPr kumimoji="1" lang="en-US" altLang="ja-JP" dirty="0"/>
              <a:t>=2         17               NA          NA            161</a:t>
            </a:r>
          </a:p>
          <a:p>
            <a:r>
              <a:rPr kumimoji="1" lang="en-US" altLang="ja-JP" dirty="0"/>
              <a:t>               95%</a:t>
            </a:r>
            <a:r>
              <a:rPr kumimoji="1" lang="ja-JP" altLang="en-US"/>
              <a:t>信頼区間  </a:t>
            </a:r>
            <a:r>
              <a:rPr kumimoji="1" lang="en-US" altLang="ja-JP" dirty="0"/>
              <a:t>P</a:t>
            </a:r>
            <a:r>
              <a:rPr kumimoji="1" lang="ja-JP" altLang="en-US"/>
              <a:t>値</a:t>
            </a:r>
          </a:p>
          <a:p>
            <a:r>
              <a:rPr kumimoji="1" lang="ja-JP" altLang="en-US"/>
              <a:t>二次治療以降</a:t>
            </a:r>
            <a:r>
              <a:rPr kumimoji="1" lang="en-US" altLang="ja-JP" dirty="0"/>
              <a:t>=0      63-176 0.17</a:t>
            </a:r>
          </a:p>
          <a:p>
            <a:r>
              <a:rPr kumimoji="1" lang="ja-JP" altLang="en-US"/>
              <a:t>二次治療以降</a:t>
            </a:r>
            <a:r>
              <a:rPr kumimoji="1" lang="en-US" altLang="ja-JP" dirty="0"/>
              <a:t>=1        9-NA     </a:t>
            </a:r>
          </a:p>
          <a:p>
            <a:r>
              <a:rPr kumimoji="1" lang="ja-JP" altLang="en-US"/>
              <a:t>二次治療以降</a:t>
            </a:r>
            <a:r>
              <a:rPr kumimoji="1" lang="en-US" altLang="ja-JP" dirty="0"/>
              <a:t>=2      56-371</a:t>
            </a:r>
            <a:endParaRPr kumimoji="1" lang="ja-JP" altLang="en-US"/>
          </a:p>
          <a:p>
            <a:endParaRPr kumimoji="1" lang="en-US" altLang="ja-JP" dirty="0"/>
          </a:p>
          <a:p>
            <a:endParaRPr kumimoji="1" lang="en-US" altLang="ja-JP" dirty="0"/>
          </a:p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E53ADC5-D5D9-4A20-BDED-106C17C92942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180181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ja-JP" altLang="en-US"/>
              <a:t>サンプル数 指定時点の生存率 </a:t>
            </a:r>
            <a:r>
              <a:rPr kumimoji="1" lang="en-US" altLang="ja-JP" dirty="0"/>
              <a:t>95%</a:t>
            </a:r>
            <a:r>
              <a:rPr kumimoji="1" lang="ja-JP" altLang="en-US"/>
              <a:t>信頼区間 生存期間中央値</a:t>
            </a:r>
          </a:p>
          <a:p>
            <a:r>
              <a:rPr kumimoji="1" lang="en-US" altLang="ja-JP" dirty="0"/>
              <a:t>OP.</a:t>
            </a:r>
            <a:r>
              <a:rPr kumimoji="1" lang="ja-JP" altLang="en-US"/>
              <a:t>１</a:t>
            </a:r>
            <a:r>
              <a:rPr kumimoji="1" lang="en-US" altLang="ja-JP" dirty="0"/>
              <a:t>.non.OP.0=0          7               NA          NA            476</a:t>
            </a:r>
          </a:p>
          <a:p>
            <a:r>
              <a:rPr kumimoji="1" lang="en-US" altLang="ja-JP" dirty="0"/>
              <a:t>OP.</a:t>
            </a:r>
            <a:r>
              <a:rPr kumimoji="1" lang="ja-JP" altLang="en-US"/>
              <a:t>１</a:t>
            </a:r>
            <a:r>
              <a:rPr kumimoji="1" lang="en-US" altLang="ja-JP" dirty="0"/>
              <a:t>.non.OP.0=1          9               NA          NA            536</a:t>
            </a:r>
          </a:p>
          <a:p>
            <a:r>
              <a:rPr kumimoji="1" lang="en-US" altLang="ja-JP" dirty="0"/>
              <a:t>                 95%</a:t>
            </a:r>
            <a:r>
              <a:rPr kumimoji="1" lang="ja-JP" altLang="en-US"/>
              <a:t>信頼区間    </a:t>
            </a:r>
            <a:r>
              <a:rPr kumimoji="1" lang="en-US" altLang="ja-JP" dirty="0"/>
              <a:t>P</a:t>
            </a:r>
            <a:r>
              <a:rPr kumimoji="1" lang="ja-JP" altLang="en-US"/>
              <a:t>値</a:t>
            </a:r>
          </a:p>
          <a:p>
            <a:r>
              <a:rPr kumimoji="1" lang="en-US" altLang="ja-JP" dirty="0"/>
              <a:t>OP.</a:t>
            </a:r>
            <a:r>
              <a:rPr kumimoji="1" lang="ja-JP" altLang="en-US"/>
              <a:t>１</a:t>
            </a:r>
            <a:r>
              <a:rPr kumimoji="1" lang="en-US" altLang="ja-JP" dirty="0"/>
              <a:t>.non.OP.0=0        9-NA 0.0773</a:t>
            </a:r>
          </a:p>
          <a:p>
            <a:r>
              <a:rPr kumimoji="1" lang="en-US" altLang="ja-JP" dirty="0"/>
              <a:t>OP.</a:t>
            </a:r>
            <a:r>
              <a:rPr kumimoji="1" lang="ja-JP" altLang="en-US"/>
              <a:t>１</a:t>
            </a:r>
            <a:r>
              <a:rPr kumimoji="1" lang="en-US" altLang="ja-JP" dirty="0"/>
              <a:t>.non.OP.0=1     151-564</a:t>
            </a:r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E53ADC5-D5D9-4A20-BDED-106C17C92942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889013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クリックして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103AF0-F1F3-B649-96FA-1D4ADAB0F4B1}" type="datetimeFigureOut">
              <a:rPr kumimoji="1" lang="ja-JP" altLang="en-US" smtClean="0"/>
              <a:t>2020/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23E074-551F-684A-B61A-32788463E3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22525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103AF0-F1F3-B649-96FA-1D4ADAB0F4B1}" type="datetimeFigureOut">
              <a:rPr kumimoji="1" lang="ja-JP" altLang="en-US" smtClean="0"/>
              <a:t>2020/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23E074-551F-684A-B61A-32788463E3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07495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103AF0-F1F3-B649-96FA-1D4ADAB0F4B1}" type="datetimeFigureOut">
              <a:rPr kumimoji="1" lang="ja-JP" altLang="en-US" smtClean="0"/>
              <a:t>2020/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23E074-551F-684A-B61A-32788463E3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65423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103AF0-F1F3-B649-96FA-1D4ADAB0F4B1}" type="datetimeFigureOut">
              <a:rPr kumimoji="1" lang="ja-JP" altLang="en-US" smtClean="0"/>
              <a:t>2020/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23E074-551F-684A-B61A-32788463E3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77947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103AF0-F1F3-B649-96FA-1D4ADAB0F4B1}" type="datetimeFigureOut">
              <a:rPr kumimoji="1" lang="ja-JP" altLang="en-US" smtClean="0"/>
              <a:t>2020/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23E074-551F-684A-B61A-32788463E3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3235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103AF0-F1F3-B649-96FA-1D4ADAB0F4B1}" type="datetimeFigureOut">
              <a:rPr kumimoji="1" lang="ja-JP" altLang="en-US" smtClean="0"/>
              <a:t>2020/2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23E074-551F-684A-B61A-32788463E3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25239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103AF0-F1F3-B649-96FA-1D4ADAB0F4B1}" type="datetimeFigureOut">
              <a:rPr kumimoji="1" lang="ja-JP" altLang="en-US" smtClean="0"/>
              <a:t>2020/2/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23E074-551F-684A-B61A-32788463E3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983229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103AF0-F1F3-B649-96FA-1D4ADAB0F4B1}" type="datetimeFigureOut">
              <a:rPr kumimoji="1" lang="ja-JP" altLang="en-US" smtClean="0"/>
              <a:t>2020/2/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23E074-551F-684A-B61A-32788463E3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76985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103AF0-F1F3-B649-96FA-1D4ADAB0F4B1}" type="datetimeFigureOut">
              <a:rPr kumimoji="1" lang="ja-JP" altLang="en-US" smtClean="0"/>
              <a:t>2020/2/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23E074-551F-684A-B61A-32788463E3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731177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コンテンツ (キャプション付き)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103AF0-F1F3-B649-96FA-1D4ADAB0F4B1}" type="datetimeFigureOut">
              <a:rPr kumimoji="1" lang="ja-JP" altLang="en-US" smtClean="0"/>
              <a:t>2020/2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23E074-551F-684A-B61A-32788463E3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25718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図  (キャプション付き)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103AF0-F1F3-B649-96FA-1D4ADAB0F4B1}" type="datetimeFigureOut">
              <a:rPr kumimoji="1" lang="ja-JP" altLang="en-US" smtClean="0"/>
              <a:t>2020/2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23E074-551F-684A-B61A-32788463E3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53139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103AF0-F1F3-B649-96FA-1D4ADAB0F4B1}" type="datetimeFigureOut">
              <a:rPr kumimoji="1" lang="ja-JP" altLang="en-US" smtClean="0"/>
              <a:t>2020/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23E074-551F-684A-B61A-32788463E3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25804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9" name="Rectangle 110">
            <a:extLst>
              <a:ext uri="{FF2B5EF4-FFF2-40B4-BE49-F238E27FC236}">
                <a16:creationId xmlns:a16="http://schemas.microsoft.com/office/drawing/2014/main" id="{52DFBB16-11EB-4342-B5C9-7C21DE437E4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91774" y="5098078"/>
            <a:ext cx="766235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ime (months)</a:t>
            </a:r>
            <a:endParaRPr kumimoji="1" lang="ja-JP" altLang="ja-JP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0" name="Rectangle 30">
            <a:extLst>
              <a:ext uri="{FF2B5EF4-FFF2-40B4-BE49-F238E27FC236}">
                <a16:creationId xmlns:a16="http://schemas.microsoft.com/office/drawing/2014/main" id="{038C1D11-3569-1D4E-900B-B0B937A4FDB9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4303308" y="3839810"/>
            <a:ext cx="1522853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rogression-free survival (%)</a:t>
            </a:r>
            <a:endParaRPr kumimoji="1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2" name="テキスト ボックス 161">
            <a:extLst>
              <a:ext uri="{FF2B5EF4-FFF2-40B4-BE49-F238E27FC236}">
                <a16:creationId xmlns:a16="http://schemas.microsoft.com/office/drawing/2014/main" id="{FB8F63F2-B2EA-5940-8137-E7FC2F91C552}"/>
              </a:ext>
            </a:extLst>
          </p:cNvPr>
          <p:cNvSpPr txBox="1"/>
          <p:nvPr/>
        </p:nvSpPr>
        <p:spPr>
          <a:xfrm>
            <a:off x="6593579" y="2924494"/>
            <a:ext cx="296262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eviously treated patients (n=103)</a:t>
            </a:r>
            <a:endParaRPr kumimoji="1" lang="en-US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dian 4.9m (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4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-6.1m) 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4" name="テキスト ボックス 163">
            <a:extLst>
              <a:ext uri="{FF2B5EF4-FFF2-40B4-BE49-F238E27FC236}">
                <a16:creationId xmlns:a16="http://schemas.microsoft.com/office/drawing/2014/main" id="{61B53DEF-94D0-C046-8BC7-9ED8F88183BE}"/>
              </a:ext>
            </a:extLst>
          </p:cNvPr>
          <p:cNvSpPr txBox="1"/>
          <p:nvPr/>
        </p:nvSpPr>
        <p:spPr>
          <a:xfrm>
            <a:off x="4846184" y="2226149"/>
            <a:ext cx="4442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7" name="テキスト ボックス 296">
            <a:extLst>
              <a:ext uri="{FF2B5EF4-FFF2-40B4-BE49-F238E27FC236}">
                <a16:creationId xmlns:a16="http://schemas.microsoft.com/office/drawing/2014/main" id="{B2FF2DE7-91C5-D942-BFED-DA6B2168F993}"/>
              </a:ext>
            </a:extLst>
          </p:cNvPr>
          <p:cNvSpPr txBox="1"/>
          <p:nvPr/>
        </p:nvSpPr>
        <p:spPr>
          <a:xfrm>
            <a:off x="58091" y="2202563"/>
            <a:ext cx="4442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6" name="テキスト ボックス 215">
            <a:extLst>
              <a:ext uri="{FF2B5EF4-FFF2-40B4-BE49-F238E27FC236}">
                <a16:creationId xmlns:a16="http://schemas.microsoft.com/office/drawing/2014/main" id="{7D3C2231-E9D4-0244-A4E4-A50E95E8F667}"/>
              </a:ext>
            </a:extLst>
          </p:cNvPr>
          <p:cNvSpPr txBox="1"/>
          <p:nvPr/>
        </p:nvSpPr>
        <p:spPr>
          <a:xfrm>
            <a:off x="1066042" y="2189976"/>
            <a:ext cx="29626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Untreated</a:t>
            </a:r>
            <a:endParaRPr kumimoji="1" lang="ja-JP" altLang="en-US" sz="1200" b="1" u="sng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8" name="Rectangle 30">
            <a:extLst>
              <a:ext uri="{FF2B5EF4-FFF2-40B4-BE49-F238E27FC236}">
                <a16:creationId xmlns:a16="http://schemas.microsoft.com/office/drawing/2014/main" id="{8AE4731B-1592-1842-A7FC-DB675AE1AFE2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-219361" y="3839811"/>
            <a:ext cx="1522853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rogression-free survival (%)</a:t>
            </a:r>
            <a:endParaRPr kumimoji="1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0" name="Rectangle 110">
            <a:extLst>
              <a:ext uri="{FF2B5EF4-FFF2-40B4-BE49-F238E27FC236}">
                <a16:creationId xmlns:a16="http://schemas.microsoft.com/office/drawing/2014/main" id="{4BE442AD-FA4B-EA40-85C7-7CD2E5EC10A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02310" y="5081404"/>
            <a:ext cx="801501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105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ime (</a:t>
            </a:r>
            <a:r>
              <a:rPr kumimoji="1" lang="en-US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onths</a:t>
            </a:r>
            <a:r>
              <a:rPr kumimoji="1" lang="en-US" altLang="ja-JP" sz="105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ja-JP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9" name="テキスト ボックス 218">
            <a:extLst>
              <a:ext uri="{FF2B5EF4-FFF2-40B4-BE49-F238E27FC236}">
                <a16:creationId xmlns:a16="http://schemas.microsoft.com/office/drawing/2014/main" id="{FE307EF8-0664-4B4B-9BA5-B0FF764FE67F}"/>
              </a:ext>
            </a:extLst>
          </p:cNvPr>
          <p:cNvSpPr txBox="1"/>
          <p:nvPr/>
        </p:nvSpPr>
        <p:spPr>
          <a:xfrm>
            <a:off x="5948486" y="2189976"/>
            <a:ext cx="29626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viously treated</a:t>
            </a:r>
            <a:endParaRPr kumimoji="1" lang="ja-JP" altLang="en-US" sz="1200" b="1" u="sng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35" name="グループ化 334">
            <a:extLst>
              <a:ext uri="{FF2B5EF4-FFF2-40B4-BE49-F238E27FC236}">
                <a16:creationId xmlns:a16="http://schemas.microsoft.com/office/drawing/2014/main" id="{A7C87F63-13F4-D345-AD25-773A1D721035}"/>
              </a:ext>
            </a:extLst>
          </p:cNvPr>
          <p:cNvGrpSpPr/>
          <p:nvPr/>
        </p:nvGrpSpPr>
        <p:grpSpPr>
          <a:xfrm>
            <a:off x="154374" y="2361021"/>
            <a:ext cx="3923414" cy="3080148"/>
            <a:chOff x="1333211" y="1117600"/>
            <a:chExt cx="5083464" cy="4535488"/>
          </a:xfrm>
        </p:grpSpPr>
        <p:sp>
          <p:nvSpPr>
            <p:cNvPr id="336" name="AutoShape 4">
              <a:extLst>
                <a:ext uri="{FF2B5EF4-FFF2-40B4-BE49-F238E27FC236}">
                  <a16:creationId xmlns:a16="http://schemas.microsoft.com/office/drawing/2014/main" id="{FB34C3A5-B4E4-D847-837D-F695CD9D1093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1881188" y="1117600"/>
              <a:ext cx="4535487" cy="45354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7" name="Line 6">
              <a:extLst>
                <a:ext uri="{FF2B5EF4-FFF2-40B4-BE49-F238E27FC236}">
                  <a16:creationId xmlns:a16="http://schemas.microsoft.com/office/drawing/2014/main" id="{E3E58552-5E4A-D24F-B478-C31B86CBC6C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08238" y="4802188"/>
              <a:ext cx="3711575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8" name="Line 7">
              <a:extLst>
                <a:ext uri="{FF2B5EF4-FFF2-40B4-BE49-F238E27FC236}">
                  <a16:creationId xmlns:a16="http://schemas.microsoft.com/office/drawing/2014/main" id="{70B3FF73-AAA4-7940-9D03-1AD548BA7B1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08238" y="4802188"/>
              <a:ext cx="0" cy="6191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9" name="Line 8">
              <a:extLst>
                <a:ext uri="{FF2B5EF4-FFF2-40B4-BE49-F238E27FC236}">
                  <a16:creationId xmlns:a16="http://schemas.microsoft.com/office/drawing/2014/main" id="{208247A4-B3D9-9743-BD5A-137AF200013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49600" y="4802188"/>
              <a:ext cx="0" cy="6191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0" name="Line 9">
              <a:extLst>
                <a:ext uri="{FF2B5EF4-FFF2-40B4-BE49-F238E27FC236}">
                  <a16:creationId xmlns:a16="http://schemas.microsoft.com/office/drawing/2014/main" id="{DF271881-05AB-1E44-8FC9-A4483D075A1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92550" y="4802188"/>
              <a:ext cx="0" cy="6191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1" name="Line 10">
              <a:extLst>
                <a:ext uri="{FF2B5EF4-FFF2-40B4-BE49-F238E27FC236}">
                  <a16:creationId xmlns:a16="http://schemas.microsoft.com/office/drawing/2014/main" id="{7F704883-74ED-9A46-99AF-4E317862A8F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35500" y="4802188"/>
              <a:ext cx="0" cy="6191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2" name="Line 11">
              <a:extLst>
                <a:ext uri="{FF2B5EF4-FFF2-40B4-BE49-F238E27FC236}">
                  <a16:creationId xmlns:a16="http://schemas.microsoft.com/office/drawing/2014/main" id="{C894E89A-CC38-A644-AE59-3040D3A3AC0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76863" y="4802188"/>
              <a:ext cx="0" cy="6191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3" name="Line 12">
              <a:extLst>
                <a:ext uri="{FF2B5EF4-FFF2-40B4-BE49-F238E27FC236}">
                  <a16:creationId xmlns:a16="http://schemas.microsoft.com/office/drawing/2014/main" id="{66921080-5C72-A849-A6A7-934E4F2C4D5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119813" y="4802188"/>
              <a:ext cx="0" cy="6191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4" name="Rectangle 13">
              <a:extLst>
                <a:ext uri="{FF2B5EF4-FFF2-40B4-BE49-F238E27FC236}">
                  <a16:creationId xmlns:a16="http://schemas.microsoft.com/office/drawing/2014/main" id="{16DA5F2A-E1E6-B145-9C77-E976EAA438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54263" y="4943475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5" name="Rectangle 14">
              <a:extLst>
                <a:ext uri="{FF2B5EF4-FFF2-40B4-BE49-F238E27FC236}">
                  <a16:creationId xmlns:a16="http://schemas.microsoft.com/office/drawing/2014/main" id="{BD7E93B6-576F-224B-8046-09FEFF4F2A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95625" y="4943475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6" name="Rectangle 15">
              <a:extLst>
                <a:ext uri="{FF2B5EF4-FFF2-40B4-BE49-F238E27FC236}">
                  <a16:creationId xmlns:a16="http://schemas.microsoft.com/office/drawing/2014/main" id="{19B00747-3152-284D-8A67-E15C0D9375C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05238" y="4943475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7" name="Rectangle 16">
              <a:extLst>
                <a:ext uri="{FF2B5EF4-FFF2-40B4-BE49-F238E27FC236}">
                  <a16:creationId xmlns:a16="http://schemas.microsoft.com/office/drawing/2014/main" id="{A8F71543-04DF-7441-9136-1922B5ADEA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48188" y="4943475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8" name="Rectangle 17">
              <a:extLst>
                <a:ext uri="{FF2B5EF4-FFF2-40B4-BE49-F238E27FC236}">
                  <a16:creationId xmlns:a16="http://schemas.microsoft.com/office/drawing/2014/main" id="{D20B34DF-A6A8-5F46-93E8-E68E4A64E3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89550" y="4943475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9" name="Rectangle 18">
              <a:extLst>
                <a:ext uri="{FF2B5EF4-FFF2-40B4-BE49-F238E27FC236}">
                  <a16:creationId xmlns:a16="http://schemas.microsoft.com/office/drawing/2014/main" id="{E930E20C-ADF8-A247-AD65-F1E8C149AA3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32500" y="4943475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0" name="Line 19">
              <a:extLst>
                <a:ext uri="{FF2B5EF4-FFF2-40B4-BE49-F238E27FC236}">
                  <a16:creationId xmlns:a16="http://schemas.microsoft.com/office/drawing/2014/main" id="{4D0BB0C1-677B-4B4D-8893-9D4347A6B83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08238" y="1765300"/>
              <a:ext cx="0" cy="29162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1" name="Line 20">
              <a:extLst>
                <a:ext uri="{FF2B5EF4-FFF2-40B4-BE49-F238E27FC236}">
                  <a16:creationId xmlns:a16="http://schemas.microsoft.com/office/drawing/2014/main" id="{A0326CCE-D02A-8446-8A8A-884C4DF9758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346325" y="4681538"/>
              <a:ext cx="6191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2" name="Line 21">
              <a:extLst>
                <a:ext uri="{FF2B5EF4-FFF2-40B4-BE49-F238E27FC236}">
                  <a16:creationId xmlns:a16="http://schemas.microsoft.com/office/drawing/2014/main" id="{3064E5FA-FCD2-6542-9ED8-184C2F74715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346325" y="4100513"/>
              <a:ext cx="6191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3" name="Line 22">
              <a:extLst>
                <a:ext uri="{FF2B5EF4-FFF2-40B4-BE49-F238E27FC236}">
                  <a16:creationId xmlns:a16="http://schemas.microsoft.com/office/drawing/2014/main" id="{A8437102-60C9-984D-BF9E-D2B18F3CD3C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346325" y="3513138"/>
              <a:ext cx="6191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4" name="Line 23">
              <a:extLst>
                <a:ext uri="{FF2B5EF4-FFF2-40B4-BE49-F238E27FC236}">
                  <a16:creationId xmlns:a16="http://schemas.microsoft.com/office/drawing/2014/main" id="{2278203B-3A7C-014D-996F-3837FE7EC81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346325" y="2933700"/>
              <a:ext cx="6191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5" name="Line 24">
              <a:extLst>
                <a:ext uri="{FF2B5EF4-FFF2-40B4-BE49-F238E27FC236}">
                  <a16:creationId xmlns:a16="http://schemas.microsoft.com/office/drawing/2014/main" id="{926D4FE7-2929-E847-A1CF-F1C17C4CBA9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346325" y="2346325"/>
              <a:ext cx="6191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6" name="Line 25">
              <a:extLst>
                <a:ext uri="{FF2B5EF4-FFF2-40B4-BE49-F238E27FC236}">
                  <a16:creationId xmlns:a16="http://schemas.microsoft.com/office/drawing/2014/main" id="{4DE4A302-D6BD-F14C-BD09-BE435FBA26F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346325" y="1765300"/>
              <a:ext cx="6191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7" name="Rectangle 26">
              <a:extLst>
                <a:ext uri="{FF2B5EF4-FFF2-40B4-BE49-F238E27FC236}">
                  <a16:creationId xmlns:a16="http://schemas.microsoft.com/office/drawing/2014/main" id="{690AD2DD-A701-454D-AB11-4940C9CD7A4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70100" y="4640263"/>
              <a:ext cx="1603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8" name="Rectangle 27">
              <a:extLst>
                <a:ext uri="{FF2B5EF4-FFF2-40B4-BE49-F238E27FC236}">
                  <a16:creationId xmlns:a16="http://schemas.microsoft.com/office/drawing/2014/main" id="{861C51A2-9D2D-0947-9643-0C92194981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70100" y="4052888"/>
              <a:ext cx="1603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9" name="Rectangle 28">
              <a:extLst>
                <a:ext uri="{FF2B5EF4-FFF2-40B4-BE49-F238E27FC236}">
                  <a16:creationId xmlns:a16="http://schemas.microsoft.com/office/drawing/2014/main" id="{C099ACA5-4359-5F4D-87DE-492E61325F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70100" y="3471863"/>
              <a:ext cx="1603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0" name="Rectangle 29">
              <a:extLst>
                <a:ext uri="{FF2B5EF4-FFF2-40B4-BE49-F238E27FC236}">
                  <a16:creationId xmlns:a16="http://schemas.microsoft.com/office/drawing/2014/main" id="{AA08B5E7-AB18-794B-93BD-10B70C9F9BF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70100" y="2884488"/>
              <a:ext cx="1603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6</a:t>
              </a:r>
              <a:endParaRPr kumimoji="1" lang="ja-JP" altLang="ja-JP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1" name="Rectangle 30">
              <a:extLst>
                <a:ext uri="{FF2B5EF4-FFF2-40B4-BE49-F238E27FC236}">
                  <a16:creationId xmlns:a16="http://schemas.microsoft.com/office/drawing/2014/main" id="{5D18E259-5BB4-1B46-9A36-CA188B4B899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70100" y="2305050"/>
              <a:ext cx="1603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8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2" name="Rectangle 31">
              <a:extLst>
                <a:ext uri="{FF2B5EF4-FFF2-40B4-BE49-F238E27FC236}">
                  <a16:creationId xmlns:a16="http://schemas.microsoft.com/office/drawing/2014/main" id="{82E51F77-92E8-E942-9560-C4A4855C28D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70100" y="1717675"/>
              <a:ext cx="1603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0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3" name="Freeform 32">
              <a:extLst>
                <a:ext uri="{FF2B5EF4-FFF2-40B4-BE49-F238E27FC236}">
                  <a16:creationId xmlns:a16="http://schemas.microsoft.com/office/drawing/2014/main" id="{45686689-EFFD-C140-B961-17B8D9F531C9}"/>
                </a:ext>
              </a:extLst>
            </p:cNvPr>
            <p:cNvSpPr>
              <a:spLocks/>
            </p:cNvSpPr>
            <p:nvPr/>
          </p:nvSpPr>
          <p:spPr bwMode="auto">
            <a:xfrm>
              <a:off x="2408238" y="1644650"/>
              <a:ext cx="3738562" cy="3157538"/>
            </a:xfrm>
            <a:custGeom>
              <a:avLst/>
              <a:gdLst>
                <a:gd name="T0" fmla="*/ 0 w 554"/>
                <a:gd name="T1" fmla="*/ 0 h 468"/>
                <a:gd name="T2" fmla="*/ 0 w 554"/>
                <a:gd name="T3" fmla="*/ 468 h 468"/>
                <a:gd name="T4" fmla="*/ 554 w 554"/>
                <a:gd name="T5" fmla="*/ 468 h 4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54" h="468">
                  <a:moveTo>
                    <a:pt x="0" y="0"/>
                  </a:moveTo>
                  <a:lnTo>
                    <a:pt x="0" y="468"/>
                  </a:lnTo>
                  <a:lnTo>
                    <a:pt x="554" y="468"/>
                  </a:lnTo>
                </a:path>
              </a:pathLst>
            </a:cu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4" name="Freeform 35">
              <a:extLst>
                <a:ext uri="{FF2B5EF4-FFF2-40B4-BE49-F238E27FC236}">
                  <a16:creationId xmlns:a16="http://schemas.microsoft.com/office/drawing/2014/main" id="{6E7CCF9A-9614-E74B-A3E3-F3B99FE12158}"/>
                </a:ext>
              </a:extLst>
            </p:cNvPr>
            <p:cNvSpPr>
              <a:spLocks/>
            </p:cNvSpPr>
            <p:nvPr/>
          </p:nvSpPr>
          <p:spPr bwMode="auto">
            <a:xfrm>
              <a:off x="2408238" y="1765300"/>
              <a:ext cx="3597275" cy="2370138"/>
            </a:xfrm>
            <a:custGeom>
              <a:avLst/>
              <a:gdLst>
                <a:gd name="T0" fmla="*/ 0 w 533"/>
                <a:gd name="T1" fmla="*/ 0 h 351"/>
                <a:gd name="T2" fmla="*/ 19 w 533"/>
                <a:gd name="T3" fmla="*/ 0 h 351"/>
                <a:gd name="T4" fmla="*/ 19 w 533"/>
                <a:gd name="T5" fmla="*/ 48 h 351"/>
                <a:gd name="T6" fmla="*/ 24 w 533"/>
                <a:gd name="T7" fmla="*/ 48 h 351"/>
                <a:gd name="T8" fmla="*/ 24 w 533"/>
                <a:gd name="T9" fmla="*/ 64 h 351"/>
                <a:gd name="T10" fmla="*/ 27 w 533"/>
                <a:gd name="T11" fmla="*/ 64 h 351"/>
                <a:gd name="T12" fmla="*/ 27 w 533"/>
                <a:gd name="T13" fmla="*/ 97 h 351"/>
                <a:gd name="T14" fmla="*/ 31 w 533"/>
                <a:gd name="T15" fmla="*/ 97 h 351"/>
                <a:gd name="T16" fmla="*/ 31 w 533"/>
                <a:gd name="T17" fmla="*/ 114 h 351"/>
                <a:gd name="T18" fmla="*/ 83 w 533"/>
                <a:gd name="T19" fmla="*/ 114 h 351"/>
                <a:gd name="T20" fmla="*/ 83 w 533"/>
                <a:gd name="T21" fmla="*/ 131 h 351"/>
                <a:gd name="T22" fmla="*/ 92 w 533"/>
                <a:gd name="T23" fmla="*/ 131 h 351"/>
                <a:gd name="T24" fmla="*/ 92 w 533"/>
                <a:gd name="T25" fmla="*/ 147 h 351"/>
                <a:gd name="T26" fmla="*/ 93 w 533"/>
                <a:gd name="T27" fmla="*/ 147 h 351"/>
                <a:gd name="T28" fmla="*/ 93 w 533"/>
                <a:gd name="T29" fmla="*/ 164 h 351"/>
                <a:gd name="T30" fmla="*/ 116 w 533"/>
                <a:gd name="T31" fmla="*/ 164 h 351"/>
                <a:gd name="T32" fmla="*/ 116 w 533"/>
                <a:gd name="T33" fmla="*/ 181 h 351"/>
                <a:gd name="T34" fmla="*/ 188 w 533"/>
                <a:gd name="T35" fmla="*/ 181 h 351"/>
                <a:gd name="T36" fmla="*/ 188 w 533"/>
                <a:gd name="T37" fmla="*/ 204 h 351"/>
                <a:gd name="T38" fmla="*/ 203 w 533"/>
                <a:gd name="T39" fmla="*/ 204 h 351"/>
                <a:gd name="T40" fmla="*/ 203 w 533"/>
                <a:gd name="T41" fmla="*/ 229 h 351"/>
                <a:gd name="T42" fmla="*/ 330 w 533"/>
                <a:gd name="T43" fmla="*/ 229 h 351"/>
                <a:gd name="T44" fmla="*/ 330 w 533"/>
                <a:gd name="T45" fmla="*/ 270 h 351"/>
                <a:gd name="T46" fmla="*/ 344 w 533"/>
                <a:gd name="T47" fmla="*/ 270 h 351"/>
                <a:gd name="T48" fmla="*/ 344 w 533"/>
                <a:gd name="T49" fmla="*/ 311 h 351"/>
                <a:gd name="T50" fmla="*/ 408 w 533"/>
                <a:gd name="T51" fmla="*/ 311 h 351"/>
                <a:gd name="T52" fmla="*/ 408 w 533"/>
                <a:gd name="T53" fmla="*/ 351 h 351"/>
                <a:gd name="T54" fmla="*/ 533 w 533"/>
                <a:gd name="T55" fmla="*/ 351 h 351"/>
                <a:gd name="T56" fmla="*/ 533 w 533"/>
                <a:gd name="T57" fmla="*/ 351 h 3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</a:cxnLst>
              <a:rect l="0" t="0" r="r" b="b"/>
              <a:pathLst>
                <a:path w="533" h="351">
                  <a:moveTo>
                    <a:pt x="0" y="0"/>
                  </a:moveTo>
                  <a:lnTo>
                    <a:pt x="19" y="0"/>
                  </a:lnTo>
                  <a:lnTo>
                    <a:pt x="19" y="48"/>
                  </a:lnTo>
                  <a:lnTo>
                    <a:pt x="24" y="48"/>
                  </a:lnTo>
                  <a:lnTo>
                    <a:pt x="24" y="64"/>
                  </a:lnTo>
                  <a:lnTo>
                    <a:pt x="27" y="64"/>
                  </a:lnTo>
                  <a:lnTo>
                    <a:pt x="27" y="97"/>
                  </a:lnTo>
                  <a:lnTo>
                    <a:pt x="31" y="97"/>
                  </a:lnTo>
                  <a:lnTo>
                    <a:pt x="31" y="114"/>
                  </a:lnTo>
                  <a:lnTo>
                    <a:pt x="83" y="114"/>
                  </a:lnTo>
                  <a:lnTo>
                    <a:pt x="83" y="131"/>
                  </a:lnTo>
                  <a:lnTo>
                    <a:pt x="92" y="131"/>
                  </a:lnTo>
                  <a:lnTo>
                    <a:pt x="92" y="147"/>
                  </a:lnTo>
                  <a:lnTo>
                    <a:pt x="93" y="147"/>
                  </a:lnTo>
                  <a:lnTo>
                    <a:pt x="93" y="164"/>
                  </a:lnTo>
                  <a:lnTo>
                    <a:pt x="116" y="164"/>
                  </a:lnTo>
                  <a:lnTo>
                    <a:pt x="116" y="181"/>
                  </a:lnTo>
                  <a:lnTo>
                    <a:pt x="188" y="181"/>
                  </a:lnTo>
                  <a:lnTo>
                    <a:pt x="188" y="204"/>
                  </a:lnTo>
                  <a:lnTo>
                    <a:pt x="203" y="204"/>
                  </a:lnTo>
                  <a:lnTo>
                    <a:pt x="203" y="229"/>
                  </a:lnTo>
                  <a:lnTo>
                    <a:pt x="330" y="229"/>
                  </a:lnTo>
                  <a:lnTo>
                    <a:pt x="330" y="270"/>
                  </a:lnTo>
                  <a:lnTo>
                    <a:pt x="344" y="270"/>
                  </a:lnTo>
                  <a:lnTo>
                    <a:pt x="344" y="311"/>
                  </a:lnTo>
                  <a:lnTo>
                    <a:pt x="408" y="311"/>
                  </a:lnTo>
                  <a:lnTo>
                    <a:pt x="408" y="351"/>
                  </a:lnTo>
                  <a:lnTo>
                    <a:pt x="533" y="351"/>
                  </a:lnTo>
                  <a:lnTo>
                    <a:pt x="533" y="351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5" name="Line 36">
              <a:extLst>
                <a:ext uri="{FF2B5EF4-FFF2-40B4-BE49-F238E27FC236}">
                  <a16:creationId xmlns:a16="http://schemas.microsoft.com/office/drawing/2014/main" id="{FDFC71BB-80C8-7D4E-8FC3-E5BC7B8CF98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49525" y="2197100"/>
              <a:ext cx="66675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6" name="Line 37">
              <a:extLst>
                <a:ext uri="{FF2B5EF4-FFF2-40B4-BE49-F238E27FC236}">
                  <a16:creationId xmlns:a16="http://schemas.microsoft.com/office/drawing/2014/main" id="{8ED0EC55-C94D-A949-908A-D1C66762D2E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82863" y="2163763"/>
              <a:ext cx="0" cy="6826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7" name="Line 38">
              <a:extLst>
                <a:ext uri="{FF2B5EF4-FFF2-40B4-BE49-F238E27FC236}">
                  <a16:creationId xmlns:a16="http://schemas.microsoft.com/office/drawing/2014/main" id="{8202CBCB-E3CC-5F40-96D9-E92DA0373D4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03575" y="2987675"/>
              <a:ext cx="6826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8" name="Line 39">
              <a:extLst>
                <a:ext uri="{FF2B5EF4-FFF2-40B4-BE49-F238E27FC236}">
                  <a16:creationId xmlns:a16="http://schemas.microsoft.com/office/drawing/2014/main" id="{8C69FCDD-240B-0B4D-9A66-874D6A42BAF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38500" y="2952750"/>
              <a:ext cx="0" cy="6826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9" name="Line 40">
              <a:extLst>
                <a:ext uri="{FF2B5EF4-FFF2-40B4-BE49-F238E27FC236}">
                  <a16:creationId xmlns:a16="http://schemas.microsoft.com/office/drawing/2014/main" id="{D2AD5FA3-E40B-CB41-B63A-FA3C8DA2F0D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11525" y="2987675"/>
              <a:ext cx="6826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0" name="Line 41">
              <a:extLst>
                <a:ext uri="{FF2B5EF4-FFF2-40B4-BE49-F238E27FC236}">
                  <a16:creationId xmlns:a16="http://schemas.microsoft.com/office/drawing/2014/main" id="{13AD96BE-485E-8241-B088-5C3B59D543D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346450" y="2952750"/>
              <a:ext cx="0" cy="6826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1" name="Line 42">
              <a:extLst>
                <a:ext uri="{FF2B5EF4-FFF2-40B4-BE49-F238E27FC236}">
                  <a16:creationId xmlns:a16="http://schemas.microsoft.com/office/drawing/2014/main" id="{E839785A-1585-4E43-B0ED-C37E86A086A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40113" y="2987675"/>
              <a:ext cx="7461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2" name="Line 43">
              <a:extLst>
                <a:ext uri="{FF2B5EF4-FFF2-40B4-BE49-F238E27FC236}">
                  <a16:creationId xmlns:a16="http://schemas.microsoft.com/office/drawing/2014/main" id="{CCD48BA9-BCD4-5841-B364-0116967959D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73450" y="2952750"/>
              <a:ext cx="0" cy="6826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3" name="Line 44">
              <a:extLst>
                <a:ext uri="{FF2B5EF4-FFF2-40B4-BE49-F238E27FC236}">
                  <a16:creationId xmlns:a16="http://schemas.microsoft.com/office/drawing/2014/main" id="{C7A401B3-08B3-EC43-8868-BD75ED282A5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46463" y="2987675"/>
              <a:ext cx="6826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4" name="Line 45">
              <a:extLst>
                <a:ext uri="{FF2B5EF4-FFF2-40B4-BE49-F238E27FC236}">
                  <a16:creationId xmlns:a16="http://schemas.microsoft.com/office/drawing/2014/main" id="{B723519A-3656-5142-AE01-8EDDC0E683E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81388" y="2952750"/>
              <a:ext cx="0" cy="6826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5" name="Line 46">
              <a:extLst>
                <a:ext uri="{FF2B5EF4-FFF2-40B4-BE49-F238E27FC236}">
                  <a16:creationId xmlns:a16="http://schemas.microsoft.com/office/drawing/2014/main" id="{AB683BEF-11A1-3543-9BC1-068E22AD8BD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83000" y="3143250"/>
              <a:ext cx="6826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6" name="Line 47">
              <a:extLst>
                <a:ext uri="{FF2B5EF4-FFF2-40B4-BE49-F238E27FC236}">
                  <a16:creationId xmlns:a16="http://schemas.microsoft.com/office/drawing/2014/main" id="{F0ABF028-4FCA-AA4A-9F2C-B713950CA91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16338" y="3108325"/>
              <a:ext cx="0" cy="6826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7" name="Line 48">
              <a:extLst>
                <a:ext uri="{FF2B5EF4-FFF2-40B4-BE49-F238E27FC236}">
                  <a16:creationId xmlns:a16="http://schemas.microsoft.com/office/drawing/2014/main" id="{1779C3F8-B970-6947-82BF-E9E9D4E95A2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43325" y="3311525"/>
              <a:ext cx="6826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8" name="Line 49">
              <a:extLst>
                <a:ext uri="{FF2B5EF4-FFF2-40B4-BE49-F238E27FC236}">
                  <a16:creationId xmlns:a16="http://schemas.microsoft.com/office/drawing/2014/main" id="{DCC37CA3-ACEC-7C41-9894-2397DFAEE97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78250" y="3278188"/>
              <a:ext cx="0" cy="66675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9" name="Line 50">
              <a:extLst>
                <a:ext uri="{FF2B5EF4-FFF2-40B4-BE49-F238E27FC236}">
                  <a16:creationId xmlns:a16="http://schemas.microsoft.com/office/drawing/2014/main" id="{AA63FD8E-22CF-BD4D-BAA7-D8356C9C23E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230688" y="3311525"/>
              <a:ext cx="66675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0" name="Line 51">
              <a:extLst>
                <a:ext uri="{FF2B5EF4-FFF2-40B4-BE49-F238E27FC236}">
                  <a16:creationId xmlns:a16="http://schemas.microsoft.com/office/drawing/2014/main" id="{1222F1CF-18B7-AC4E-BB41-0EAF2B62159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264025" y="3278188"/>
              <a:ext cx="0" cy="66675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1" name="Line 52">
              <a:extLst>
                <a:ext uri="{FF2B5EF4-FFF2-40B4-BE49-F238E27FC236}">
                  <a16:creationId xmlns:a16="http://schemas.microsoft.com/office/drawing/2014/main" id="{8235336C-FA26-BE4C-93EA-B130B2E5387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365625" y="3311525"/>
              <a:ext cx="66675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2" name="Line 53">
              <a:extLst>
                <a:ext uri="{FF2B5EF4-FFF2-40B4-BE49-F238E27FC236}">
                  <a16:creationId xmlns:a16="http://schemas.microsoft.com/office/drawing/2014/main" id="{947CA136-19E2-954F-9924-91104DA8C0F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398963" y="3278188"/>
              <a:ext cx="0" cy="66675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3" name="Line 54">
              <a:extLst>
                <a:ext uri="{FF2B5EF4-FFF2-40B4-BE49-F238E27FC236}">
                  <a16:creationId xmlns:a16="http://schemas.microsoft.com/office/drawing/2014/main" id="{D42EC4C9-D344-D34C-8E4A-9F6F9F0D03F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45125" y="4135438"/>
              <a:ext cx="7461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4" name="Line 55">
              <a:extLst>
                <a:ext uri="{FF2B5EF4-FFF2-40B4-BE49-F238E27FC236}">
                  <a16:creationId xmlns:a16="http://schemas.microsoft.com/office/drawing/2014/main" id="{95DE1459-29D3-184C-A100-985F8725458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484813" y="4100513"/>
              <a:ext cx="0" cy="6826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5" name="Line 56">
              <a:extLst>
                <a:ext uri="{FF2B5EF4-FFF2-40B4-BE49-F238E27FC236}">
                  <a16:creationId xmlns:a16="http://schemas.microsoft.com/office/drawing/2014/main" id="{EA2D0391-6E3D-F743-83BE-2CDD1E39042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970588" y="4135438"/>
              <a:ext cx="6826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6" name="Line 57">
              <a:extLst>
                <a:ext uri="{FF2B5EF4-FFF2-40B4-BE49-F238E27FC236}">
                  <a16:creationId xmlns:a16="http://schemas.microsoft.com/office/drawing/2014/main" id="{0E0487A2-4DF8-554D-ADDE-97BDADB2762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005513" y="4100513"/>
              <a:ext cx="0" cy="6826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7" name="Rectangle 58">
              <a:extLst>
                <a:ext uri="{FF2B5EF4-FFF2-40B4-BE49-F238E27FC236}">
                  <a16:creationId xmlns:a16="http://schemas.microsoft.com/office/drawing/2014/main" id="{26608F33-762D-824F-8225-0C8341EE70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20925" y="5335588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7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8" name="Rectangle 59">
              <a:extLst>
                <a:ext uri="{FF2B5EF4-FFF2-40B4-BE49-F238E27FC236}">
                  <a16:creationId xmlns:a16="http://schemas.microsoft.com/office/drawing/2014/main" id="{45A60B29-FF05-9541-BCDD-E02524D93C0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62288" y="5335588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6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9" name="Rectangle 60">
              <a:extLst>
                <a:ext uri="{FF2B5EF4-FFF2-40B4-BE49-F238E27FC236}">
                  <a16:creationId xmlns:a16="http://schemas.microsoft.com/office/drawing/2014/main" id="{EA45814B-CAE6-5941-B510-917550D4269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38575" y="5335588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0" name="Rectangle 61">
              <a:extLst>
                <a:ext uri="{FF2B5EF4-FFF2-40B4-BE49-F238E27FC236}">
                  <a16:creationId xmlns:a16="http://schemas.microsoft.com/office/drawing/2014/main" id="{2C039711-6EB4-1D40-9420-DA9A84AEE5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81525" y="5335588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1" name="Rectangle 62">
              <a:extLst>
                <a:ext uri="{FF2B5EF4-FFF2-40B4-BE49-F238E27FC236}">
                  <a16:creationId xmlns:a16="http://schemas.microsoft.com/office/drawing/2014/main" id="{A44B612C-ED1C-2641-BC22-754370DF686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22888" y="5335588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2" name="Rectangle 63">
              <a:extLst>
                <a:ext uri="{FF2B5EF4-FFF2-40B4-BE49-F238E27FC236}">
                  <a16:creationId xmlns:a16="http://schemas.microsoft.com/office/drawing/2014/main" id="{889346BC-1F00-0145-9C8E-6BDD16BBE61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65838" y="5335588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3" name="Rectangle 64">
              <a:extLst>
                <a:ext uri="{FF2B5EF4-FFF2-40B4-BE49-F238E27FC236}">
                  <a16:creationId xmlns:a16="http://schemas.microsoft.com/office/drawing/2014/main" id="{705DD0A9-6178-2341-A209-D2992A6FA2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33211" y="5171916"/>
              <a:ext cx="771045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umber at risk</a:t>
              </a:r>
              <a:endParaRPr kumimoji="1" lang="ja-JP" altLang="ja-JP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94" name="グループ化 393">
            <a:extLst>
              <a:ext uri="{FF2B5EF4-FFF2-40B4-BE49-F238E27FC236}">
                <a16:creationId xmlns:a16="http://schemas.microsoft.com/office/drawing/2014/main" id="{E48973BD-0E21-9845-A69A-86762F3C829F}"/>
              </a:ext>
            </a:extLst>
          </p:cNvPr>
          <p:cNvGrpSpPr/>
          <p:nvPr/>
        </p:nvGrpSpPr>
        <p:grpSpPr>
          <a:xfrm>
            <a:off x="4729641" y="2773349"/>
            <a:ext cx="3837354" cy="2617856"/>
            <a:chOff x="1153951" y="1532358"/>
            <a:chExt cx="5018028" cy="4135662"/>
          </a:xfrm>
        </p:grpSpPr>
        <p:sp>
          <p:nvSpPr>
            <p:cNvPr id="395" name="Line 6">
              <a:extLst>
                <a:ext uri="{FF2B5EF4-FFF2-40B4-BE49-F238E27FC236}">
                  <a16:creationId xmlns:a16="http://schemas.microsoft.com/office/drawing/2014/main" id="{06E9F53A-F6C7-A641-A8E0-B2B27BA3A46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28629" y="4862933"/>
              <a:ext cx="3857625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6" name="Line 7">
              <a:extLst>
                <a:ext uri="{FF2B5EF4-FFF2-40B4-BE49-F238E27FC236}">
                  <a16:creationId xmlns:a16="http://schemas.microsoft.com/office/drawing/2014/main" id="{DD2856E7-8BD2-754D-904C-C170BE53F15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28629" y="4862933"/>
              <a:ext cx="0" cy="6508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7" name="Line 8">
              <a:extLst>
                <a:ext uri="{FF2B5EF4-FFF2-40B4-BE49-F238E27FC236}">
                  <a16:creationId xmlns:a16="http://schemas.microsoft.com/office/drawing/2014/main" id="{33545659-151E-6B41-B875-AD1CFD51883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03329" y="4862933"/>
              <a:ext cx="0" cy="6508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8" name="Line 9">
              <a:extLst>
                <a:ext uri="{FF2B5EF4-FFF2-40B4-BE49-F238E27FC236}">
                  <a16:creationId xmlns:a16="http://schemas.microsoft.com/office/drawing/2014/main" id="{41C18DE4-217F-2640-8F87-0B289537634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73267" y="4862933"/>
              <a:ext cx="0" cy="6508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9" name="Line 10">
              <a:extLst>
                <a:ext uri="{FF2B5EF4-FFF2-40B4-BE49-F238E27FC236}">
                  <a16:creationId xmlns:a16="http://schemas.microsoft.com/office/drawing/2014/main" id="{CFFF1576-1908-7F4F-BC0E-542992114BE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41617" y="4862933"/>
              <a:ext cx="0" cy="6508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0" name="Line 11">
              <a:extLst>
                <a:ext uri="{FF2B5EF4-FFF2-40B4-BE49-F238E27FC236}">
                  <a16:creationId xmlns:a16="http://schemas.microsoft.com/office/drawing/2014/main" id="{ACF17494-AD05-CE42-98A5-5826CB90FCF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17904" y="4862933"/>
              <a:ext cx="0" cy="6508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1" name="Line 12">
              <a:extLst>
                <a:ext uri="{FF2B5EF4-FFF2-40B4-BE49-F238E27FC236}">
                  <a16:creationId xmlns:a16="http://schemas.microsoft.com/office/drawing/2014/main" id="{6CEA06CF-319D-274A-A159-7015B646393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086254" y="4862933"/>
              <a:ext cx="0" cy="6508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2" name="Rectangle 13">
              <a:extLst>
                <a:ext uri="{FF2B5EF4-FFF2-40B4-BE49-F238E27FC236}">
                  <a16:creationId xmlns:a16="http://schemas.microsoft.com/office/drawing/2014/main" id="{B5D8842F-1197-A24E-A266-7D696D9B013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71479" y="5012158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3" name="Rectangle 14">
              <a:extLst>
                <a:ext uri="{FF2B5EF4-FFF2-40B4-BE49-F238E27FC236}">
                  <a16:creationId xmlns:a16="http://schemas.microsoft.com/office/drawing/2014/main" id="{FF5E5CD2-0C9C-AE4A-9629-145DD28FC8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14429" y="5012158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4" name="Rectangle 15">
              <a:extLst>
                <a:ext uri="{FF2B5EF4-FFF2-40B4-BE49-F238E27FC236}">
                  <a16:creationId xmlns:a16="http://schemas.microsoft.com/office/drawing/2014/main" id="{26AF3E54-6FB3-7C4E-B5A6-74372CC794F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84367" y="5012158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5" name="Rectangle 16">
              <a:extLst>
                <a:ext uri="{FF2B5EF4-FFF2-40B4-BE49-F238E27FC236}">
                  <a16:creationId xmlns:a16="http://schemas.microsoft.com/office/drawing/2014/main" id="{AA2E7C7A-7F98-0841-9233-80F6BEFAE5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52717" y="5012158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0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6" name="Rectangle 17">
              <a:extLst>
                <a:ext uri="{FF2B5EF4-FFF2-40B4-BE49-F238E27FC236}">
                  <a16:creationId xmlns:a16="http://schemas.microsoft.com/office/drawing/2014/main" id="{7FCDFBC3-D98C-9944-AFC1-4B4DAC623F2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29004" y="5012158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0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7" name="Rectangle 18">
              <a:extLst>
                <a:ext uri="{FF2B5EF4-FFF2-40B4-BE49-F238E27FC236}">
                  <a16:creationId xmlns:a16="http://schemas.microsoft.com/office/drawing/2014/main" id="{1C214C53-D0BD-D249-B2D0-E97DF2BFF0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97354" y="5012158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0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8" name="Line 19">
              <a:extLst>
                <a:ext uri="{FF2B5EF4-FFF2-40B4-BE49-F238E27FC236}">
                  <a16:creationId xmlns:a16="http://schemas.microsoft.com/office/drawing/2014/main" id="{2D778484-B3C1-1041-B3C0-C4BD6E7FFEE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28629" y="1659358"/>
              <a:ext cx="0" cy="3076575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9" name="Line 20">
              <a:extLst>
                <a:ext uri="{FF2B5EF4-FFF2-40B4-BE49-F238E27FC236}">
                  <a16:creationId xmlns:a16="http://schemas.microsoft.com/office/drawing/2014/main" id="{7A4238E1-F23F-BD47-A672-5593A11703C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163542" y="4735933"/>
              <a:ext cx="6508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0" name="Line 21">
              <a:extLst>
                <a:ext uri="{FF2B5EF4-FFF2-40B4-BE49-F238E27FC236}">
                  <a16:creationId xmlns:a16="http://schemas.microsoft.com/office/drawing/2014/main" id="{DD75A391-BE65-9B47-B94B-B9914C2A3B5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163542" y="4123158"/>
              <a:ext cx="6508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1" name="Line 22">
              <a:extLst>
                <a:ext uri="{FF2B5EF4-FFF2-40B4-BE49-F238E27FC236}">
                  <a16:creationId xmlns:a16="http://schemas.microsoft.com/office/drawing/2014/main" id="{3E4E1420-7D7D-124E-ABAE-57CAC6C9341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163542" y="3504033"/>
              <a:ext cx="6508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2" name="Line 23">
              <a:extLst>
                <a:ext uri="{FF2B5EF4-FFF2-40B4-BE49-F238E27FC236}">
                  <a16:creationId xmlns:a16="http://schemas.microsoft.com/office/drawing/2014/main" id="{FE4A6EA1-2B3B-BD4A-B390-ACA97C68B33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163542" y="2891258"/>
              <a:ext cx="6508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3" name="Line 24">
              <a:extLst>
                <a:ext uri="{FF2B5EF4-FFF2-40B4-BE49-F238E27FC236}">
                  <a16:creationId xmlns:a16="http://schemas.microsoft.com/office/drawing/2014/main" id="{7D046F9B-5111-F844-9ECE-FE506B6D830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163542" y="2272133"/>
              <a:ext cx="6508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4" name="Line 25">
              <a:extLst>
                <a:ext uri="{FF2B5EF4-FFF2-40B4-BE49-F238E27FC236}">
                  <a16:creationId xmlns:a16="http://schemas.microsoft.com/office/drawing/2014/main" id="{8EEFB130-6A9E-254B-808E-22D4C345EF0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163542" y="1659358"/>
              <a:ext cx="6508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5" name="Rectangle 26">
              <a:extLst>
                <a:ext uri="{FF2B5EF4-FFF2-40B4-BE49-F238E27FC236}">
                  <a16:creationId xmlns:a16="http://schemas.microsoft.com/office/drawing/2014/main" id="{8AA500C6-C7CB-EE43-885D-F996F212F91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87317" y="4691483"/>
              <a:ext cx="1603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6" name="Rectangle 27">
              <a:extLst>
                <a:ext uri="{FF2B5EF4-FFF2-40B4-BE49-F238E27FC236}">
                  <a16:creationId xmlns:a16="http://schemas.microsoft.com/office/drawing/2014/main" id="{50E9120C-992E-4849-A62A-1A9EB8EF193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87317" y="4072358"/>
              <a:ext cx="1603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7" name="Rectangle 28">
              <a:extLst>
                <a:ext uri="{FF2B5EF4-FFF2-40B4-BE49-F238E27FC236}">
                  <a16:creationId xmlns:a16="http://schemas.microsoft.com/office/drawing/2014/main" id="{F2DC106F-D143-2740-83DB-BF334C55086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87317" y="3461170"/>
              <a:ext cx="1603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  <a:endParaRPr kumimoji="1" lang="ja-JP" altLang="ja-JP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8" name="Rectangle 29">
              <a:extLst>
                <a:ext uri="{FF2B5EF4-FFF2-40B4-BE49-F238E27FC236}">
                  <a16:creationId xmlns:a16="http://schemas.microsoft.com/office/drawing/2014/main" id="{7900B4F5-58FF-6748-B35B-142A05022C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87317" y="2842045"/>
              <a:ext cx="1603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6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9" name="Rectangle 30">
              <a:extLst>
                <a:ext uri="{FF2B5EF4-FFF2-40B4-BE49-F238E27FC236}">
                  <a16:creationId xmlns:a16="http://schemas.microsoft.com/office/drawing/2014/main" id="{DB0DC495-8D46-C843-8588-CC60E3F0023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87317" y="2229270"/>
              <a:ext cx="1603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8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0" name="Rectangle 31">
              <a:extLst>
                <a:ext uri="{FF2B5EF4-FFF2-40B4-BE49-F238E27FC236}">
                  <a16:creationId xmlns:a16="http://schemas.microsoft.com/office/drawing/2014/main" id="{F35286FA-2763-3044-B84F-4F0EE5E25F0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87317" y="1610145"/>
              <a:ext cx="1603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0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1" name="Freeform 32">
              <a:extLst>
                <a:ext uri="{FF2B5EF4-FFF2-40B4-BE49-F238E27FC236}">
                  <a16:creationId xmlns:a16="http://schemas.microsoft.com/office/drawing/2014/main" id="{07A56566-B6F6-074E-997E-BADB55C61CF4}"/>
                </a:ext>
              </a:extLst>
            </p:cNvPr>
            <p:cNvSpPr>
              <a:spLocks/>
            </p:cNvSpPr>
            <p:nvPr/>
          </p:nvSpPr>
          <p:spPr bwMode="auto">
            <a:xfrm>
              <a:off x="2228629" y="1532358"/>
              <a:ext cx="3943350" cy="3330575"/>
            </a:xfrm>
            <a:custGeom>
              <a:avLst/>
              <a:gdLst>
                <a:gd name="T0" fmla="*/ 0 w 554"/>
                <a:gd name="T1" fmla="*/ 0 h 468"/>
                <a:gd name="T2" fmla="*/ 0 w 554"/>
                <a:gd name="T3" fmla="*/ 468 h 468"/>
                <a:gd name="T4" fmla="*/ 554 w 554"/>
                <a:gd name="T5" fmla="*/ 468 h 4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54" h="468">
                  <a:moveTo>
                    <a:pt x="0" y="0"/>
                  </a:moveTo>
                  <a:lnTo>
                    <a:pt x="0" y="468"/>
                  </a:lnTo>
                  <a:lnTo>
                    <a:pt x="554" y="468"/>
                  </a:lnTo>
                </a:path>
              </a:pathLst>
            </a:cu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2" name="Freeform 35">
              <a:extLst>
                <a:ext uri="{FF2B5EF4-FFF2-40B4-BE49-F238E27FC236}">
                  <a16:creationId xmlns:a16="http://schemas.microsoft.com/office/drawing/2014/main" id="{FC0A5EC6-708C-FD49-9F36-7EC590E1CAB8}"/>
                </a:ext>
              </a:extLst>
            </p:cNvPr>
            <p:cNvSpPr>
              <a:spLocks/>
            </p:cNvSpPr>
            <p:nvPr/>
          </p:nvSpPr>
          <p:spPr bwMode="auto">
            <a:xfrm>
              <a:off x="2228629" y="1659358"/>
              <a:ext cx="3794125" cy="2705100"/>
            </a:xfrm>
            <a:custGeom>
              <a:avLst/>
              <a:gdLst>
                <a:gd name="T0" fmla="*/ 1 w 533"/>
                <a:gd name="T1" fmla="*/ 4 h 380"/>
                <a:gd name="T2" fmla="*/ 3 w 533"/>
                <a:gd name="T3" fmla="*/ 8 h 380"/>
                <a:gd name="T4" fmla="*/ 3 w 533"/>
                <a:gd name="T5" fmla="*/ 16 h 380"/>
                <a:gd name="T6" fmla="*/ 6 w 533"/>
                <a:gd name="T7" fmla="*/ 20 h 380"/>
                <a:gd name="T8" fmla="*/ 7 w 533"/>
                <a:gd name="T9" fmla="*/ 28 h 380"/>
                <a:gd name="T10" fmla="*/ 8 w 533"/>
                <a:gd name="T11" fmla="*/ 33 h 380"/>
                <a:gd name="T12" fmla="*/ 8 w 533"/>
                <a:gd name="T13" fmla="*/ 41 h 380"/>
                <a:gd name="T14" fmla="*/ 10 w 533"/>
                <a:gd name="T15" fmla="*/ 45 h 380"/>
                <a:gd name="T16" fmla="*/ 10 w 533"/>
                <a:gd name="T17" fmla="*/ 57 h 380"/>
                <a:gd name="T18" fmla="*/ 11 w 533"/>
                <a:gd name="T19" fmla="*/ 62 h 380"/>
                <a:gd name="T20" fmla="*/ 12 w 533"/>
                <a:gd name="T21" fmla="*/ 78 h 380"/>
                <a:gd name="T22" fmla="*/ 13 w 533"/>
                <a:gd name="T23" fmla="*/ 87 h 380"/>
                <a:gd name="T24" fmla="*/ 17 w 533"/>
                <a:gd name="T25" fmla="*/ 95 h 380"/>
                <a:gd name="T26" fmla="*/ 19 w 533"/>
                <a:gd name="T27" fmla="*/ 104 h 380"/>
                <a:gd name="T28" fmla="*/ 19 w 533"/>
                <a:gd name="T29" fmla="*/ 112 h 380"/>
                <a:gd name="T30" fmla="*/ 20 w 533"/>
                <a:gd name="T31" fmla="*/ 116 h 380"/>
                <a:gd name="T32" fmla="*/ 21 w 533"/>
                <a:gd name="T33" fmla="*/ 133 h 380"/>
                <a:gd name="T34" fmla="*/ 22 w 533"/>
                <a:gd name="T35" fmla="*/ 138 h 380"/>
                <a:gd name="T36" fmla="*/ 23 w 533"/>
                <a:gd name="T37" fmla="*/ 155 h 380"/>
                <a:gd name="T38" fmla="*/ 23 w 533"/>
                <a:gd name="T39" fmla="*/ 159 h 380"/>
                <a:gd name="T40" fmla="*/ 25 w 533"/>
                <a:gd name="T41" fmla="*/ 172 h 380"/>
                <a:gd name="T42" fmla="*/ 28 w 533"/>
                <a:gd name="T43" fmla="*/ 176 h 380"/>
                <a:gd name="T44" fmla="*/ 28 w 533"/>
                <a:gd name="T45" fmla="*/ 185 h 380"/>
                <a:gd name="T46" fmla="*/ 33 w 533"/>
                <a:gd name="T47" fmla="*/ 190 h 380"/>
                <a:gd name="T48" fmla="*/ 36 w 533"/>
                <a:gd name="T49" fmla="*/ 199 h 380"/>
                <a:gd name="T50" fmla="*/ 46 w 533"/>
                <a:gd name="T51" fmla="*/ 204 h 380"/>
                <a:gd name="T52" fmla="*/ 49 w 533"/>
                <a:gd name="T53" fmla="*/ 213 h 380"/>
                <a:gd name="T54" fmla="*/ 54 w 533"/>
                <a:gd name="T55" fmla="*/ 218 h 380"/>
                <a:gd name="T56" fmla="*/ 55 w 533"/>
                <a:gd name="T57" fmla="*/ 228 h 380"/>
                <a:gd name="T58" fmla="*/ 58 w 533"/>
                <a:gd name="T59" fmla="*/ 233 h 380"/>
                <a:gd name="T60" fmla="*/ 62 w 533"/>
                <a:gd name="T61" fmla="*/ 243 h 380"/>
                <a:gd name="T62" fmla="*/ 65 w 533"/>
                <a:gd name="T63" fmla="*/ 248 h 380"/>
                <a:gd name="T64" fmla="*/ 65 w 533"/>
                <a:gd name="T65" fmla="*/ 258 h 380"/>
                <a:gd name="T66" fmla="*/ 71 w 533"/>
                <a:gd name="T67" fmla="*/ 263 h 380"/>
                <a:gd name="T68" fmla="*/ 71 w 533"/>
                <a:gd name="T69" fmla="*/ 273 h 380"/>
                <a:gd name="T70" fmla="*/ 78 w 533"/>
                <a:gd name="T71" fmla="*/ 278 h 380"/>
                <a:gd name="T72" fmla="*/ 81 w 533"/>
                <a:gd name="T73" fmla="*/ 289 h 380"/>
                <a:gd name="T74" fmla="*/ 94 w 533"/>
                <a:gd name="T75" fmla="*/ 294 h 380"/>
                <a:gd name="T76" fmla="*/ 98 w 533"/>
                <a:gd name="T77" fmla="*/ 306 h 380"/>
                <a:gd name="T78" fmla="*/ 108 w 533"/>
                <a:gd name="T79" fmla="*/ 312 h 380"/>
                <a:gd name="T80" fmla="*/ 116 w 533"/>
                <a:gd name="T81" fmla="*/ 326 h 380"/>
                <a:gd name="T82" fmla="*/ 140 w 533"/>
                <a:gd name="T83" fmla="*/ 332 h 380"/>
                <a:gd name="T84" fmla="*/ 163 w 533"/>
                <a:gd name="T85" fmla="*/ 348 h 380"/>
                <a:gd name="T86" fmla="*/ 191 w 533"/>
                <a:gd name="T87" fmla="*/ 359 h 380"/>
                <a:gd name="T88" fmla="*/ 192 w 533"/>
                <a:gd name="T89" fmla="*/ 380 h 3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</a:cxnLst>
              <a:rect l="0" t="0" r="r" b="b"/>
              <a:pathLst>
                <a:path w="533" h="380">
                  <a:moveTo>
                    <a:pt x="0" y="0"/>
                  </a:moveTo>
                  <a:lnTo>
                    <a:pt x="1" y="0"/>
                  </a:lnTo>
                  <a:lnTo>
                    <a:pt x="1" y="4"/>
                  </a:lnTo>
                  <a:lnTo>
                    <a:pt x="2" y="4"/>
                  </a:lnTo>
                  <a:lnTo>
                    <a:pt x="2" y="8"/>
                  </a:lnTo>
                  <a:lnTo>
                    <a:pt x="3" y="8"/>
                  </a:lnTo>
                  <a:lnTo>
                    <a:pt x="3" y="12"/>
                  </a:lnTo>
                  <a:lnTo>
                    <a:pt x="3" y="12"/>
                  </a:lnTo>
                  <a:lnTo>
                    <a:pt x="3" y="16"/>
                  </a:lnTo>
                  <a:lnTo>
                    <a:pt x="5" y="16"/>
                  </a:lnTo>
                  <a:lnTo>
                    <a:pt x="5" y="20"/>
                  </a:lnTo>
                  <a:lnTo>
                    <a:pt x="6" y="20"/>
                  </a:lnTo>
                  <a:lnTo>
                    <a:pt x="6" y="24"/>
                  </a:lnTo>
                  <a:lnTo>
                    <a:pt x="7" y="24"/>
                  </a:lnTo>
                  <a:lnTo>
                    <a:pt x="7" y="28"/>
                  </a:lnTo>
                  <a:lnTo>
                    <a:pt x="7" y="28"/>
                  </a:lnTo>
                  <a:lnTo>
                    <a:pt x="7" y="33"/>
                  </a:lnTo>
                  <a:lnTo>
                    <a:pt x="8" y="33"/>
                  </a:lnTo>
                  <a:lnTo>
                    <a:pt x="8" y="37"/>
                  </a:lnTo>
                  <a:lnTo>
                    <a:pt x="8" y="37"/>
                  </a:lnTo>
                  <a:lnTo>
                    <a:pt x="8" y="41"/>
                  </a:lnTo>
                  <a:lnTo>
                    <a:pt x="9" y="41"/>
                  </a:lnTo>
                  <a:lnTo>
                    <a:pt x="9" y="45"/>
                  </a:lnTo>
                  <a:lnTo>
                    <a:pt x="10" y="45"/>
                  </a:lnTo>
                  <a:lnTo>
                    <a:pt x="10" y="49"/>
                  </a:lnTo>
                  <a:lnTo>
                    <a:pt x="10" y="49"/>
                  </a:lnTo>
                  <a:lnTo>
                    <a:pt x="10" y="57"/>
                  </a:lnTo>
                  <a:lnTo>
                    <a:pt x="11" y="57"/>
                  </a:lnTo>
                  <a:lnTo>
                    <a:pt x="11" y="62"/>
                  </a:lnTo>
                  <a:lnTo>
                    <a:pt x="11" y="62"/>
                  </a:lnTo>
                  <a:lnTo>
                    <a:pt x="11" y="66"/>
                  </a:lnTo>
                  <a:lnTo>
                    <a:pt x="12" y="66"/>
                  </a:lnTo>
                  <a:lnTo>
                    <a:pt x="12" y="78"/>
                  </a:lnTo>
                  <a:lnTo>
                    <a:pt x="13" y="78"/>
                  </a:lnTo>
                  <a:lnTo>
                    <a:pt x="13" y="87"/>
                  </a:lnTo>
                  <a:lnTo>
                    <a:pt x="13" y="87"/>
                  </a:lnTo>
                  <a:lnTo>
                    <a:pt x="13" y="91"/>
                  </a:lnTo>
                  <a:lnTo>
                    <a:pt x="17" y="91"/>
                  </a:lnTo>
                  <a:lnTo>
                    <a:pt x="17" y="95"/>
                  </a:lnTo>
                  <a:lnTo>
                    <a:pt x="17" y="95"/>
                  </a:lnTo>
                  <a:lnTo>
                    <a:pt x="17" y="104"/>
                  </a:lnTo>
                  <a:lnTo>
                    <a:pt x="19" y="104"/>
                  </a:lnTo>
                  <a:lnTo>
                    <a:pt x="19" y="108"/>
                  </a:lnTo>
                  <a:lnTo>
                    <a:pt x="19" y="108"/>
                  </a:lnTo>
                  <a:lnTo>
                    <a:pt x="19" y="112"/>
                  </a:lnTo>
                  <a:lnTo>
                    <a:pt x="19" y="112"/>
                  </a:lnTo>
                  <a:lnTo>
                    <a:pt x="19" y="116"/>
                  </a:lnTo>
                  <a:lnTo>
                    <a:pt x="20" y="116"/>
                  </a:lnTo>
                  <a:lnTo>
                    <a:pt x="20" y="129"/>
                  </a:lnTo>
                  <a:lnTo>
                    <a:pt x="21" y="129"/>
                  </a:lnTo>
                  <a:lnTo>
                    <a:pt x="21" y="133"/>
                  </a:lnTo>
                  <a:lnTo>
                    <a:pt x="22" y="133"/>
                  </a:lnTo>
                  <a:lnTo>
                    <a:pt x="22" y="138"/>
                  </a:lnTo>
                  <a:lnTo>
                    <a:pt x="22" y="138"/>
                  </a:lnTo>
                  <a:lnTo>
                    <a:pt x="22" y="142"/>
                  </a:lnTo>
                  <a:lnTo>
                    <a:pt x="23" y="142"/>
                  </a:lnTo>
                  <a:lnTo>
                    <a:pt x="23" y="155"/>
                  </a:lnTo>
                  <a:lnTo>
                    <a:pt x="23" y="155"/>
                  </a:lnTo>
                  <a:lnTo>
                    <a:pt x="23" y="159"/>
                  </a:lnTo>
                  <a:lnTo>
                    <a:pt x="23" y="159"/>
                  </a:lnTo>
                  <a:lnTo>
                    <a:pt x="23" y="163"/>
                  </a:lnTo>
                  <a:lnTo>
                    <a:pt x="25" y="163"/>
                  </a:lnTo>
                  <a:lnTo>
                    <a:pt x="25" y="172"/>
                  </a:lnTo>
                  <a:lnTo>
                    <a:pt x="26" y="172"/>
                  </a:lnTo>
                  <a:lnTo>
                    <a:pt x="26" y="176"/>
                  </a:lnTo>
                  <a:lnTo>
                    <a:pt x="28" y="176"/>
                  </a:lnTo>
                  <a:lnTo>
                    <a:pt x="28" y="181"/>
                  </a:lnTo>
                  <a:lnTo>
                    <a:pt x="28" y="181"/>
                  </a:lnTo>
                  <a:lnTo>
                    <a:pt x="28" y="185"/>
                  </a:lnTo>
                  <a:lnTo>
                    <a:pt x="33" y="185"/>
                  </a:lnTo>
                  <a:lnTo>
                    <a:pt x="33" y="190"/>
                  </a:lnTo>
                  <a:lnTo>
                    <a:pt x="33" y="190"/>
                  </a:lnTo>
                  <a:lnTo>
                    <a:pt x="33" y="194"/>
                  </a:lnTo>
                  <a:lnTo>
                    <a:pt x="36" y="194"/>
                  </a:lnTo>
                  <a:lnTo>
                    <a:pt x="36" y="199"/>
                  </a:lnTo>
                  <a:lnTo>
                    <a:pt x="45" y="199"/>
                  </a:lnTo>
                  <a:lnTo>
                    <a:pt x="45" y="204"/>
                  </a:lnTo>
                  <a:lnTo>
                    <a:pt x="46" y="204"/>
                  </a:lnTo>
                  <a:lnTo>
                    <a:pt x="46" y="208"/>
                  </a:lnTo>
                  <a:lnTo>
                    <a:pt x="49" y="208"/>
                  </a:lnTo>
                  <a:lnTo>
                    <a:pt x="49" y="213"/>
                  </a:lnTo>
                  <a:lnTo>
                    <a:pt x="53" y="213"/>
                  </a:lnTo>
                  <a:lnTo>
                    <a:pt x="53" y="218"/>
                  </a:lnTo>
                  <a:lnTo>
                    <a:pt x="54" y="218"/>
                  </a:lnTo>
                  <a:lnTo>
                    <a:pt x="54" y="223"/>
                  </a:lnTo>
                  <a:lnTo>
                    <a:pt x="55" y="223"/>
                  </a:lnTo>
                  <a:lnTo>
                    <a:pt x="55" y="228"/>
                  </a:lnTo>
                  <a:lnTo>
                    <a:pt x="58" y="228"/>
                  </a:lnTo>
                  <a:lnTo>
                    <a:pt x="58" y="233"/>
                  </a:lnTo>
                  <a:lnTo>
                    <a:pt x="58" y="233"/>
                  </a:lnTo>
                  <a:lnTo>
                    <a:pt x="58" y="238"/>
                  </a:lnTo>
                  <a:lnTo>
                    <a:pt x="62" y="238"/>
                  </a:lnTo>
                  <a:lnTo>
                    <a:pt x="62" y="243"/>
                  </a:lnTo>
                  <a:lnTo>
                    <a:pt x="63" y="243"/>
                  </a:lnTo>
                  <a:lnTo>
                    <a:pt x="63" y="248"/>
                  </a:lnTo>
                  <a:lnTo>
                    <a:pt x="65" y="248"/>
                  </a:lnTo>
                  <a:lnTo>
                    <a:pt x="65" y="253"/>
                  </a:lnTo>
                  <a:lnTo>
                    <a:pt x="65" y="253"/>
                  </a:lnTo>
                  <a:lnTo>
                    <a:pt x="65" y="258"/>
                  </a:lnTo>
                  <a:lnTo>
                    <a:pt x="68" y="258"/>
                  </a:lnTo>
                  <a:lnTo>
                    <a:pt x="68" y="263"/>
                  </a:lnTo>
                  <a:lnTo>
                    <a:pt x="71" y="263"/>
                  </a:lnTo>
                  <a:lnTo>
                    <a:pt x="71" y="268"/>
                  </a:lnTo>
                  <a:lnTo>
                    <a:pt x="71" y="268"/>
                  </a:lnTo>
                  <a:lnTo>
                    <a:pt x="71" y="273"/>
                  </a:lnTo>
                  <a:lnTo>
                    <a:pt x="76" y="273"/>
                  </a:lnTo>
                  <a:lnTo>
                    <a:pt x="76" y="278"/>
                  </a:lnTo>
                  <a:lnTo>
                    <a:pt x="78" y="278"/>
                  </a:lnTo>
                  <a:lnTo>
                    <a:pt x="78" y="284"/>
                  </a:lnTo>
                  <a:lnTo>
                    <a:pt x="81" y="284"/>
                  </a:lnTo>
                  <a:lnTo>
                    <a:pt x="81" y="289"/>
                  </a:lnTo>
                  <a:lnTo>
                    <a:pt x="93" y="289"/>
                  </a:lnTo>
                  <a:lnTo>
                    <a:pt x="93" y="294"/>
                  </a:lnTo>
                  <a:lnTo>
                    <a:pt x="94" y="294"/>
                  </a:lnTo>
                  <a:lnTo>
                    <a:pt x="94" y="300"/>
                  </a:lnTo>
                  <a:lnTo>
                    <a:pt x="98" y="300"/>
                  </a:lnTo>
                  <a:lnTo>
                    <a:pt x="98" y="306"/>
                  </a:lnTo>
                  <a:lnTo>
                    <a:pt x="107" y="306"/>
                  </a:lnTo>
                  <a:lnTo>
                    <a:pt x="107" y="312"/>
                  </a:lnTo>
                  <a:lnTo>
                    <a:pt x="108" y="312"/>
                  </a:lnTo>
                  <a:lnTo>
                    <a:pt x="108" y="319"/>
                  </a:lnTo>
                  <a:lnTo>
                    <a:pt x="116" y="319"/>
                  </a:lnTo>
                  <a:lnTo>
                    <a:pt x="116" y="326"/>
                  </a:lnTo>
                  <a:lnTo>
                    <a:pt x="132" y="326"/>
                  </a:lnTo>
                  <a:lnTo>
                    <a:pt x="132" y="332"/>
                  </a:lnTo>
                  <a:lnTo>
                    <a:pt x="140" y="332"/>
                  </a:lnTo>
                  <a:lnTo>
                    <a:pt x="140" y="340"/>
                  </a:lnTo>
                  <a:lnTo>
                    <a:pt x="163" y="340"/>
                  </a:lnTo>
                  <a:lnTo>
                    <a:pt x="163" y="348"/>
                  </a:lnTo>
                  <a:lnTo>
                    <a:pt x="186" y="348"/>
                  </a:lnTo>
                  <a:lnTo>
                    <a:pt x="186" y="359"/>
                  </a:lnTo>
                  <a:lnTo>
                    <a:pt x="191" y="359"/>
                  </a:lnTo>
                  <a:lnTo>
                    <a:pt x="191" y="369"/>
                  </a:lnTo>
                  <a:lnTo>
                    <a:pt x="192" y="369"/>
                  </a:lnTo>
                  <a:lnTo>
                    <a:pt x="192" y="380"/>
                  </a:lnTo>
                  <a:lnTo>
                    <a:pt x="533" y="380"/>
                  </a:lnTo>
                  <a:lnTo>
                    <a:pt x="533" y="380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3" name="Line 36">
              <a:extLst>
                <a:ext uri="{FF2B5EF4-FFF2-40B4-BE49-F238E27FC236}">
                  <a16:creationId xmlns:a16="http://schemas.microsoft.com/office/drawing/2014/main" id="{57B9CE25-3192-7C42-8EEF-A2988CEACCB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57204" y="1980033"/>
              <a:ext cx="714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4" name="Line 37">
              <a:extLst>
                <a:ext uri="{FF2B5EF4-FFF2-40B4-BE49-F238E27FC236}">
                  <a16:creationId xmlns:a16="http://schemas.microsoft.com/office/drawing/2014/main" id="{4EFB61DC-792E-CC44-8A3D-837F7A191A7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92129" y="1945108"/>
              <a:ext cx="0" cy="714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5" name="Line 38">
              <a:extLst>
                <a:ext uri="{FF2B5EF4-FFF2-40B4-BE49-F238E27FC236}">
                  <a16:creationId xmlns:a16="http://schemas.microsoft.com/office/drawing/2014/main" id="{B272B4A3-612E-684B-9AEC-F7B3CBB3C22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77842" y="2214983"/>
              <a:ext cx="714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6" name="Line 39">
              <a:extLst>
                <a:ext uri="{FF2B5EF4-FFF2-40B4-BE49-F238E27FC236}">
                  <a16:creationId xmlns:a16="http://schemas.microsoft.com/office/drawing/2014/main" id="{7DE9298C-D531-924E-A6FC-0DBD856D055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14354" y="2180058"/>
              <a:ext cx="0" cy="714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7" name="Line 40">
              <a:extLst>
                <a:ext uri="{FF2B5EF4-FFF2-40B4-BE49-F238E27FC236}">
                  <a16:creationId xmlns:a16="http://schemas.microsoft.com/office/drawing/2014/main" id="{346AED55-34E3-C144-8E86-1E37C4953E9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20704" y="2400720"/>
              <a:ext cx="714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8" name="Line 41">
              <a:extLst>
                <a:ext uri="{FF2B5EF4-FFF2-40B4-BE49-F238E27FC236}">
                  <a16:creationId xmlns:a16="http://schemas.microsoft.com/office/drawing/2014/main" id="{82B3EF0C-7C64-6F43-93F8-7B5371C8688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55629" y="2357858"/>
              <a:ext cx="0" cy="7778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9" name="Line 42">
              <a:extLst>
                <a:ext uri="{FF2B5EF4-FFF2-40B4-BE49-F238E27FC236}">
                  <a16:creationId xmlns:a16="http://schemas.microsoft.com/office/drawing/2014/main" id="{E951D58D-EF7E-5B41-BCCD-E3E9128CCE7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69917" y="2819820"/>
              <a:ext cx="714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0" name="Line 43">
              <a:extLst>
                <a:ext uri="{FF2B5EF4-FFF2-40B4-BE49-F238E27FC236}">
                  <a16:creationId xmlns:a16="http://schemas.microsoft.com/office/drawing/2014/main" id="{9FD8AF2B-B188-484D-8AFB-C529BD86E29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06429" y="2784895"/>
              <a:ext cx="0" cy="714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1" name="Line 44">
              <a:extLst>
                <a:ext uri="{FF2B5EF4-FFF2-40B4-BE49-F238E27FC236}">
                  <a16:creationId xmlns:a16="http://schemas.microsoft.com/office/drawing/2014/main" id="{B1ADD5FB-9E03-2E4A-A2CC-BE27296323A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77854" y="2884908"/>
              <a:ext cx="714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2" name="Line 45">
              <a:extLst>
                <a:ext uri="{FF2B5EF4-FFF2-40B4-BE49-F238E27FC236}">
                  <a16:creationId xmlns:a16="http://schemas.microsoft.com/office/drawing/2014/main" id="{90408BB3-378C-274A-A8B4-218496CD9E8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12779" y="2848395"/>
              <a:ext cx="0" cy="714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3" name="Line 46">
              <a:extLst>
                <a:ext uri="{FF2B5EF4-FFF2-40B4-BE49-F238E27FC236}">
                  <a16:creationId xmlns:a16="http://schemas.microsoft.com/office/drawing/2014/main" id="{E185E421-4108-1A46-9E26-EF80C8BAF5F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12779" y="2976983"/>
              <a:ext cx="79375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4" name="Line 47">
              <a:extLst>
                <a:ext uri="{FF2B5EF4-FFF2-40B4-BE49-F238E27FC236}">
                  <a16:creationId xmlns:a16="http://schemas.microsoft.com/office/drawing/2014/main" id="{6B962E7E-767E-AE4A-ADBD-36EDE42F8FB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55642" y="2942058"/>
              <a:ext cx="0" cy="6985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5" name="Line 48">
              <a:extLst>
                <a:ext uri="{FF2B5EF4-FFF2-40B4-BE49-F238E27FC236}">
                  <a16:creationId xmlns:a16="http://schemas.microsoft.com/office/drawing/2014/main" id="{0257CD37-20BB-EA49-9A5F-68BCC730CB9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35004" y="3040483"/>
              <a:ext cx="714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6" name="Line 49">
              <a:extLst>
                <a:ext uri="{FF2B5EF4-FFF2-40B4-BE49-F238E27FC236}">
                  <a16:creationId xmlns:a16="http://schemas.microsoft.com/office/drawing/2014/main" id="{34FA9716-D297-7E40-9B99-83BD75B7445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69929" y="3005558"/>
              <a:ext cx="0" cy="714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7" name="Line 50">
              <a:extLst>
                <a:ext uri="{FF2B5EF4-FFF2-40B4-BE49-F238E27FC236}">
                  <a16:creationId xmlns:a16="http://schemas.microsoft.com/office/drawing/2014/main" id="{8DB2F939-24F1-AE44-B4F7-38CA2098F19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84217" y="3076995"/>
              <a:ext cx="714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8" name="Line 51">
              <a:extLst>
                <a:ext uri="{FF2B5EF4-FFF2-40B4-BE49-F238E27FC236}">
                  <a16:creationId xmlns:a16="http://schemas.microsoft.com/office/drawing/2014/main" id="{33980254-1FE1-5C4D-B521-4383569B02E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20729" y="3040483"/>
              <a:ext cx="0" cy="714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9" name="Line 52">
              <a:extLst>
                <a:ext uri="{FF2B5EF4-FFF2-40B4-BE49-F238E27FC236}">
                  <a16:creationId xmlns:a16="http://schemas.microsoft.com/office/drawing/2014/main" id="{62ADE7E2-4848-5D4D-B6E3-0054BB62132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92154" y="3076995"/>
              <a:ext cx="6985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0" name="Line 53">
              <a:extLst>
                <a:ext uri="{FF2B5EF4-FFF2-40B4-BE49-F238E27FC236}">
                  <a16:creationId xmlns:a16="http://schemas.microsoft.com/office/drawing/2014/main" id="{C2972F1E-2FFC-444E-9B1E-8CFE5D0FB16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27079" y="3040483"/>
              <a:ext cx="0" cy="714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1" name="Line 54">
              <a:extLst>
                <a:ext uri="{FF2B5EF4-FFF2-40B4-BE49-F238E27FC236}">
                  <a16:creationId xmlns:a16="http://schemas.microsoft.com/office/drawing/2014/main" id="{9388256C-CBB8-3147-A8C2-676CB6C182C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20729" y="3111920"/>
              <a:ext cx="6985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2" name="Line 55">
              <a:extLst>
                <a:ext uri="{FF2B5EF4-FFF2-40B4-BE49-F238E27FC236}">
                  <a16:creationId xmlns:a16="http://schemas.microsoft.com/office/drawing/2014/main" id="{5D269CF0-0A7D-5F46-A747-F9177F00E51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55654" y="3076995"/>
              <a:ext cx="0" cy="714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3" name="Line 56">
              <a:extLst>
                <a:ext uri="{FF2B5EF4-FFF2-40B4-BE49-F238E27FC236}">
                  <a16:creationId xmlns:a16="http://schemas.microsoft.com/office/drawing/2014/main" id="{21662C8A-FB28-324C-9259-E7699F5FBBB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69942" y="3211933"/>
              <a:ext cx="714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4" name="Line 57">
              <a:extLst>
                <a:ext uri="{FF2B5EF4-FFF2-40B4-BE49-F238E27FC236}">
                  <a16:creationId xmlns:a16="http://schemas.microsoft.com/office/drawing/2014/main" id="{39A7400B-E2A6-1147-8A42-E781C753F8A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04867" y="3177008"/>
              <a:ext cx="0" cy="6985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5" name="Line 58">
              <a:extLst>
                <a:ext uri="{FF2B5EF4-FFF2-40B4-BE49-F238E27FC236}">
                  <a16:creationId xmlns:a16="http://schemas.microsoft.com/office/drawing/2014/main" id="{9277F986-1B4C-8849-B8EA-4D4BD3E7DFB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84242" y="3532608"/>
              <a:ext cx="714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6" name="Line 59">
              <a:extLst>
                <a:ext uri="{FF2B5EF4-FFF2-40B4-BE49-F238E27FC236}">
                  <a16:creationId xmlns:a16="http://schemas.microsoft.com/office/drawing/2014/main" id="{BEC86AC5-30B1-9B45-A693-E793514DF35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19167" y="3496095"/>
              <a:ext cx="0" cy="714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7" name="Line 60">
              <a:extLst>
                <a:ext uri="{FF2B5EF4-FFF2-40B4-BE49-F238E27FC236}">
                  <a16:creationId xmlns:a16="http://schemas.microsoft.com/office/drawing/2014/main" id="{450B02B4-CADF-5843-9F08-24C6FB7A781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19179" y="3716758"/>
              <a:ext cx="7778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8" name="Line 61">
              <a:extLst>
                <a:ext uri="{FF2B5EF4-FFF2-40B4-BE49-F238E27FC236}">
                  <a16:creationId xmlns:a16="http://schemas.microsoft.com/office/drawing/2014/main" id="{E3C42C45-47B4-F94C-AE72-D2CDE706C74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62042" y="3681833"/>
              <a:ext cx="0" cy="714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9" name="Line 62">
              <a:extLst>
                <a:ext uri="{FF2B5EF4-FFF2-40B4-BE49-F238E27FC236}">
                  <a16:creationId xmlns:a16="http://schemas.microsoft.com/office/drawing/2014/main" id="{91A0655B-3A56-D14E-A5DF-F5DEE3D3F70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25529" y="3716758"/>
              <a:ext cx="714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0" name="Line 63">
              <a:extLst>
                <a:ext uri="{FF2B5EF4-FFF2-40B4-BE49-F238E27FC236}">
                  <a16:creationId xmlns:a16="http://schemas.microsoft.com/office/drawing/2014/main" id="{65088A81-5327-2441-980C-8B9A1FC288F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62042" y="3681833"/>
              <a:ext cx="0" cy="714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1" name="Line 64">
              <a:extLst>
                <a:ext uri="{FF2B5EF4-FFF2-40B4-BE49-F238E27FC236}">
                  <a16:creationId xmlns:a16="http://schemas.microsoft.com/office/drawing/2014/main" id="{B0CF7514-CC5D-984B-8DF5-C3313D4A35B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76329" y="3796133"/>
              <a:ext cx="714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2" name="Line 65">
              <a:extLst>
                <a:ext uri="{FF2B5EF4-FFF2-40B4-BE49-F238E27FC236}">
                  <a16:creationId xmlns:a16="http://schemas.microsoft.com/office/drawing/2014/main" id="{C9B808BB-B795-D142-8736-54B16266845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11254" y="3759620"/>
              <a:ext cx="0" cy="714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3" name="Line 66">
              <a:extLst>
                <a:ext uri="{FF2B5EF4-FFF2-40B4-BE49-F238E27FC236}">
                  <a16:creationId xmlns:a16="http://schemas.microsoft.com/office/drawing/2014/main" id="{C29ABC1E-F3F2-6E44-9C1D-C7D573A418E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33479" y="3838995"/>
              <a:ext cx="6985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4" name="Line 67">
              <a:extLst>
                <a:ext uri="{FF2B5EF4-FFF2-40B4-BE49-F238E27FC236}">
                  <a16:creationId xmlns:a16="http://schemas.microsoft.com/office/drawing/2014/main" id="{E20E187D-856D-AB4A-8A86-062E6612D93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68404" y="3796133"/>
              <a:ext cx="0" cy="7778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5" name="Line 68">
              <a:extLst>
                <a:ext uri="{FF2B5EF4-FFF2-40B4-BE49-F238E27FC236}">
                  <a16:creationId xmlns:a16="http://schemas.microsoft.com/office/drawing/2014/main" id="{22583E23-A0C0-C44E-B4B8-C59CCBA2F7C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39829" y="3838995"/>
              <a:ext cx="714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6" name="Line 69">
              <a:extLst>
                <a:ext uri="{FF2B5EF4-FFF2-40B4-BE49-F238E27FC236}">
                  <a16:creationId xmlns:a16="http://schemas.microsoft.com/office/drawing/2014/main" id="{91E1F7D3-8E04-AD48-9544-042D0CD1BB6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76342" y="3796133"/>
              <a:ext cx="0" cy="7778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7" name="Line 70">
              <a:extLst>
                <a:ext uri="{FF2B5EF4-FFF2-40B4-BE49-F238E27FC236}">
                  <a16:creationId xmlns:a16="http://schemas.microsoft.com/office/drawing/2014/main" id="{5FB8B4B5-ADA1-6E48-9BEB-F4F48F383F3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47767" y="3838995"/>
              <a:ext cx="6985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8" name="Line 71">
              <a:extLst>
                <a:ext uri="{FF2B5EF4-FFF2-40B4-BE49-F238E27FC236}">
                  <a16:creationId xmlns:a16="http://schemas.microsoft.com/office/drawing/2014/main" id="{4C0AADC4-DAD6-D944-B3A4-BDC4206824A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82692" y="3796133"/>
              <a:ext cx="0" cy="7778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9" name="Line 72">
              <a:extLst>
                <a:ext uri="{FF2B5EF4-FFF2-40B4-BE49-F238E27FC236}">
                  <a16:creationId xmlns:a16="http://schemas.microsoft.com/office/drawing/2014/main" id="{756AAEC4-613F-4046-9032-AAD5B3AEFE2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39854" y="4023145"/>
              <a:ext cx="6985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0" name="Line 73">
              <a:extLst>
                <a:ext uri="{FF2B5EF4-FFF2-40B4-BE49-F238E27FC236}">
                  <a16:creationId xmlns:a16="http://schemas.microsoft.com/office/drawing/2014/main" id="{338B4FA3-A102-6A48-A264-44CD05A835A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74779" y="3988220"/>
              <a:ext cx="0" cy="714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1" name="Line 74">
              <a:extLst>
                <a:ext uri="{FF2B5EF4-FFF2-40B4-BE49-F238E27FC236}">
                  <a16:creationId xmlns:a16="http://schemas.microsoft.com/office/drawing/2014/main" id="{D96287FC-F5AB-A440-91AE-3259103D4D9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89067" y="4023145"/>
              <a:ext cx="714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2" name="Line 75">
              <a:extLst>
                <a:ext uri="{FF2B5EF4-FFF2-40B4-BE49-F238E27FC236}">
                  <a16:creationId xmlns:a16="http://schemas.microsoft.com/office/drawing/2014/main" id="{242C70F7-99D9-3747-B7DA-85903158793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23992" y="3988220"/>
              <a:ext cx="0" cy="714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3" name="Line 76">
              <a:extLst>
                <a:ext uri="{FF2B5EF4-FFF2-40B4-BE49-F238E27FC236}">
                  <a16:creationId xmlns:a16="http://schemas.microsoft.com/office/drawing/2014/main" id="{20D30BA3-6EA9-B842-BE61-8D3AE10F09E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17642" y="4080295"/>
              <a:ext cx="714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4" name="Line 77">
              <a:extLst>
                <a:ext uri="{FF2B5EF4-FFF2-40B4-BE49-F238E27FC236}">
                  <a16:creationId xmlns:a16="http://schemas.microsoft.com/office/drawing/2014/main" id="{027877AC-7291-4642-9848-2087C909EC2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52567" y="4045370"/>
              <a:ext cx="0" cy="6985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5" name="Line 78">
              <a:extLst>
                <a:ext uri="{FF2B5EF4-FFF2-40B4-BE49-F238E27FC236}">
                  <a16:creationId xmlns:a16="http://schemas.microsoft.com/office/drawing/2014/main" id="{02054A64-F7C3-3A46-B38C-363B6E00E6B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38304" y="4137445"/>
              <a:ext cx="714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6" name="Line 79">
              <a:extLst>
                <a:ext uri="{FF2B5EF4-FFF2-40B4-BE49-F238E27FC236}">
                  <a16:creationId xmlns:a16="http://schemas.microsoft.com/office/drawing/2014/main" id="{8390FE24-9E15-0444-AE4C-F5049059ECB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73229" y="4100933"/>
              <a:ext cx="0" cy="714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7" name="Line 80">
              <a:extLst>
                <a:ext uri="{FF2B5EF4-FFF2-40B4-BE49-F238E27FC236}">
                  <a16:creationId xmlns:a16="http://schemas.microsoft.com/office/drawing/2014/main" id="{8BC4DF2C-D355-BF4E-99D2-46A6833CB9E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16092" y="4137445"/>
              <a:ext cx="714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8" name="Line 81">
              <a:extLst>
                <a:ext uri="{FF2B5EF4-FFF2-40B4-BE49-F238E27FC236}">
                  <a16:creationId xmlns:a16="http://schemas.microsoft.com/office/drawing/2014/main" id="{11FDE349-1398-DA4C-88A3-1DC932195A8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52604" y="4100933"/>
              <a:ext cx="0" cy="714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9" name="Line 82">
              <a:extLst>
                <a:ext uri="{FF2B5EF4-FFF2-40B4-BE49-F238E27FC236}">
                  <a16:creationId xmlns:a16="http://schemas.microsoft.com/office/drawing/2014/main" id="{D99DFE52-8C3E-9840-87B2-9606D6C350C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43154" y="4364458"/>
              <a:ext cx="714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0" name="Line 83">
              <a:extLst>
                <a:ext uri="{FF2B5EF4-FFF2-40B4-BE49-F238E27FC236}">
                  <a16:creationId xmlns:a16="http://schemas.microsoft.com/office/drawing/2014/main" id="{74FF5C90-91FF-DC48-AA4F-DC97D3712B3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78079" y="4329533"/>
              <a:ext cx="0" cy="714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1" name="Line 84">
              <a:extLst>
                <a:ext uri="{FF2B5EF4-FFF2-40B4-BE49-F238E27FC236}">
                  <a16:creationId xmlns:a16="http://schemas.microsoft.com/office/drawing/2014/main" id="{DDFD7786-DA48-2D4E-8310-F2156F97BCC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55904" y="4364458"/>
              <a:ext cx="714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2" name="Line 85">
              <a:extLst>
                <a:ext uri="{FF2B5EF4-FFF2-40B4-BE49-F238E27FC236}">
                  <a16:creationId xmlns:a16="http://schemas.microsoft.com/office/drawing/2014/main" id="{432D6461-49D8-F546-871C-E01C1C10D9B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590829" y="4329533"/>
              <a:ext cx="0" cy="714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3" name="Line 86">
              <a:extLst>
                <a:ext uri="{FF2B5EF4-FFF2-40B4-BE49-F238E27FC236}">
                  <a16:creationId xmlns:a16="http://schemas.microsoft.com/office/drawing/2014/main" id="{96A82A67-95FA-184D-8AAC-6054DC866B5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919442" y="4364458"/>
              <a:ext cx="6985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4" name="Line 87">
              <a:extLst>
                <a:ext uri="{FF2B5EF4-FFF2-40B4-BE49-F238E27FC236}">
                  <a16:creationId xmlns:a16="http://schemas.microsoft.com/office/drawing/2014/main" id="{DEC59D12-C4CA-A046-9DB1-AAE7334480F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954367" y="4329533"/>
              <a:ext cx="0" cy="714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5" name="Line 88">
              <a:extLst>
                <a:ext uri="{FF2B5EF4-FFF2-40B4-BE49-F238E27FC236}">
                  <a16:creationId xmlns:a16="http://schemas.microsoft.com/office/drawing/2014/main" id="{F159C006-41DC-AD4B-8F90-45F5614E7E7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068667" y="4364458"/>
              <a:ext cx="714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6" name="Line 89">
              <a:extLst>
                <a:ext uri="{FF2B5EF4-FFF2-40B4-BE49-F238E27FC236}">
                  <a16:creationId xmlns:a16="http://schemas.microsoft.com/office/drawing/2014/main" id="{795BBD6E-8639-4640-B33B-8E18EB8A110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103592" y="4329533"/>
              <a:ext cx="0" cy="714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7" name="Line 90">
              <a:extLst>
                <a:ext uri="{FF2B5EF4-FFF2-40B4-BE49-F238E27FC236}">
                  <a16:creationId xmlns:a16="http://schemas.microsoft.com/office/drawing/2014/main" id="{A016F4F7-4825-4144-8C8B-CCCE0F97CB8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986242" y="4364458"/>
              <a:ext cx="714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8" name="Line 91">
              <a:extLst>
                <a:ext uri="{FF2B5EF4-FFF2-40B4-BE49-F238E27FC236}">
                  <a16:creationId xmlns:a16="http://schemas.microsoft.com/office/drawing/2014/main" id="{427DE4BF-2E06-9446-9DA4-6B6DCF9DFAB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022754" y="4329533"/>
              <a:ext cx="0" cy="714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9" name="Rectangle 92">
              <a:extLst>
                <a:ext uri="{FF2B5EF4-FFF2-40B4-BE49-F238E27FC236}">
                  <a16:creationId xmlns:a16="http://schemas.microsoft.com/office/drawing/2014/main" id="{9DFE8B8F-C78E-5448-BD73-875F503C6D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07979" y="5424909"/>
              <a:ext cx="251545" cy="24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kumimoji="1" lang="en-US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0" name="Rectangle 93">
              <a:extLst>
                <a:ext uri="{FF2B5EF4-FFF2-40B4-BE49-F238E27FC236}">
                  <a16:creationId xmlns:a16="http://schemas.microsoft.com/office/drawing/2014/main" id="{AAC8F29F-C8AA-1946-A68C-DF32F1CAEC9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14429" y="5424908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7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1" name="Rectangle 94">
              <a:extLst>
                <a:ext uri="{FF2B5EF4-FFF2-40B4-BE49-F238E27FC236}">
                  <a16:creationId xmlns:a16="http://schemas.microsoft.com/office/drawing/2014/main" id="{1210947C-37A9-184F-8671-2795DF76E0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16117" y="5424908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2" name="Rectangle 95">
              <a:extLst>
                <a:ext uri="{FF2B5EF4-FFF2-40B4-BE49-F238E27FC236}">
                  <a16:creationId xmlns:a16="http://schemas.microsoft.com/office/drawing/2014/main" id="{A900ECB6-8398-244B-9896-23395188070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84467" y="5424908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3" name="Rectangle 96">
              <a:extLst>
                <a:ext uri="{FF2B5EF4-FFF2-40B4-BE49-F238E27FC236}">
                  <a16:creationId xmlns:a16="http://schemas.microsoft.com/office/drawing/2014/main" id="{FA409677-52EA-9043-8346-203281A434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60754" y="5424908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4" name="Rectangle 97">
              <a:extLst>
                <a:ext uri="{FF2B5EF4-FFF2-40B4-BE49-F238E27FC236}">
                  <a16:creationId xmlns:a16="http://schemas.microsoft.com/office/drawing/2014/main" id="{7DF9921A-C48A-B74C-A636-AFB675D384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29104" y="5424908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5" name="Rectangle 98">
              <a:extLst>
                <a:ext uri="{FF2B5EF4-FFF2-40B4-BE49-F238E27FC236}">
                  <a16:creationId xmlns:a16="http://schemas.microsoft.com/office/drawing/2014/main" id="{0963C0C3-4EF6-704C-B5DB-2D770C5FF5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53951" y="5227314"/>
              <a:ext cx="771046" cy="153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umber at risk</a:t>
              </a:r>
              <a:endParaRPr kumimoji="1" lang="ja-JP" altLang="ja-JP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59B3A9C1-DA2B-9447-B2FE-E1AFFCA54EA8}"/>
              </a:ext>
            </a:extLst>
          </p:cNvPr>
          <p:cNvSpPr/>
          <p:nvPr/>
        </p:nvSpPr>
        <p:spPr>
          <a:xfrm>
            <a:off x="58091" y="245781"/>
            <a:ext cx="304744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b="1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</a:rPr>
              <a:t>Supplementary</a:t>
            </a:r>
            <a:r>
              <a:rPr lang="en-US" altLang="ja-JP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</a:rPr>
              <a:t> </a:t>
            </a:r>
            <a:r>
              <a:rPr lang="en-US" altLang="ja-JP" b="1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gure 1</a:t>
            </a:r>
            <a:endParaRPr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ja-JP" altLang="en-US" dirty="0"/>
          </a:p>
        </p:txBody>
      </p:sp>
      <p:sp>
        <p:nvSpPr>
          <p:cNvPr id="489" name="Line 111">
            <a:extLst>
              <a:ext uri="{FF2B5EF4-FFF2-40B4-BE49-F238E27FC236}">
                <a16:creationId xmlns:a16="http://schemas.microsoft.com/office/drawing/2014/main" id="{5FE6847A-DFD5-5F47-99EC-C94ADA28AF20}"/>
              </a:ext>
            </a:extLst>
          </p:cNvPr>
          <p:cNvSpPr>
            <a:spLocks noChangeShapeType="1"/>
          </p:cNvSpPr>
          <p:nvPr/>
        </p:nvSpPr>
        <p:spPr bwMode="auto">
          <a:xfrm>
            <a:off x="1886144" y="3085262"/>
            <a:ext cx="178984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2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0" name="Rectangle 108">
            <a:extLst>
              <a:ext uri="{FF2B5EF4-FFF2-40B4-BE49-F238E27FC236}">
                <a16:creationId xmlns:a16="http://schemas.microsoft.com/office/drawing/2014/main" id="{4A2DBC33-375E-7544-A071-4B7FFA3DF54C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66343" y="3009165"/>
            <a:ext cx="1739259" cy="5539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ntreated patients (n=27)</a:t>
            </a:r>
          </a:p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dian 9.3m (3.8m-18.8m) </a:t>
            </a:r>
            <a:endParaRPr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1" lang="ja-JP" altLang="ja-JP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1" name="Line 111">
            <a:extLst>
              <a:ext uri="{FF2B5EF4-FFF2-40B4-BE49-F238E27FC236}">
                <a16:creationId xmlns:a16="http://schemas.microsoft.com/office/drawing/2014/main" id="{484CBDA7-DAD0-9544-9DF1-35595276A9D9}"/>
              </a:ext>
            </a:extLst>
          </p:cNvPr>
          <p:cNvSpPr>
            <a:spLocks noChangeShapeType="1"/>
          </p:cNvSpPr>
          <p:nvPr/>
        </p:nvSpPr>
        <p:spPr bwMode="auto">
          <a:xfrm>
            <a:off x="6414595" y="3085262"/>
            <a:ext cx="178984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2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182937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2" name="Rectangle 89">
            <a:extLst>
              <a:ext uri="{FF2B5EF4-FFF2-40B4-BE49-F238E27FC236}">
                <a16:creationId xmlns:a16="http://schemas.microsoft.com/office/drawing/2014/main" id="{90A592D8-BB8B-C24B-AC01-7C597099EB0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368" y="4839293"/>
            <a:ext cx="771045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Number at risk</a:t>
            </a:r>
            <a:endParaRPr kumimoji="1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3" name="Rectangle 110">
            <a:extLst>
              <a:ext uri="{FF2B5EF4-FFF2-40B4-BE49-F238E27FC236}">
                <a16:creationId xmlns:a16="http://schemas.microsoft.com/office/drawing/2014/main" id="{9896FC02-89C1-9044-989C-7114C2F2E691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25488" y="4831598"/>
            <a:ext cx="766235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ime (months)</a:t>
            </a:r>
            <a:endParaRPr kumimoji="1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4" name="Rectangle 30">
            <a:extLst>
              <a:ext uri="{FF2B5EF4-FFF2-40B4-BE49-F238E27FC236}">
                <a16:creationId xmlns:a16="http://schemas.microsoft.com/office/drawing/2014/main" id="{804E59E6-C02E-3541-8888-F0D00E33F8EC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-186910" y="3377268"/>
            <a:ext cx="1522853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rogression-free survival (%)</a:t>
            </a:r>
            <a:endParaRPr kumimoji="1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6" name="Line 111">
            <a:extLst>
              <a:ext uri="{FF2B5EF4-FFF2-40B4-BE49-F238E27FC236}">
                <a16:creationId xmlns:a16="http://schemas.microsoft.com/office/drawing/2014/main" id="{67DEC4FB-61DB-7C45-BF0D-8E6F2E173724}"/>
              </a:ext>
            </a:extLst>
          </p:cNvPr>
          <p:cNvSpPr>
            <a:spLocks noChangeShapeType="1"/>
          </p:cNvSpPr>
          <p:nvPr/>
        </p:nvSpPr>
        <p:spPr bwMode="auto">
          <a:xfrm>
            <a:off x="1867142" y="2755937"/>
            <a:ext cx="178984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7" name="Line 112">
            <a:extLst>
              <a:ext uri="{FF2B5EF4-FFF2-40B4-BE49-F238E27FC236}">
                <a16:creationId xmlns:a16="http://schemas.microsoft.com/office/drawing/2014/main" id="{6BE45F55-B5B1-6440-81BE-EC9A079767DD}"/>
              </a:ext>
            </a:extLst>
          </p:cNvPr>
          <p:cNvSpPr>
            <a:spLocks noChangeShapeType="1"/>
          </p:cNvSpPr>
          <p:nvPr/>
        </p:nvSpPr>
        <p:spPr bwMode="auto">
          <a:xfrm>
            <a:off x="1867142" y="2034197"/>
            <a:ext cx="178984" cy="0"/>
          </a:xfrm>
          <a:prstGeom prst="line">
            <a:avLst/>
          </a:prstGeom>
          <a:noFill/>
          <a:ln w="9525" cap="rnd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8" name="Line 113">
            <a:extLst>
              <a:ext uri="{FF2B5EF4-FFF2-40B4-BE49-F238E27FC236}">
                <a16:creationId xmlns:a16="http://schemas.microsoft.com/office/drawing/2014/main" id="{74B1CF52-3A4A-204A-99C0-8EA6DE27BF7D}"/>
              </a:ext>
            </a:extLst>
          </p:cNvPr>
          <p:cNvSpPr>
            <a:spLocks noChangeShapeType="1"/>
          </p:cNvSpPr>
          <p:nvPr/>
        </p:nvSpPr>
        <p:spPr bwMode="auto">
          <a:xfrm>
            <a:off x="1867142" y="2404869"/>
            <a:ext cx="178984" cy="0"/>
          </a:xfrm>
          <a:prstGeom prst="line">
            <a:avLst/>
          </a:prstGeom>
          <a:noFill/>
          <a:ln w="9525" cap="rnd">
            <a:solidFill>
              <a:srgbClr val="00CD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9" name="Rectangle 107">
            <a:extLst>
              <a:ext uri="{FF2B5EF4-FFF2-40B4-BE49-F238E27FC236}">
                <a16:creationId xmlns:a16="http://schemas.microsoft.com/office/drawing/2014/main" id="{54D90C3D-1670-5245-A67D-30BA24791EB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53074" y="2659958"/>
            <a:ext cx="143449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Non-</a:t>
            </a:r>
            <a:r>
              <a:rPr kumimoji="1" lang="en-US" altLang="ja-JP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irAEs</a:t>
            </a:r>
            <a:r>
              <a:rPr kumimoji="1" lang="en-US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(n=15)</a:t>
            </a:r>
            <a:endParaRPr kumimoji="1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0" name="Rectangle 108">
            <a:extLst>
              <a:ext uri="{FF2B5EF4-FFF2-40B4-BE49-F238E27FC236}">
                <a16:creationId xmlns:a16="http://schemas.microsoft.com/office/drawing/2014/main" id="{0F8C230E-2E58-F94C-B861-B5C1A7A7BD2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53074" y="1942174"/>
            <a:ext cx="63799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LD (n=6)</a:t>
            </a:r>
            <a:endParaRPr kumimoji="1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1" name="Rectangle 109">
            <a:extLst>
              <a:ext uri="{FF2B5EF4-FFF2-40B4-BE49-F238E27FC236}">
                <a16:creationId xmlns:a16="http://schemas.microsoft.com/office/drawing/2014/main" id="{8676215D-459A-104F-A406-8170F36C42F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53074" y="2310869"/>
            <a:ext cx="133850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12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IrAEs</a:t>
            </a:r>
            <a:r>
              <a:rPr kumimoji="1" lang="en-US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-non-ILD (n=6)</a:t>
            </a:r>
            <a:endParaRPr kumimoji="1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4" name="Rectangle 89">
            <a:extLst>
              <a:ext uri="{FF2B5EF4-FFF2-40B4-BE49-F238E27FC236}">
                <a16:creationId xmlns:a16="http://schemas.microsoft.com/office/drawing/2014/main" id="{EAD5DA3D-E464-C040-A262-04EBCF9AEE3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24861" y="4846086"/>
            <a:ext cx="771045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Number at risk</a:t>
            </a:r>
            <a:endParaRPr kumimoji="1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5" name="Rectangle 110">
            <a:extLst>
              <a:ext uri="{FF2B5EF4-FFF2-40B4-BE49-F238E27FC236}">
                <a16:creationId xmlns:a16="http://schemas.microsoft.com/office/drawing/2014/main" id="{0A0EE9F8-6B02-A446-8E39-10EF48375CDD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66239" y="4810598"/>
            <a:ext cx="766235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ime (months)</a:t>
            </a:r>
            <a:endParaRPr kumimoji="1" lang="ja-JP" altLang="ja-JP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6" name="Rectangle 30">
            <a:extLst>
              <a:ext uri="{FF2B5EF4-FFF2-40B4-BE49-F238E27FC236}">
                <a16:creationId xmlns:a16="http://schemas.microsoft.com/office/drawing/2014/main" id="{278E51CE-BDB4-9743-8277-28B8B7F6BF20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4269947" y="3340703"/>
            <a:ext cx="1522853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rogression-free survival (%)</a:t>
            </a:r>
            <a:endParaRPr kumimoji="1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7" name="Line 111">
            <a:extLst>
              <a:ext uri="{FF2B5EF4-FFF2-40B4-BE49-F238E27FC236}">
                <a16:creationId xmlns:a16="http://schemas.microsoft.com/office/drawing/2014/main" id="{4814BADC-C348-5142-BC21-E7490B9B4230}"/>
              </a:ext>
            </a:extLst>
          </p:cNvPr>
          <p:cNvSpPr>
            <a:spLocks noChangeShapeType="1"/>
          </p:cNvSpPr>
          <p:nvPr/>
        </p:nvSpPr>
        <p:spPr bwMode="auto">
          <a:xfrm>
            <a:off x="6348680" y="3075894"/>
            <a:ext cx="178984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8" name="Line 112">
            <a:extLst>
              <a:ext uri="{FF2B5EF4-FFF2-40B4-BE49-F238E27FC236}">
                <a16:creationId xmlns:a16="http://schemas.microsoft.com/office/drawing/2014/main" id="{3883C4DD-3FAC-0C43-A75B-9E2ED59A2D50}"/>
              </a:ext>
            </a:extLst>
          </p:cNvPr>
          <p:cNvSpPr>
            <a:spLocks noChangeShapeType="1"/>
          </p:cNvSpPr>
          <p:nvPr/>
        </p:nvSpPr>
        <p:spPr bwMode="auto">
          <a:xfrm>
            <a:off x="6348680" y="2333209"/>
            <a:ext cx="178984" cy="0"/>
          </a:xfrm>
          <a:prstGeom prst="line">
            <a:avLst/>
          </a:prstGeom>
          <a:noFill/>
          <a:ln w="9525" cap="rnd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9" name="Line 113">
            <a:extLst>
              <a:ext uri="{FF2B5EF4-FFF2-40B4-BE49-F238E27FC236}">
                <a16:creationId xmlns:a16="http://schemas.microsoft.com/office/drawing/2014/main" id="{C6AC68E6-9506-4E48-886D-4F5147535A0D}"/>
              </a:ext>
            </a:extLst>
          </p:cNvPr>
          <p:cNvSpPr>
            <a:spLocks noChangeShapeType="1"/>
          </p:cNvSpPr>
          <p:nvPr/>
        </p:nvSpPr>
        <p:spPr bwMode="auto">
          <a:xfrm>
            <a:off x="6348680" y="2696716"/>
            <a:ext cx="178984" cy="0"/>
          </a:xfrm>
          <a:prstGeom prst="line">
            <a:avLst/>
          </a:prstGeom>
          <a:noFill/>
          <a:ln w="9525" cap="rnd">
            <a:solidFill>
              <a:srgbClr val="00CD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0" name="Rectangle 107">
            <a:extLst>
              <a:ext uri="{FF2B5EF4-FFF2-40B4-BE49-F238E27FC236}">
                <a16:creationId xmlns:a16="http://schemas.microsoft.com/office/drawing/2014/main" id="{C562EFEE-DD47-0042-86FB-843AF33A99F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26661" y="2980872"/>
            <a:ext cx="113332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Non-</a:t>
            </a:r>
            <a:r>
              <a:rPr kumimoji="1" lang="en-US" altLang="ja-JP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irAEs</a:t>
            </a:r>
            <a:r>
              <a:rPr kumimoji="1" lang="en-US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(n=76)</a:t>
            </a:r>
            <a:endParaRPr kumimoji="1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1" name="Rectangle 108">
            <a:extLst>
              <a:ext uri="{FF2B5EF4-FFF2-40B4-BE49-F238E27FC236}">
                <a16:creationId xmlns:a16="http://schemas.microsoft.com/office/drawing/2014/main" id="{42C7D4C4-3B67-0346-8F8F-CAE74CC53043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26661" y="2225285"/>
            <a:ext cx="71493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LD (n=10)</a:t>
            </a:r>
            <a:endParaRPr kumimoji="1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2" name="Rectangle 109">
            <a:extLst>
              <a:ext uri="{FF2B5EF4-FFF2-40B4-BE49-F238E27FC236}">
                <a16:creationId xmlns:a16="http://schemas.microsoft.com/office/drawing/2014/main" id="{6F431327-9605-5C46-806C-664B44847B4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26661" y="2595244"/>
            <a:ext cx="141545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12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IrAEs</a:t>
            </a:r>
            <a:r>
              <a:rPr kumimoji="1" lang="en-US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-non-ILD (n=17)</a:t>
            </a:r>
            <a:endParaRPr kumimoji="1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4" name="テキスト ボックス 343">
            <a:extLst>
              <a:ext uri="{FF2B5EF4-FFF2-40B4-BE49-F238E27FC236}">
                <a16:creationId xmlns:a16="http://schemas.microsoft.com/office/drawing/2014/main" id="{1D0B0D89-D1C6-5748-9B56-54A8C49E2BFF}"/>
              </a:ext>
            </a:extLst>
          </p:cNvPr>
          <p:cNvSpPr txBox="1"/>
          <p:nvPr/>
        </p:nvSpPr>
        <p:spPr>
          <a:xfrm>
            <a:off x="4587101" y="1372003"/>
            <a:ext cx="4442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5" name="テキスト ボックス 344">
            <a:extLst>
              <a:ext uri="{FF2B5EF4-FFF2-40B4-BE49-F238E27FC236}">
                <a16:creationId xmlns:a16="http://schemas.microsoft.com/office/drawing/2014/main" id="{4D21E7C9-4CFB-CD41-B6E7-DF73A7B8422A}"/>
              </a:ext>
            </a:extLst>
          </p:cNvPr>
          <p:cNvSpPr txBox="1"/>
          <p:nvPr/>
        </p:nvSpPr>
        <p:spPr>
          <a:xfrm>
            <a:off x="172462" y="1372003"/>
            <a:ext cx="4442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6" name="正方形/長方形 345">
            <a:extLst>
              <a:ext uri="{FF2B5EF4-FFF2-40B4-BE49-F238E27FC236}">
                <a16:creationId xmlns:a16="http://schemas.microsoft.com/office/drawing/2014/main" id="{D98CB455-7BC6-504F-94F1-E4EC69F50BE6}"/>
              </a:ext>
            </a:extLst>
          </p:cNvPr>
          <p:cNvSpPr/>
          <p:nvPr/>
        </p:nvSpPr>
        <p:spPr>
          <a:xfrm>
            <a:off x="1098074" y="4077139"/>
            <a:ext cx="162095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g-rank test: 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09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9" name="正方形/長方形 348">
            <a:extLst>
              <a:ext uri="{FF2B5EF4-FFF2-40B4-BE49-F238E27FC236}">
                <a16:creationId xmlns:a16="http://schemas.microsoft.com/office/drawing/2014/main" id="{BA6B5585-CD13-6549-A4E3-DF8032FA5AFB}"/>
              </a:ext>
            </a:extLst>
          </p:cNvPr>
          <p:cNvSpPr/>
          <p:nvPr/>
        </p:nvSpPr>
        <p:spPr>
          <a:xfrm>
            <a:off x="6936797" y="3793680"/>
            <a:ext cx="162095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g-rank test: 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17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77" name="グループ化 476">
            <a:extLst>
              <a:ext uri="{FF2B5EF4-FFF2-40B4-BE49-F238E27FC236}">
                <a16:creationId xmlns:a16="http://schemas.microsoft.com/office/drawing/2014/main" id="{3B27AC16-34C1-A047-ADF9-D0CA176782D2}"/>
              </a:ext>
            </a:extLst>
          </p:cNvPr>
          <p:cNvGrpSpPr/>
          <p:nvPr/>
        </p:nvGrpSpPr>
        <p:grpSpPr>
          <a:xfrm>
            <a:off x="735454" y="2395045"/>
            <a:ext cx="3532014" cy="2386613"/>
            <a:chOff x="2490327" y="880528"/>
            <a:chExt cx="3963347" cy="3015366"/>
          </a:xfrm>
        </p:grpSpPr>
        <p:sp>
          <p:nvSpPr>
            <p:cNvPr id="478" name="Line 6">
              <a:extLst>
                <a:ext uri="{FF2B5EF4-FFF2-40B4-BE49-F238E27FC236}">
                  <a16:creationId xmlns:a16="http://schemas.microsoft.com/office/drawing/2014/main" id="{AFEA1CAC-7363-A940-B93C-E65EB5F32DB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32158" y="3563857"/>
              <a:ext cx="3564817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9" name="Line 7">
              <a:extLst>
                <a:ext uri="{FF2B5EF4-FFF2-40B4-BE49-F238E27FC236}">
                  <a16:creationId xmlns:a16="http://schemas.microsoft.com/office/drawing/2014/main" id="{5CA4806F-8F9F-414B-B00C-9FDBEEB96B0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32158" y="3563857"/>
              <a:ext cx="0" cy="62548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0" name="Line 8">
              <a:extLst>
                <a:ext uri="{FF2B5EF4-FFF2-40B4-BE49-F238E27FC236}">
                  <a16:creationId xmlns:a16="http://schemas.microsoft.com/office/drawing/2014/main" id="{805E9B4A-1F5C-4043-AF40-3FE576A7A11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43727" y="3563857"/>
              <a:ext cx="0" cy="62548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1" name="Line 9">
              <a:extLst>
                <a:ext uri="{FF2B5EF4-FFF2-40B4-BE49-F238E27FC236}">
                  <a16:creationId xmlns:a16="http://schemas.microsoft.com/office/drawing/2014/main" id="{9D6CB18E-47BD-6444-99AC-927083B21D6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255295" y="3563857"/>
              <a:ext cx="0" cy="62548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2" name="Line 10">
              <a:extLst>
                <a:ext uri="{FF2B5EF4-FFF2-40B4-BE49-F238E27FC236}">
                  <a16:creationId xmlns:a16="http://schemas.microsoft.com/office/drawing/2014/main" id="{7146789A-41D0-334F-9B69-DF406BA7F25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973839" y="3563857"/>
              <a:ext cx="0" cy="62548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3" name="Line 11">
              <a:extLst>
                <a:ext uri="{FF2B5EF4-FFF2-40B4-BE49-F238E27FC236}">
                  <a16:creationId xmlns:a16="http://schemas.microsoft.com/office/drawing/2014/main" id="{F93CAB1E-C8C0-344C-8AFA-B68CE442AE4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685407" y="3563857"/>
              <a:ext cx="0" cy="62548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4" name="Line 12">
              <a:extLst>
                <a:ext uri="{FF2B5EF4-FFF2-40B4-BE49-F238E27FC236}">
                  <a16:creationId xmlns:a16="http://schemas.microsoft.com/office/drawing/2014/main" id="{BAD7131F-F4C1-AF4D-A836-7B56B344181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396975" y="3563857"/>
              <a:ext cx="0" cy="62548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5" name="Rectangle 13">
              <a:extLst>
                <a:ext uri="{FF2B5EF4-FFF2-40B4-BE49-F238E27FC236}">
                  <a16:creationId xmlns:a16="http://schemas.microsoft.com/office/drawing/2014/main" id="{939E0AFF-7966-3042-95D2-9DFC13574F7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76349" y="3701464"/>
              <a:ext cx="71950" cy="1944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6" name="Rectangle 14">
              <a:extLst>
                <a:ext uri="{FF2B5EF4-FFF2-40B4-BE49-F238E27FC236}">
                  <a16:creationId xmlns:a16="http://schemas.microsoft.com/office/drawing/2014/main" id="{BDB8461F-474D-D44B-B3C0-DBB0C47EDF3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87917" y="3701464"/>
              <a:ext cx="71950" cy="1944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7" name="Rectangle 15">
              <a:extLst>
                <a:ext uri="{FF2B5EF4-FFF2-40B4-BE49-F238E27FC236}">
                  <a16:creationId xmlns:a16="http://schemas.microsoft.com/office/drawing/2014/main" id="{FBCE348C-E522-C74D-AAB8-AC442A3353C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68093" y="3701464"/>
              <a:ext cx="143901" cy="1944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8" name="Rectangle 16">
              <a:extLst>
                <a:ext uri="{FF2B5EF4-FFF2-40B4-BE49-F238E27FC236}">
                  <a16:creationId xmlns:a16="http://schemas.microsoft.com/office/drawing/2014/main" id="{30276AF5-CEC1-1A4C-A412-61D59491669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86636" y="3701464"/>
              <a:ext cx="143901" cy="1944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9" name="Rectangle 17">
              <a:extLst>
                <a:ext uri="{FF2B5EF4-FFF2-40B4-BE49-F238E27FC236}">
                  <a16:creationId xmlns:a16="http://schemas.microsoft.com/office/drawing/2014/main" id="{46582A44-8864-3E4A-A251-7ADC015977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98205" y="3701464"/>
              <a:ext cx="143901" cy="1944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0" name="Rectangle 18">
              <a:extLst>
                <a:ext uri="{FF2B5EF4-FFF2-40B4-BE49-F238E27FC236}">
                  <a16:creationId xmlns:a16="http://schemas.microsoft.com/office/drawing/2014/main" id="{B7C264B3-4112-2449-BBC5-7D0E87E902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09773" y="3701464"/>
              <a:ext cx="143901" cy="1944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1" name="Line 19">
              <a:extLst>
                <a:ext uri="{FF2B5EF4-FFF2-40B4-BE49-F238E27FC236}">
                  <a16:creationId xmlns:a16="http://schemas.microsoft.com/office/drawing/2014/main" id="{61EE6EEB-E54E-CE4D-834C-965EF53DE58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32158" y="980606"/>
              <a:ext cx="0" cy="248317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2" name="Line 20">
              <a:extLst>
                <a:ext uri="{FF2B5EF4-FFF2-40B4-BE49-F238E27FC236}">
                  <a16:creationId xmlns:a16="http://schemas.microsoft.com/office/drawing/2014/main" id="{8E9F23AA-E462-B44A-9C6D-7615AD8AE42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762397" y="3463780"/>
              <a:ext cx="69762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3" name="Line 21">
              <a:extLst>
                <a:ext uri="{FF2B5EF4-FFF2-40B4-BE49-F238E27FC236}">
                  <a16:creationId xmlns:a16="http://schemas.microsoft.com/office/drawing/2014/main" id="{53176F4D-812F-0148-98AE-7AA63F9ABE2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762397" y="2969647"/>
              <a:ext cx="69762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4" name="Line 22">
              <a:extLst>
                <a:ext uri="{FF2B5EF4-FFF2-40B4-BE49-F238E27FC236}">
                  <a16:creationId xmlns:a16="http://schemas.microsoft.com/office/drawing/2014/main" id="{36E2106B-4A31-D849-83EA-7C78F5E907E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762397" y="2475514"/>
              <a:ext cx="69762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5" name="Line 23">
              <a:extLst>
                <a:ext uri="{FF2B5EF4-FFF2-40B4-BE49-F238E27FC236}">
                  <a16:creationId xmlns:a16="http://schemas.microsoft.com/office/drawing/2014/main" id="{ADE7E135-6307-B64C-983F-55628FC3C2D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762397" y="1975126"/>
              <a:ext cx="69762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6" name="Line 24">
              <a:extLst>
                <a:ext uri="{FF2B5EF4-FFF2-40B4-BE49-F238E27FC236}">
                  <a16:creationId xmlns:a16="http://schemas.microsoft.com/office/drawing/2014/main" id="{BDF5CAB9-F5E5-3745-ACD0-AE678BB214D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762397" y="1480993"/>
              <a:ext cx="69762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7" name="Line 25">
              <a:extLst>
                <a:ext uri="{FF2B5EF4-FFF2-40B4-BE49-F238E27FC236}">
                  <a16:creationId xmlns:a16="http://schemas.microsoft.com/office/drawing/2014/main" id="{6CA473B3-FF55-3740-B197-15CBAD8B3DD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762397" y="980606"/>
              <a:ext cx="69762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8" name="Rectangle 26">
              <a:extLst>
                <a:ext uri="{FF2B5EF4-FFF2-40B4-BE49-F238E27FC236}">
                  <a16:creationId xmlns:a16="http://schemas.microsoft.com/office/drawing/2014/main" id="{F0D9E57F-C2C2-0C45-A17F-2684D2D7A7B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90327" y="3426251"/>
              <a:ext cx="179876" cy="1944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9" name="Rectangle 27">
              <a:extLst>
                <a:ext uri="{FF2B5EF4-FFF2-40B4-BE49-F238E27FC236}">
                  <a16:creationId xmlns:a16="http://schemas.microsoft.com/office/drawing/2014/main" id="{E6E05F7E-65E8-A14E-8DF2-3FC0C641E03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90327" y="2932118"/>
              <a:ext cx="179876" cy="1944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0" name="Rectangle 28">
              <a:extLst>
                <a:ext uri="{FF2B5EF4-FFF2-40B4-BE49-F238E27FC236}">
                  <a16:creationId xmlns:a16="http://schemas.microsoft.com/office/drawing/2014/main" id="{98A0FC2D-E031-0E4C-AA97-34CB69A9E0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90327" y="2431730"/>
              <a:ext cx="179876" cy="1944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1" name="Rectangle 29">
              <a:extLst>
                <a:ext uri="{FF2B5EF4-FFF2-40B4-BE49-F238E27FC236}">
                  <a16:creationId xmlns:a16="http://schemas.microsoft.com/office/drawing/2014/main" id="{3125F494-891C-DD43-A0C6-3A5A0E13A42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90327" y="1937597"/>
              <a:ext cx="179876" cy="1944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6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2" name="Rectangle 30">
              <a:extLst>
                <a:ext uri="{FF2B5EF4-FFF2-40B4-BE49-F238E27FC236}">
                  <a16:creationId xmlns:a16="http://schemas.microsoft.com/office/drawing/2014/main" id="{F3B49731-BADF-7549-A8E1-A9D31130E4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90327" y="1437209"/>
              <a:ext cx="179876" cy="1944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8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3" name="Rectangle 31">
              <a:extLst>
                <a:ext uri="{FF2B5EF4-FFF2-40B4-BE49-F238E27FC236}">
                  <a16:creationId xmlns:a16="http://schemas.microsoft.com/office/drawing/2014/main" id="{D42525E2-3BD3-3D40-A095-3DA1C8C949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90327" y="943076"/>
              <a:ext cx="179876" cy="1944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0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4" name="Freeform 32">
              <a:extLst>
                <a:ext uri="{FF2B5EF4-FFF2-40B4-BE49-F238E27FC236}">
                  <a16:creationId xmlns:a16="http://schemas.microsoft.com/office/drawing/2014/main" id="{F073F1F0-D2D5-3C42-B06B-5D347E1A73F7}"/>
                </a:ext>
              </a:extLst>
            </p:cNvPr>
            <p:cNvSpPr>
              <a:spLocks/>
            </p:cNvSpPr>
            <p:nvPr/>
          </p:nvSpPr>
          <p:spPr bwMode="auto">
            <a:xfrm>
              <a:off x="2832158" y="880528"/>
              <a:ext cx="3592721" cy="2683329"/>
            </a:xfrm>
            <a:custGeom>
              <a:avLst/>
              <a:gdLst>
                <a:gd name="T0" fmla="*/ 0 w 515"/>
                <a:gd name="T1" fmla="*/ 0 h 429"/>
                <a:gd name="T2" fmla="*/ 0 w 515"/>
                <a:gd name="T3" fmla="*/ 429 h 429"/>
                <a:gd name="T4" fmla="*/ 515 w 515"/>
                <a:gd name="T5" fmla="*/ 429 h 4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5" h="429">
                  <a:moveTo>
                    <a:pt x="0" y="0"/>
                  </a:moveTo>
                  <a:lnTo>
                    <a:pt x="0" y="429"/>
                  </a:lnTo>
                  <a:lnTo>
                    <a:pt x="515" y="429"/>
                  </a:lnTo>
                </a:path>
              </a:pathLst>
            </a:cu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5" name="Freeform 35">
              <a:extLst>
                <a:ext uri="{FF2B5EF4-FFF2-40B4-BE49-F238E27FC236}">
                  <a16:creationId xmlns:a16="http://schemas.microsoft.com/office/drawing/2014/main" id="{09F09957-815D-8747-AB92-3F23AA1B5629}"/>
                </a:ext>
              </a:extLst>
            </p:cNvPr>
            <p:cNvSpPr>
              <a:spLocks/>
            </p:cNvSpPr>
            <p:nvPr/>
          </p:nvSpPr>
          <p:spPr bwMode="auto">
            <a:xfrm>
              <a:off x="2832158" y="980606"/>
              <a:ext cx="2134704" cy="2483174"/>
            </a:xfrm>
            <a:custGeom>
              <a:avLst/>
              <a:gdLst>
                <a:gd name="T0" fmla="*/ 0 w 306"/>
                <a:gd name="T1" fmla="*/ 0 h 397"/>
                <a:gd name="T2" fmla="*/ 17 w 306"/>
                <a:gd name="T3" fmla="*/ 0 h 397"/>
                <a:gd name="T4" fmla="*/ 17 w 306"/>
                <a:gd name="T5" fmla="*/ 80 h 397"/>
                <a:gd name="T6" fmla="*/ 22 w 306"/>
                <a:gd name="T7" fmla="*/ 80 h 397"/>
                <a:gd name="T8" fmla="*/ 22 w 306"/>
                <a:gd name="T9" fmla="*/ 106 h 397"/>
                <a:gd name="T10" fmla="*/ 28 w 306"/>
                <a:gd name="T11" fmla="*/ 106 h 397"/>
                <a:gd name="T12" fmla="*/ 28 w 306"/>
                <a:gd name="T13" fmla="*/ 135 h 397"/>
                <a:gd name="T14" fmla="*/ 85 w 306"/>
                <a:gd name="T15" fmla="*/ 135 h 397"/>
                <a:gd name="T16" fmla="*/ 85 w 306"/>
                <a:gd name="T17" fmla="*/ 164 h 397"/>
                <a:gd name="T18" fmla="*/ 86 w 306"/>
                <a:gd name="T19" fmla="*/ 164 h 397"/>
                <a:gd name="T20" fmla="*/ 86 w 306"/>
                <a:gd name="T21" fmla="*/ 194 h 397"/>
                <a:gd name="T22" fmla="*/ 175 w 306"/>
                <a:gd name="T23" fmla="*/ 194 h 397"/>
                <a:gd name="T24" fmla="*/ 175 w 306"/>
                <a:gd name="T25" fmla="*/ 244 h 397"/>
                <a:gd name="T26" fmla="*/ 188 w 306"/>
                <a:gd name="T27" fmla="*/ 244 h 397"/>
                <a:gd name="T28" fmla="*/ 188 w 306"/>
                <a:gd name="T29" fmla="*/ 295 h 397"/>
                <a:gd name="T30" fmla="*/ 306 w 306"/>
                <a:gd name="T31" fmla="*/ 295 h 397"/>
                <a:gd name="T32" fmla="*/ 306 w 306"/>
                <a:gd name="T33" fmla="*/ 397 h 39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306" h="397">
                  <a:moveTo>
                    <a:pt x="0" y="0"/>
                  </a:moveTo>
                  <a:lnTo>
                    <a:pt x="17" y="0"/>
                  </a:lnTo>
                  <a:lnTo>
                    <a:pt x="17" y="80"/>
                  </a:lnTo>
                  <a:lnTo>
                    <a:pt x="22" y="80"/>
                  </a:lnTo>
                  <a:lnTo>
                    <a:pt x="22" y="106"/>
                  </a:lnTo>
                  <a:lnTo>
                    <a:pt x="28" y="106"/>
                  </a:lnTo>
                  <a:lnTo>
                    <a:pt x="28" y="135"/>
                  </a:lnTo>
                  <a:lnTo>
                    <a:pt x="85" y="135"/>
                  </a:lnTo>
                  <a:lnTo>
                    <a:pt x="85" y="164"/>
                  </a:lnTo>
                  <a:lnTo>
                    <a:pt x="86" y="164"/>
                  </a:lnTo>
                  <a:lnTo>
                    <a:pt x="86" y="194"/>
                  </a:lnTo>
                  <a:lnTo>
                    <a:pt x="175" y="194"/>
                  </a:lnTo>
                  <a:lnTo>
                    <a:pt x="175" y="244"/>
                  </a:lnTo>
                  <a:lnTo>
                    <a:pt x="188" y="244"/>
                  </a:lnTo>
                  <a:lnTo>
                    <a:pt x="188" y="295"/>
                  </a:lnTo>
                  <a:lnTo>
                    <a:pt x="306" y="295"/>
                  </a:lnTo>
                  <a:lnTo>
                    <a:pt x="306" y="397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6" name="Line 36">
              <a:extLst>
                <a:ext uri="{FF2B5EF4-FFF2-40B4-BE49-F238E27FC236}">
                  <a16:creationId xmlns:a16="http://schemas.microsoft.com/office/drawing/2014/main" id="{57D2F458-84D4-024E-81D0-367D73B367A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64705" y="1643619"/>
              <a:ext cx="69762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7" name="Line 37">
              <a:extLst>
                <a:ext uri="{FF2B5EF4-FFF2-40B4-BE49-F238E27FC236}">
                  <a16:creationId xmlns:a16="http://schemas.microsoft.com/office/drawing/2014/main" id="{FE1F9AB4-D27A-3846-B649-27A510D446B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99586" y="1612345"/>
              <a:ext cx="0" cy="62548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8" name="Line 38">
              <a:extLst>
                <a:ext uri="{FF2B5EF4-FFF2-40B4-BE49-F238E27FC236}">
                  <a16:creationId xmlns:a16="http://schemas.microsoft.com/office/drawing/2014/main" id="{17740854-7288-AB4E-9CCC-D42A89CE309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92560" y="2194046"/>
              <a:ext cx="69762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9" name="Line 39">
              <a:extLst>
                <a:ext uri="{FF2B5EF4-FFF2-40B4-BE49-F238E27FC236}">
                  <a16:creationId xmlns:a16="http://schemas.microsoft.com/office/drawing/2014/main" id="{845A70DC-4826-3640-980D-9E6A9D30834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27440" y="2156517"/>
              <a:ext cx="0" cy="68803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0" name="Line 40">
              <a:extLst>
                <a:ext uri="{FF2B5EF4-FFF2-40B4-BE49-F238E27FC236}">
                  <a16:creationId xmlns:a16="http://schemas.microsoft.com/office/drawing/2014/main" id="{18457865-7DF9-4240-8D61-9D1F8DAB698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22773" y="2194046"/>
              <a:ext cx="69762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1" name="Line 41">
              <a:extLst>
                <a:ext uri="{FF2B5EF4-FFF2-40B4-BE49-F238E27FC236}">
                  <a16:creationId xmlns:a16="http://schemas.microsoft.com/office/drawing/2014/main" id="{F0C33FB4-F4F2-B74E-A16E-8C9373CF6ED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857654" y="2156517"/>
              <a:ext cx="0" cy="68803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2" name="Line 42">
              <a:extLst>
                <a:ext uri="{FF2B5EF4-FFF2-40B4-BE49-F238E27FC236}">
                  <a16:creationId xmlns:a16="http://schemas.microsoft.com/office/drawing/2014/main" id="{D82CD0B1-9F92-6343-B6D1-D531BC49CC8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29749" y="2194046"/>
              <a:ext cx="69762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3" name="Line 43">
              <a:extLst>
                <a:ext uri="{FF2B5EF4-FFF2-40B4-BE49-F238E27FC236}">
                  <a16:creationId xmlns:a16="http://schemas.microsoft.com/office/drawing/2014/main" id="{380E6AEF-974D-F146-BF47-54B0525DC2B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864630" y="2156517"/>
              <a:ext cx="0" cy="68803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4" name="Line 44">
              <a:extLst>
                <a:ext uri="{FF2B5EF4-FFF2-40B4-BE49-F238E27FC236}">
                  <a16:creationId xmlns:a16="http://schemas.microsoft.com/office/drawing/2014/main" id="{9DD8CC7E-F8A0-494B-8F30-55E6CD2CA07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76198" y="2825785"/>
              <a:ext cx="69762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5" name="Line 45">
              <a:extLst>
                <a:ext uri="{FF2B5EF4-FFF2-40B4-BE49-F238E27FC236}">
                  <a16:creationId xmlns:a16="http://schemas.microsoft.com/office/drawing/2014/main" id="{6C309694-101C-A84E-AD0D-7AA0E74DB64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611079" y="2794511"/>
              <a:ext cx="0" cy="68803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6" name="Freeform 46">
              <a:extLst>
                <a:ext uri="{FF2B5EF4-FFF2-40B4-BE49-F238E27FC236}">
                  <a16:creationId xmlns:a16="http://schemas.microsoft.com/office/drawing/2014/main" id="{79E66C74-4B43-F649-AA64-008727EC733A}"/>
                </a:ext>
              </a:extLst>
            </p:cNvPr>
            <p:cNvSpPr>
              <a:spLocks/>
            </p:cNvSpPr>
            <p:nvPr/>
          </p:nvSpPr>
          <p:spPr bwMode="auto">
            <a:xfrm>
              <a:off x="2832158" y="980606"/>
              <a:ext cx="2643964" cy="2483174"/>
            </a:xfrm>
            <a:custGeom>
              <a:avLst/>
              <a:gdLst>
                <a:gd name="T0" fmla="*/ 0 w 379"/>
                <a:gd name="T1" fmla="*/ 0 h 397"/>
                <a:gd name="T2" fmla="*/ 25 w 379"/>
                <a:gd name="T3" fmla="*/ 0 h 397"/>
                <a:gd name="T4" fmla="*/ 25 w 379"/>
                <a:gd name="T5" fmla="*/ 133 h 397"/>
                <a:gd name="T6" fmla="*/ 320 w 379"/>
                <a:gd name="T7" fmla="*/ 133 h 397"/>
                <a:gd name="T8" fmla="*/ 320 w 379"/>
                <a:gd name="T9" fmla="*/ 265 h 397"/>
                <a:gd name="T10" fmla="*/ 379 w 379"/>
                <a:gd name="T11" fmla="*/ 265 h 397"/>
                <a:gd name="T12" fmla="*/ 379 w 379"/>
                <a:gd name="T13" fmla="*/ 397 h 39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379" h="397">
                  <a:moveTo>
                    <a:pt x="0" y="0"/>
                  </a:moveTo>
                  <a:lnTo>
                    <a:pt x="25" y="0"/>
                  </a:lnTo>
                  <a:lnTo>
                    <a:pt x="25" y="133"/>
                  </a:lnTo>
                  <a:lnTo>
                    <a:pt x="320" y="133"/>
                  </a:lnTo>
                  <a:lnTo>
                    <a:pt x="320" y="265"/>
                  </a:lnTo>
                  <a:lnTo>
                    <a:pt x="379" y="265"/>
                  </a:lnTo>
                  <a:lnTo>
                    <a:pt x="379" y="397"/>
                  </a:lnTo>
                </a:path>
              </a:pathLst>
            </a:cu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7" name="Line 47">
              <a:extLst>
                <a:ext uri="{FF2B5EF4-FFF2-40B4-BE49-F238E27FC236}">
                  <a16:creationId xmlns:a16="http://schemas.microsoft.com/office/drawing/2014/main" id="{88DBD7BB-674D-7346-B175-62DDB2544D5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97202" y="1812500"/>
              <a:ext cx="69762" cy="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8" name="Line 48">
              <a:extLst>
                <a:ext uri="{FF2B5EF4-FFF2-40B4-BE49-F238E27FC236}">
                  <a16:creationId xmlns:a16="http://schemas.microsoft.com/office/drawing/2014/main" id="{AD36CCA9-801C-FE45-80DC-44625703DF2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32083" y="1774971"/>
              <a:ext cx="0" cy="68803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9" name="Line 49">
              <a:extLst>
                <a:ext uri="{FF2B5EF4-FFF2-40B4-BE49-F238E27FC236}">
                  <a16:creationId xmlns:a16="http://schemas.microsoft.com/office/drawing/2014/main" id="{39C998EF-8F53-D140-9478-28454B752A3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15771" y="1812500"/>
              <a:ext cx="69762" cy="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0" name="Line 50">
              <a:extLst>
                <a:ext uri="{FF2B5EF4-FFF2-40B4-BE49-F238E27FC236}">
                  <a16:creationId xmlns:a16="http://schemas.microsoft.com/office/drawing/2014/main" id="{C11A822D-AA80-1A46-AF4B-CBCC6F424D8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50652" y="1774971"/>
              <a:ext cx="0" cy="68803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1" name="Freeform 51">
              <a:extLst>
                <a:ext uri="{FF2B5EF4-FFF2-40B4-BE49-F238E27FC236}">
                  <a16:creationId xmlns:a16="http://schemas.microsoft.com/office/drawing/2014/main" id="{CFE8D10B-0C0B-954F-910E-0BC88503A434}"/>
                </a:ext>
              </a:extLst>
            </p:cNvPr>
            <p:cNvSpPr>
              <a:spLocks/>
            </p:cNvSpPr>
            <p:nvPr/>
          </p:nvSpPr>
          <p:spPr bwMode="auto">
            <a:xfrm>
              <a:off x="2832158" y="980606"/>
              <a:ext cx="3453198" cy="831895"/>
            </a:xfrm>
            <a:custGeom>
              <a:avLst/>
              <a:gdLst>
                <a:gd name="T0" fmla="*/ 0 w 495"/>
                <a:gd name="T1" fmla="*/ 0 h 133"/>
                <a:gd name="T2" fmla="*/ 76 w 495"/>
                <a:gd name="T3" fmla="*/ 0 h 133"/>
                <a:gd name="T4" fmla="*/ 76 w 495"/>
                <a:gd name="T5" fmla="*/ 66 h 133"/>
                <a:gd name="T6" fmla="*/ 107 w 495"/>
                <a:gd name="T7" fmla="*/ 66 h 133"/>
                <a:gd name="T8" fmla="*/ 107 w 495"/>
                <a:gd name="T9" fmla="*/ 133 h 133"/>
                <a:gd name="T10" fmla="*/ 495 w 495"/>
                <a:gd name="T11" fmla="*/ 133 h 133"/>
                <a:gd name="T12" fmla="*/ 495 w 495"/>
                <a:gd name="T13" fmla="*/ 133 h 1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495" h="133">
                  <a:moveTo>
                    <a:pt x="0" y="0"/>
                  </a:moveTo>
                  <a:lnTo>
                    <a:pt x="76" y="0"/>
                  </a:lnTo>
                  <a:lnTo>
                    <a:pt x="76" y="66"/>
                  </a:lnTo>
                  <a:lnTo>
                    <a:pt x="107" y="66"/>
                  </a:lnTo>
                  <a:lnTo>
                    <a:pt x="107" y="133"/>
                  </a:lnTo>
                  <a:lnTo>
                    <a:pt x="495" y="133"/>
                  </a:lnTo>
                  <a:lnTo>
                    <a:pt x="495" y="133"/>
                  </a:lnTo>
                </a:path>
              </a:pathLst>
            </a:cu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2" name="Line 52">
              <a:extLst>
                <a:ext uri="{FF2B5EF4-FFF2-40B4-BE49-F238E27FC236}">
                  <a16:creationId xmlns:a16="http://schemas.microsoft.com/office/drawing/2014/main" id="{267695B0-B993-984D-910D-4346C799371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52986" y="1812500"/>
              <a:ext cx="69762" cy="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3" name="Line 53">
              <a:extLst>
                <a:ext uri="{FF2B5EF4-FFF2-40B4-BE49-F238E27FC236}">
                  <a16:creationId xmlns:a16="http://schemas.microsoft.com/office/drawing/2014/main" id="{22095A5D-739A-7446-8EEC-87CACD95D39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087867" y="1774971"/>
              <a:ext cx="0" cy="68803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4" name="Line 54">
              <a:extLst>
                <a:ext uri="{FF2B5EF4-FFF2-40B4-BE49-F238E27FC236}">
                  <a16:creationId xmlns:a16="http://schemas.microsoft.com/office/drawing/2014/main" id="{677734F3-093B-3D4F-AE68-5C87D74E218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708745" y="1812500"/>
              <a:ext cx="69762" cy="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5" name="Line 55">
              <a:extLst>
                <a:ext uri="{FF2B5EF4-FFF2-40B4-BE49-F238E27FC236}">
                  <a16:creationId xmlns:a16="http://schemas.microsoft.com/office/drawing/2014/main" id="{FA8ACD6A-B7C2-BE49-AA36-8B620C6DEFC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743626" y="1774971"/>
              <a:ext cx="0" cy="68803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6" name="Line 56">
              <a:extLst>
                <a:ext uri="{FF2B5EF4-FFF2-40B4-BE49-F238E27FC236}">
                  <a16:creationId xmlns:a16="http://schemas.microsoft.com/office/drawing/2014/main" id="{748550B3-2B73-FC4C-8366-FC8CDCE3AF7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748192" y="1812500"/>
              <a:ext cx="69762" cy="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7" name="Line 57">
              <a:extLst>
                <a:ext uri="{FF2B5EF4-FFF2-40B4-BE49-F238E27FC236}">
                  <a16:creationId xmlns:a16="http://schemas.microsoft.com/office/drawing/2014/main" id="{25CE5ADF-0035-424A-806A-1986D848F12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783073" y="1774971"/>
              <a:ext cx="0" cy="68803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8" name="Line 58">
              <a:extLst>
                <a:ext uri="{FF2B5EF4-FFF2-40B4-BE49-F238E27FC236}">
                  <a16:creationId xmlns:a16="http://schemas.microsoft.com/office/drawing/2014/main" id="{47E579A3-B063-F14D-8A3D-C47970C00D6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250476" y="1812500"/>
              <a:ext cx="69762" cy="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9" name="Line 59">
              <a:extLst>
                <a:ext uri="{FF2B5EF4-FFF2-40B4-BE49-F238E27FC236}">
                  <a16:creationId xmlns:a16="http://schemas.microsoft.com/office/drawing/2014/main" id="{5FC105E4-1CEA-ED4C-8FCA-150B01789BD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285357" y="1774971"/>
              <a:ext cx="0" cy="68803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0" name="Rectangle 86">
              <a:extLst>
                <a:ext uri="{FF2B5EF4-FFF2-40B4-BE49-F238E27FC236}">
                  <a16:creationId xmlns:a16="http://schemas.microsoft.com/office/drawing/2014/main" id="{28107DE0-90F4-6D40-8433-F2F21BE78C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13261" y="1080682"/>
              <a:ext cx="73" cy="1944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1" name="Rectangle 88">
              <a:extLst>
                <a:ext uri="{FF2B5EF4-FFF2-40B4-BE49-F238E27FC236}">
                  <a16:creationId xmlns:a16="http://schemas.microsoft.com/office/drawing/2014/main" id="{4F14AF88-24C2-1E48-BE30-B607F19B5D3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13261" y="1324622"/>
              <a:ext cx="73" cy="1944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532" name="グループ化 531">
            <a:extLst>
              <a:ext uri="{FF2B5EF4-FFF2-40B4-BE49-F238E27FC236}">
                <a16:creationId xmlns:a16="http://schemas.microsoft.com/office/drawing/2014/main" id="{54FD8C1D-5D51-5F4F-960B-0211634E0A13}"/>
              </a:ext>
            </a:extLst>
          </p:cNvPr>
          <p:cNvGrpSpPr/>
          <p:nvPr/>
        </p:nvGrpSpPr>
        <p:grpSpPr>
          <a:xfrm>
            <a:off x="971474" y="5019509"/>
            <a:ext cx="3317786" cy="502421"/>
            <a:chOff x="2751931" y="5118305"/>
            <a:chExt cx="3672948" cy="342629"/>
          </a:xfrm>
        </p:grpSpPr>
        <p:sp>
          <p:nvSpPr>
            <p:cNvPr id="533" name="Rectangle 60">
              <a:extLst>
                <a:ext uri="{FF2B5EF4-FFF2-40B4-BE49-F238E27FC236}">
                  <a16:creationId xmlns:a16="http://schemas.microsoft.com/office/drawing/2014/main" id="{3AEAA089-8E50-1C45-801C-E7B3AD126D8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51931" y="5118305"/>
              <a:ext cx="153474" cy="1049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kumimoji="1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4" name="Rectangle 61">
              <a:extLst>
                <a:ext uri="{FF2B5EF4-FFF2-40B4-BE49-F238E27FC236}">
                  <a16:creationId xmlns:a16="http://schemas.microsoft.com/office/drawing/2014/main" id="{3EEDA83D-3177-6141-9299-E27966BF753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94892" y="5118305"/>
              <a:ext cx="76738" cy="1049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kumimoji="1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5" name="Rectangle 62">
              <a:extLst>
                <a:ext uri="{FF2B5EF4-FFF2-40B4-BE49-F238E27FC236}">
                  <a16:creationId xmlns:a16="http://schemas.microsoft.com/office/drawing/2014/main" id="{60795358-DEAC-454B-84C9-CCCD394810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06460" y="5118305"/>
              <a:ext cx="76738" cy="1049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kumimoji="1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6" name="Rectangle 63">
              <a:extLst>
                <a:ext uri="{FF2B5EF4-FFF2-40B4-BE49-F238E27FC236}">
                  <a16:creationId xmlns:a16="http://schemas.microsoft.com/office/drawing/2014/main" id="{ED3774CB-F233-FF4A-8C39-75B92F757F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25005" y="5118305"/>
              <a:ext cx="76738" cy="1049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7" name="Rectangle 64">
              <a:extLst>
                <a:ext uri="{FF2B5EF4-FFF2-40B4-BE49-F238E27FC236}">
                  <a16:creationId xmlns:a16="http://schemas.microsoft.com/office/drawing/2014/main" id="{EB8BD14D-6D40-3740-868E-FA29A7F346D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36573" y="5118305"/>
              <a:ext cx="76738" cy="1049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8" name="Rectangle 65">
              <a:extLst>
                <a:ext uri="{FF2B5EF4-FFF2-40B4-BE49-F238E27FC236}">
                  <a16:creationId xmlns:a16="http://schemas.microsoft.com/office/drawing/2014/main" id="{93C804BA-E41E-474D-B15F-048A4CF74B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48141" y="5118305"/>
              <a:ext cx="76738" cy="1049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9" name="Rectangle 66">
              <a:extLst>
                <a:ext uri="{FF2B5EF4-FFF2-40B4-BE49-F238E27FC236}">
                  <a16:creationId xmlns:a16="http://schemas.microsoft.com/office/drawing/2014/main" id="{10028FE9-8F53-4047-A966-F868C1AF053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83324" y="5237147"/>
              <a:ext cx="76738" cy="1049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endParaRPr kumimoji="1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0" name="Rectangle 67">
              <a:extLst>
                <a:ext uri="{FF2B5EF4-FFF2-40B4-BE49-F238E27FC236}">
                  <a16:creationId xmlns:a16="http://schemas.microsoft.com/office/drawing/2014/main" id="{D3943C3B-9247-114D-971A-7764677894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94892" y="5237147"/>
              <a:ext cx="76738" cy="1049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kumimoji="1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1" name="Rectangle 68">
              <a:extLst>
                <a:ext uri="{FF2B5EF4-FFF2-40B4-BE49-F238E27FC236}">
                  <a16:creationId xmlns:a16="http://schemas.microsoft.com/office/drawing/2014/main" id="{5FBD7377-D9A6-454D-AB1C-4176D958BF2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06460" y="5237147"/>
              <a:ext cx="76738" cy="1049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kumimoji="1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2" name="Rectangle 69">
              <a:extLst>
                <a:ext uri="{FF2B5EF4-FFF2-40B4-BE49-F238E27FC236}">
                  <a16:creationId xmlns:a16="http://schemas.microsoft.com/office/drawing/2014/main" id="{F84DFBB0-D9E6-4740-ABEE-A82007EF78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25005" y="5237147"/>
              <a:ext cx="76738" cy="1049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kumimoji="1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3" name="Rectangle 70">
              <a:extLst>
                <a:ext uri="{FF2B5EF4-FFF2-40B4-BE49-F238E27FC236}">
                  <a16:creationId xmlns:a16="http://schemas.microsoft.com/office/drawing/2014/main" id="{A53C5815-E636-3D4D-AE0D-B5DC8EDF051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36573" y="5237147"/>
              <a:ext cx="76738" cy="1049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4" name="Rectangle 71">
              <a:extLst>
                <a:ext uri="{FF2B5EF4-FFF2-40B4-BE49-F238E27FC236}">
                  <a16:creationId xmlns:a16="http://schemas.microsoft.com/office/drawing/2014/main" id="{D5035E74-50FC-0E42-A79B-5C62BCCB4F7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48141" y="5237147"/>
              <a:ext cx="76738" cy="1049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5" name="Rectangle 72">
              <a:extLst>
                <a:ext uri="{FF2B5EF4-FFF2-40B4-BE49-F238E27FC236}">
                  <a16:creationId xmlns:a16="http://schemas.microsoft.com/office/drawing/2014/main" id="{56C65D54-EAA7-3E4B-8AE1-062FAADB77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83324" y="5355989"/>
              <a:ext cx="76738" cy="1049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endParaRPr kumimoji="1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6" name="Rectangle 73">
              <a:extLst>
                <a:ext uri="{FF2B5EF4-FFF2-40B4-BE49-F238E27FC236}">
                  <a16:creationId xmlns:a16="http://schemas.microsoft.com/office/drawing/2014/main" id="{8C256B97-F8BD-9B4A-8BE5-A0372C3B5A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94892" y="5355989"/>
              <a:ext cx="76738" cy="1049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kumimoji="1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7" name="Rectangle 74">
              <a:extLst>
                <a:ext uri="{FF2B5EF4-FFF2-40B4-BE49-F238E27FC236}">
                  <a16:creationId xmlns:a16="http://schemas.microsoft.com/office/drawing/2014/main" id="{A8114459-8601-C443-AF76-E136C2751FB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06460" y="5355989"/>
              <a:ext cx="76738" cy="1049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endParaRPr kumimoji="1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8" name="Rectangle 75">
              <a:extLst>
                <a:ext uri="{FF2B5EF4-FFF2-40B4-BE49-F238E27FC236}">
                  <a16:creationId xmlns:a16="http://schemas.microsoft.com/office/drawing/2014/main" id="{812E90BF-D60A-9F48-B7B7-33465AA536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25005" y="5355989"/>
              <a:ext cx="76738" cy="1049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kumimoji="1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9" name="Rectangle 76">
              <a:extLst>
                <a:ext uri="{FF2B5EF4-FFF2-40B4-BE49-F238E27FC236}">
                  <a16:creationId xmlns:a16="http://schemas.microsoft.com/office/drawing/2014/main" id="{14C65014-7085-5A49-8A94-94B1C3CB32D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36573" y="5355989"/>
              <a:ext cx="76738" cy="1049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kumimoji="1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0" name="Rectangle 77">
              <a:extLst>
                <a:ext uri="{FF2B5EF4-FFF2-40B4-BE49-F238E27FC236}">
                  <a16:creationId xmlns:a16="http://schemas.microsoft.com/office/drawing/2014/main" id="{84959E58-F38B-E34B-A159-053FDE7A13F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48141" y="5355989"/>
              <a:ext cx="76738" cy="1049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551" name="グループ化 550">
            <a:extLst>
              <a:ext uri="{FF2B5EF4-FFF2-40B4-BE49-F238E27FC236}">
                <a16:creationId xmlns:a16="http://schemas.microsoft.com/office/drawing/2014/main" id="{7E069347-E783-BD46-9A73-F53358A2E01C}"/>
              </a:ext>
            </a:extLst>
          </p:cNvPr>
          <p:cNvGrpSpPr/>
          <p:nvPr/>
        </p:nvGrpSpPr>
        <p:grpSpPr>
          <a:xfrm>
            <a:off x="5196960" y="2398908"/>
            <a:ext cx="3556390" cy="2353560"/>
            <a:chOff x="2001252" y="1834147"/>
            <a:chExt cx="3990975" cy="3344763"/>
          </a:xfrm>
        </p:grpSpPr>
        <p:sp>
          <p:nvSpPr>
            <p:cNvPr id="552" name="Line 6">
              <a:extLst>
                <a:ext uri="{FF2B5EF4-FFF2-40B4-BE49-F238E27FC236}">
                  <a16:creationId xmlns:a16="http://schemas.microsoft.com/office/drawing/2014/main" id="{AE01EC16-43CA-ED45-8C9D-ABC0CB174DC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47327" y="4869447"/>
              <a:ext cx="356711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3" name="Line 7">
              <a:extLst>
                <a:ext uri="{FF2B5EF4-FFF2-40B4-BE49-F238E27FC236}">
                  <a16:creationId xmlns:a16="http://schemas.microsoft.com/office/drawing/2014/main" id="{624CD7A0-93A8-C749-BF1D-963C555337D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47327" y="4869447"/>
              <a:ext cx="0" cy="6985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4" name="Line 8">
              <a:extLst>
                <a:ext uri="{FF2B5EF4-FFF2-40B4-BE49-F238E27FC236}">
                  <a16:creationId xmlns:a16="http://schemas.microsoft.com/office/drawing/2014/main" id="{7E63D0E3-C6A8-AD4E-BB14-BAFBD38DC84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55352" y="4869447"/>
              <a:ext cx="0" cy="6985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5" name="Line 9">
              <a:extLst>
                <a:ext uri="{FF2B5EF4-FFF2-40B4-BE49-F238E27FC236}">
                  <a16:creationId xmlns:a16="http://schemas.microsoft.com/office/drawing/2014/main" id="{D989DB11-246C-8642-A941-B9C7E39502C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69727" y="4869447"/>
              <a:ext cx="0" cy="6985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6" name="Line 10">
              <a:extLst>
                <a:ext uri="{FF2B5EF4-FFF2-40B4-BE49-F238E27FC236}">
                  <a16:creationId xmlns:a16="http://schemas.microsoft.com/office/drawing/2014/main" id="{9CB7A467-E247-1842-AF54-E2654B3D847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484102" y="4869447"/>
              <a:ext cx="0" cy="6985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7" name="Line 11">
              <a:extLst>
                <a:ext uri="{FF2B5EF4-FFF2-40B4-BE49-F238E27FC236}">
                  <a16:creationId xmlns:a16="http://schemas.microsoft.com/office/drawing/2014/main" id="{383E4802-94EA-9047-A90C-DF1EB3C1D19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00065" y="4869447"/>
              <a:ext cx="0" cy="6985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8" name="Line 12">
              <a:extLst>
                <a:ext uri="{FF2B5EF4-FFF2-40B4-BE49-F238E27FC236}">
                  <a16:creationId xmlns:a16="http://schemas.microsoft.com/office/drawing/2014/main" id="{811D2045-19D3-2A4F-839B-B95C9C25B9F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914440" y="4869447"/>
              <a:ext cx="0" cy="6985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9" name="Rectangle 13">
              <a:extLst>
                <a:ext uri="{FF2B5EF4-FFF2-40B4-BE49-F238E27FC236}">
                  <a16:creationId xmlns:a16="http://schemas.microsoft.com/office/drawing/2014/main" id="{D02DE0F7-2C01-9A4C-B270-BA97FDDAD8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91765" y="5025022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0" name="Rectangle 14">
              <a:extLst>
                <a:ext uri="{FF2B5EF4-FFF2-40B4-BE49-F238E27FC236}">
                  <a16:creationId xmlns:a16="http://schemas.microsoft.com/office/drawing/2014/main" id="{0341BC66-E4E1-FE49-8FEC-82051E86EC3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68040" y="5025022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1" name="Rectangle 15">
              <a:extLst>
                <a:ext uri="{FF2B5EF4-FFF2-40B4-BE49-F238E27FC236}">
                  <a16:creationId xmlns:a16="http://schemas.microsoft.com/office/drawing/2014/main" id="{C7174326-92D2-5046-835D-023D068AFE2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82415" y="5025022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2" name="Rectangle 16">
              <a:extLst>
                <a:ext uri="{FF2B5EF4-FFF2-40B4-BE49-F238E27FC236}">
                  <a16:creationId xmlns:a16="http://schemas.microsoft.com/office/drawing/2014/main" id="{3F59495D-91B6-D841-B3D2-35F4433AFF7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96790" y="5025022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0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3" name="Rectangle 17">
              <a:extLst>
                <a:ext uri="{FF2B5EF4-FFF2-40B4-BE49-F238E27FC236}">
                  <a16:creationId xmlns:a16="http://schemas.microsoft.com/office/drawing/2014/main" id="{748076BD-92F6-8D4B-857A-88DFC235204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12752" y="5025022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0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4" name="Rectangle 18">
              <a:extLst>
                <a:ext uri="{FF2B5EF4-FFF2-40B4-BE49-F238E27FC236}">
                  <a16:creationId xmlns:a16="http://schemas.microsoft.com/office/drawing/2014/main" id="{521702E3-FF73-B04D-9896-178EDF58DDB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27127" y="5025022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0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5" name="Line 19">
              <a:extLst>
                <a:ext uri="{FF2B5EF4-FFF2-40B4-BE49-F238E27FC236}">
                  <a16:creationId xmlns:a16="http://schemas.microsoft.com/office/drawing/2014/main" id="{D8CED926-9F43-D647-9562-1D396B867D2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47327" y="1946860"/>
              <a:ext cx="0" cy="280828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6" name="Line 20">
              <a:extLst>
                <a:ext uri="{FF2B5EF4-FFF2-40B4-BE49-F238E27FC236}">
                  <a16:creationId xmlns:a16="http://schemas.microsoft.com/office/drawing/2014/main" id="{B6CBA26E-263A-DC48-8C4A-BA558F58F14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277477" y="4755147"/>
              <a:ext cx="6985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7" name="Line 21">
              <a:extLst>
                <a:ext uri="{FF2B5EF4-FFF2-40B4-BE49-F238E27FC236}">
                  <a16:creationId xmlns:a16="http://schemas.microsoft.com/office/drawing/2014/main" id="{DA1DFB38-2376-6743-B57A-1F763E85F8E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277477" y="4196347"/>
              <a:ext cx="6985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8" name="Line 22">
              <a:extLst>
                <a:ext uri="{FF2B5EF4-FFF2-40B4-BE49-F238E27FC236}">
                  <a16:creationId xmlns:a16="http://schemas.microsoft.com/office/drawing/2014/main" id="{9CAB33B1-2BE1-B84F-BEC7-BF6E54614FE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277477" y="3637547"/>
              <a:ext cx="6985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9" name="Line 23">
              <a:extLst>
                <a:ext uri="{FF2B5EF4-FFF2-40B4-BE49-F238E27FC236}">
                  <a16:creationId xmlns:a16="http://schemas.microsoft.com/office/drawing/2014/main" id="{DE04858A-C0AC-484E-A06D-14BE0DA1C33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277477" y="3072397"/>
              <a:ext cx="6985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0" name="Line 24">
              <a:extLst>
                <a:ext uri="{FF2B5EF4-FFF2-40B4-BE49-F238E27FC236}">
                  <a16:creationId xmlns:a16="http://schemas.microsoft.com/office/drawing/2014/main" id="{D95B7B17-AFF9-7141-8103-CA9F11C2EAA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277477" y="2513597"/>
              <a:ext cx="6985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1" name="Line 25">
              <a:extLst>
                <a:ext uri="{FF2B5EF4-FFF2-40B4-BE49-F238E27FC236}">
                  <a16:creationId xmlns:a16="http://schemas.microsoft.com/office/drawing/2014/main" id="{6BC4286E-E732-7345-B45A-6C4CE135233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277477" y="1946860"/>
              <a:ext cx="6985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2" name="Rectangle 26">
              <a:extLst>
                <a:ext uri="{FF2B5EF4-FFF2-40B4-BE49-F238E27FC236}">
                  <a16:creationId xmlns:a16="http://schemas.microsoft.com/office/drawing/2014/main" id="{AF0040ED-21D4-194E-B38B-71BD928986E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01252" y="4713872"/>
              <a:ext cx="1603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3" name="Rectangle 27">
              <a:extLst>
                <a:ext uri="{FF2B5EF4-FFF2-40B4-BE49-F238E27FC236}">
                  <a16:creationId xmlns:a16="http://schemas.microsoft.com/office/drawing/2014/main" id="{AE193756-B79D-CA45-8296-8C0B4FCBF57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01252" y="4155072"/>
              <a:ext cx="1603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4" name="Rectangle 28">
              <a:extLst>
                <a:ext uri="{FF2B5EF4-FFF2-40B4-BE49-F238E27FC236}">
                  <a16:creationId xmlns:a16="http://schemas.microsoft.com/office/drawing/2014/main" id="{51D588B8-3B90-F546-A28B-383B102381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01252" y="3588335"/>
              <a:ext cx="1603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5" name="Rectangle 29">
              <a:extLst>
                <a:ext uri="{FF2B5EF4-FFF2-40B4-BE49-F238E27FC236}">
                  <a16:creationId xmlns:a16="http://schemas.microsoft.com/office/drawing/2014/main" id="{150A9A67-D3F9-0845-92DD-E1C3E14D139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01252" y="3029535"/>
              <a:ext cx="1603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6</a:t>
              </a:r>
              <a:endParaRPr kumimoji="1" lang="ja-JP" altLang="ja-JP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6" name="Rectangle 30">
              <a:extLst>
                <a:ext uri="{FF2B5EF4-FFF2-40B4-BE49-F238E27FC236}">
                  <a16:creationId xmlns:a16="http://schemas.microsoft.com/office/drawing/2014/main" id="{3426460D-5BA7-7A45-A4E4-F5A2FFF0A7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01252" y="2464385"/>
              <a:ext cx="1603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8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7" name="Rectangle 31">
              <a:extLst>
                <a:ext uri="{FF2B5EF4-FFF2-40B4-BE49-F238E27FC236}">
                  <a16:creationId xmlns:a16="http://schemas.microsoft.com/office/drawing/2014/main" id="{0129BB65-2F18-964F-A4FA-0E7C6F20931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01252" y="1905585"/>
              <a:ext cx="1603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0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8" name="Freeform 32">
              <a:extLst>
                <a:ext uri="{FF2B5EF4-FFF2-40B4-BE49-F238E27FC236}">
                  <a16:creationId xmlns:a16="http://schemas.microsoft.com/office/drawing/2014/main" id="{2789320A-29F6-2644-9BC4-2C90E944100E}"/>
                </a:ext>
              </a:extLst>
            </p:cNvPr>
            <p:cNvSpPr>
              <a:spLocks/>
            </p:cNvSpPr>
            <p:nvPr/>
          </p:nvSpPr>
          <p:spPr bwMode="auto">
            <a:xfrm>
              <a:off x="2347327" y="1834147"/>
              <a:ext cx="3644900" cy="3035300"/>
            </a:xfrm>
            <a:custGeom>
              <a:avLst/>
              <a:gdLst>
                <a:gd name="T0" fmla="*/ 0 w 515"/>
                <a:gd name="T1" fmla="*/ 0 h 429"/>
                <a:gd name="T2" fmla="*/ 0 w 515"/>
                <a:gd name="T3" fmla="*/ 429 h 429"/>
                <a:gd name="T4" fmla="*/ 515 w 515"/>
                <a:gd name="T5" fmla="*/ 429 h 4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5" h="429">
                  <a:moveTo>
                    <a:pt x="0" y="0"/>
                  </a:moveTo>
                  <a:lnTo>
                    <a:pt x="0" y="429"/>
                  </a:lnTo>
                  <a:lnTo>
                    <a:pt x="515" y="429"/>
                  </a:lnTo>
                </a:path>
              </a:pathLst>
            </a:cu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9" name="Freeform 35">
              <a:extLst>
                <a:ext uri="{FF2B5EF4-FFF2-40B4-BE49-F238E27FC236}">
                  <a16:creationId xmlns:a16="http://schemas.microsoft.com/office/drawing/2014/main" id="{B9C55C84-049A-A742-9460-A790B6595BE6}"/>
                </a:ext>
              </a:extLst>
            </p:cNvPr>
            <p:cNvSpPr>
              <a:spLocks/>
            </p:cNvSpPr>
            <p:nvPr/>
          </p:nvSpPr>
          <p:spPr bwMode="auto">
            <a:xfrm>
              <a:off x="2347327" y="1946860"/>
              <a:ext cx="3503612" cy="2455863"/>
            </a:xfrm>
            <a:custGeom>
              <a:avLst/>
              <a:gdLst>
                <a:gd name="T0" fmla="*/ 1 w 495"/>
                <a:gd name="T1" fmla="*/ 0 h 347"/>
                <a:gd name="T2" fmla="*/ 1 w 495"/>
                <a:gd name="T3" fmla="*/ 5 h 347"/>
                <a:gd name="T4" fmla="*/ 2 w 495"/>
                <a:gd name="T5" fmla="*/ 10 h 347"/>
                <a:gd name="T6" fmla="*/ 4 w 495"/>
                <a:gd name="T7" fmla="*/ 15 h 347"/>
                <a:gd name="T8" fmla="*/ 5 w 495"/>
                <a:gd name="T9" fmla="*/ 20 h 347"/>
                <a:gd name="T10" fmla="*/ 6 w 495"/>
                <a:gd name="T11" fmla="*/ 26 h 347"/>
                <a:gd name="T12" fmla="*/ 6 w 495"/>
                <a:gd name="T13" fmla="*/ 31 h 347"/>
                <a:gd name="T14" fmla="*/ 7 w 495"/>
                <a:gd name="T15" fmla="*/ 36 h 347"/>
                <a:gd name="T16" fmla="*/ 7 w 495"/>
                <a:gd name="T17" fmla="*/ 41 h 347"/>
                <a:gd name="T18" fmla="*/ 8 w 495"/>
                <a:gd name="T19" fmla="*/ 46 h 347"/>
                <a:gd name="T20" fmla="*/ 9 w 495"/>
                <a:gd name="T21" fmla="*/ 51 h 347"/>
                <a:gd name="T22" fmla="*/ 9 w 495"/>
                <a:gd name="T23" fmla="*/ 56 h 347"/>
                <a:gd name="T24" fmla="*/ 10 w 495"/>
                <a:gd name="T25" fmla="*/ 61 h 347"/>
                <a:gd name="T26" fmla="*/ 10 w 495"/>
                <a:gd name="T27" fmla="*/ 67 h 347"/>
                <a:gd name="T28" fmla="*/ 11 w 495"/>
                <a:gd name="T29" fmla="*/ 82 h 347"/>
                <a:gd name="T30" fmla="*/ 15 w 495"/>
                <a:gd name="T31" fmla="*/ 93 h 347"/>
                <a:gd name="T32" fmla="*/ 16 w 495"/>
                <a:gd name="T33" fmla="*/ 98 h 347"/>
                <a:gd name="T34" fmla="*/ 17 w 495"/>
                <a:gd name="T35" fmla="*/ 108 h 347"/>
                <a:gd name="T36" fmla="*/ 17 w 495"/>
                <a:gd name="T37" fmla="*/ 114 h 347"/>
                <a:gd name="T38" fmla="*/ 18 w 495"/>
                <a:gd name="T39" fmla="*/ 119 h 347"/>
                <a:gd name="T40" fmla="*/ 18 w 495"/>
                <a:gd name="T41" fmla="*/ 124 h 347"/>
                <a:gd name="T42" fmla="*/ 20 w 495"/>
                <a:gd name="T43" fmla="*/ 135 h 347"/>
                <a:gd name="T44" fmla="*/ 20 w 495"/>
                <a:gd name="T45" fmla="*/ 140 h 347"/>
                <a:gd name="T46" fmla="*/ 20 w 495"/>
                <a:gd name="T47" fmla="*/ 146 h 347"/>
                <a:gd name="T48" fmla="*/ 21 w 495"/>
                <a:gd name="T49" fmla="*/ 162 h 347"/>
                <a:gd name="T50" fmla="*/ 21 w 495"/>
                <a:gd name="T51" fmla="*/ 167 h 347"/>
                <a:gd name="T52" fmla="*/ 23 w 495"/>
                <a:gd name="T53" fmla="*/ 173 h 347"/>
                <a:gd name="T54" fmla="*/ 24 w 495"/>
                <a:gd name="T55" fmla="*/ 178 h 347"/>
                <a:gd name="T56" fmla="*/ 25 w 495"/>
                <a:gd name="T57" fmla="*/ 183 h 347"/>
                <a:gd name="T58" fmla="*/ 25 w 495"/>
                <a:gd name="T59" fmla="*/ 189 h 347"/>
                <a:gd name="T60" fmla="*/ 30 w 495"/>
                <a:gd name="T61" fmla="*/ 194 h 347"/>
                <a:gd name="T62" fmla="*/ 30 w 495"/>
                <a:gd name="T63" fmla="*/ 200 h 347"/>
                <a:gd name="T64" fmla="*/ 33 w 495"/>
                <a:gd name="T65" fmla="*/ 205 h 347"/>
                <a:gd name="T66" fmla="*/ 42 w 495"/>
                <a:gd name="T67" fmla="*/ 211 h 347"/>
                <a:gd name="T68" fmla="*/ 45 w 495"/>
                <a:gd name="T69" fmla="*/ 217 h 347"/>
                <a:gd name="T70" fmla="*/ 51 w 495"/>
                <a:gd name="T71" fmla="*/ 222 h 347"/>
                <a:gd name="T72" fmla="*/ 53 w 495"/>
                <a:gd name="T73" fmla="*/ 228 h 347"/>
                <a:gd name="T74" fmla="*/ 57 w 495"/>
                <a:gd name="T75" fmla="*/ 234 h 347"/>
                <a:gd name="T76" fmla="*/ 58 w 495"/>
                <a:gd name="T77" fmla="*/ 241 h 347"/>
                <a:gd name="T78" fmla="*/ 60 w 495"/>
                <a:gd name="T79" fmla="*/ 247 h 347"/>
                <a:gd name="T80" fmla="*/ 63 w 495"/>
                <a:gd name="T81" fmla="*/ 253 h 347"/>
                <a:gd name="T82" fmla="*/ 65 w 495"/>
                <a:gd name="T83" fmla="*/ 259 h 347"/>
                <a:gd name="T84" fmla="*/ 66 w 495"/>
                <a:gd name="T85" fmla="*/ 265 h 347"/>
                <a:gd name="T86" fmla="*/ 71 w 495"/>
                <a:gd name="T87" fmla="*/ 271 h 347"/>
                <a:gd name="T88" fmla="*/ 72 w 495"/>
                <a:gd name="T89" fmla="*/ 277 h 347"/>
                <a:gd name="T90" fmla="*/ 75 w 495"/>
                <a:gd name="T91" fmla="*/ 283 h 347"/>
                <a:gd name="T92" fmla="*/ 86 w 495"/>
                <a:gd name="T93" fmla="*/ 289 h 347"/>
                <a:gd name="T94" fmla="*/ 86 w 495"/>
                <a:gd name="T95" fmla="*/ 296 h 347"/>
                <a:gd name="T96" fmla="*/ 99 w 495"/>
                <a:gd name="T97" fmla="*/ 302 h 347"/>
                <a:gd name="T98" fmla="*/ 100 w 495"/>
                <a:gd name="T99" fmla="*/ 310 h 347"/>
                <a:gd name="T100" fmla="*/ 151 w 495"/>
                <a:gd name="T101" fmla="*/ 318 h 347"/>
                <a:gd name="T102" fmla="*/ 173 w 495"/>
                <a:gd name="T103" fmla="*/ 330 h 347"/>
                <a:gd name="T104" fmla="*/ 495 w 495"/>
                <a:gd name="T105" fmla="*/ 347 h 3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</a:cxnLst>
              <a:rect l="0" t="0" r="r" b="b"/>
              <a:pathLst>
                <a:path w="495" h="347">
                  <a:moveTo>
                    <a:pt x="0" y="0"/>
                  </a:moveTo>
                  <a:lnTo>
                    <a:pt x="1" y="0"/>
                  </a:lnTo>
                  <a:lnTo>
                    <a:pt x="1" y="5"/>
                  </a:lnTo>
                  <a:lnTo>
                    <a:pt x="1" y="5"/>
                  </a:lnTo>
                  <a:lnTo>
                    <a:pt x="1" y="10"/>
                  </a:lnTo>
                  <a:lnTo>
                    <a:pt x="2" y="10"/>
                  </a:lnTo>
                  <a:lnTo>
                    <a:pt x="2" y="15"/>
                  </a:lnTo>
                  <a:lnTo>
                    <a:pt x="4" y="15"/>
                  </a:lnTo>
                  <a:lnTo>
                    <a:pt x="4" y="20"/>
                  </a:lnTo>
                  <a:lnTo>
                    <a:pt x="5" y="20"/>
                  </a:lnTo>
                  <a:lnTo>
                    <a:pt x="5" y="26"/>
                  </a:lnTo>
                  <a:lnTo>
                    <a:pt x="6" y="26"/>
                  </a:lnTo>
                  <a:lnTo>
                    <a:pt x="6" y="31"/>
                  </a:lnTo>
                  <a:lnTo>
                    <a:pt x="6" y="31"/>
                  </a:lnTo>
                  <a:lnTo>
                    <a:pt x="6" y="36"/>
                  </a:lnTo>
                  <a:lnTo>
                    <a:pt x="7" y="36"/>
                  </a:lnTo>
                  <a:lnTo>
                    <a:pt x="7" y="41"/>
                  </a:lnTo>
                  <a:lnTo>
                    <a:pt x="7" y="41"/>
                  </a:lnTo>
                  <a:lnTo>
                    <a:pt x="7" y="46"/>
                  </a:lnTo>
                  <a:lnTo>
                    <a:pt x="8" y="46"/>
                  </a:lnTo>
                  <a:lnTo>
                    <a:pt x="8" y="51"/>
                  </a:lnTo>
                  <a:lnTo>
                    <a:pt x="9" y="51"/>
                  </a:lnTo>
                  <a:lnTo>
                    <a:pt x="9" y="56"/>
                  </a:lnTo>
                  <a:lnTo>
                    <a:pt x="9" y="56"/>
                  </a:lnTo>
                  <a:lnTo>
                    <a:pt x="9" y="61"/>
                  </a:lnTo>
                  <a:lnTo>
                    <a:pt x="10" y="61"/>
                  </a:lnTo>
                  <a:lnTo>
                    <a:pt x="10" y="67"/>
                  </a:lnTo>
                  <a:lnTo>
                    <a:pt x="10" y="67"/>
                  </a:lnTo>
                  <a:lnTo>
                    <a:pt x="10" y="82"/>
                  </a:lnTo>
                  <a:lnTo>
                    <a:pt x="11" y="82"/>
                  </a:lnTo>
                  <a:lnTo>
                    <a:pt x="11" y="93"/>
                  </a:lnTo>
                  <a:lnTo>
                    <a:pt x="15" y="93"/>
                  </a:lnTo>
                  <a:lnTo>
                    <a:pt x="15" y="98"/>
                  </a:lnTo>
                  <a:lnTo>
                    <a:pt x="16" y="98"/>
                  </a:lnTo>
                  <a:lnTo>
                    <a:pt x="16" y="108"/>
                  </a:lnTo>
                  <a:lnTo>
                    <a:pt x="17" y="108"/>
                  </a:lnTo>
                  <a:lnTo>
                    <a:pt x="17" y="114"/>
                  </a:lnTo>
                  <a:lnTo>
                    <a:pt x="17" y="114"/>
                  </a:lnTo>
                  <a:lnTo>
                    <a:pt x="17" y="119"/>
                  </a:lnTo>
                  <a:lnTo>
                    <a:pt x="18" y="119"/>
                  </a:lnTo>
                  <a:lnTo>
                    <a:pt x="18" y="124"/>
                  </a:lnTo>
                  <a:lnTo>
                    <a:pt x="18" y="124"/>
                  </a:lnTo>
                  <a:lnTo>
                    <a:pt x="18" y="135"/>
                  </a:lnTo>
                  <a:lnTo>
                    <a:pt x="20" y="135"/>
                  </a:lnTo>
                  <a:lnTo>
                    <a:pt x="20" y="140"/>
                  </a:lnTo>
                  <a:lnTo>
                    <a:pt x="20" y="140"/>
                  </a:lnTo>
                  <a:lnTo>
                    <a:pt x="20" y="146"/>
                  </a:lnTo>
                  <a:lnTo>
                    <a:pt x="20" y="146"/>
                  </a:lnTo>
                  <a:lnTo>
                    <a:pt x="20" y="162"/>
                  </a:lnTo>
                  <a:lnTo>
                    <a:pt x="21" y="162"/>
                  </a:lnTo>
                  <a:lnTo>
                    <a:pt x="21" y="167"/>
                  </a:lnTo>
                  <a:lnTo>
                    <a:pt x="21" y="167"/>
                  </a:lnTo>
                  <a:lnTo>
                    <a:pt x="21" y="173"/>
                  </a:lnTo>
                  <a:lnTo>
                    <a:pt x="23" y="173"/>
                  </a:lnTo>
                  <a:lnTo>
                    <a:pt x="23" y="178"/>
                  </a:lnTo>
                  <a:lnTo>
                    <a:pt x="24" y="178"/>
                  </a:lnTo>
                  <a:lnTo>
                    <a:pt x="24" y="183"/>
                  </a:lnTo>
                  <a:lnTo>
                    <a:pt x="25" y="183"/>
                  </a:lnTo>
                  <a:lnTo>
                    <a:pt x="25" y="189"/>
                  </a:lnTo>
                  <a:lnTo>
                    <a:pt x="25" y="189"/>
                  </a:lnTo>
                  <a:lnTo>
                    <a:pt x="25" y="194"/>
                  </a:lnTo>
                  <a:lnTo>
                    <a:pt x="30" y="194"/>
                  </a:lnTo>
                  <a:lnTo>
                    <a:pt x="30" y="200"/>
                  </a:lnTo>
                  <a:lnTo>
                    <a:pt x="30" y="200"/>
                  </a:lnTo>
                  <a:lnTo>
                    <a:pt x="30" y="205"/>
                  </a:lnTo>
                  <a:lnTo>
                    <a:pt x="33" y="205"/>
                  </a:lnTo>
                  <a:lnTo>
                    <a:pt x="33" y="211"/>
                  </a:lnTo>
                  <a:lnTo>
                    <a:pt x="42" y="211"/>
                  </a:lnTo>
                  <a:lnTo>
                    <a:pt x="42" y="217"/>
                  </a:lnTo>
                  <a:lnTo>
                    <a:pt x="45" y="217"/>
                  </a:lnTo>
                  <a:lnTo>
                    <a:pt x="45" y="222"/>
                  </a:lnTo>
                  <a:lnTo>
                    <a:pt x="51" y="222"/>
                  </a:lnTo>
                  <a:lnTo>
                    <a:pt x="51" y="228"/>
                  </a:lnTo>
                  <a:lnTo>
                    <a:pt x="53" y="228"/>
                  </a:lnTo>
                  <a:lnTo>
                    <a:pt x="53" y="234"/>
                  </a:lnTo>
                  <a:lnTo>
                    <a:pt x="57" y="234"/>
                  </a:lnTo>
                  <a:lnTo>
                    <a:pt x="57" y="241"/>
                  </a:lnTo>
                  <a:lnTo>
                    <a:pt x="58" y="241"/>
                  </a:lnTo>
                  <a:lnTo>
                    <a:pt x="58" y="247"/>
                  </a:lnTo>
                  <a:lnTo>
                    <a:pt x="60" y="247"/>
                  </a:lnTo>
                  <a:lnTo>
                    <a:pt x="60" y="253"/>
                  </a:lnTo>
                  <a:lnTo>
                    <a:pt x="63" y="253"/>
                  </a:lnTo>
                  <a:lnTo>
                    <a:pt x="63" y="259"/>
                  </a:lnTo>
                  <a:lnTo>
                    <a:pt x="65" y="259"/>
                  </a:lnTo>
                  <a:lnTo>
                    <a:pt x="65" y="265"/>
                  </a:lnTo>
                  <a:lnTo>
                    <a:pt x="66" y="265"/>
                  </a:lnTo>
                  <a:lnTo>
                    <a:pt x="66" y="271"/>
                  </a:lnTo>
                  <a:lnTo>
                    <a:pt x="71" y="271"/>
                  </a:lnTo>
                  <a:lnTo>
                    <a:pt x="71" y="277"/>
                  </a:lnTo>
                  <a:lnTo>
                    <a:pt x="72" y="277"/>
                  </a:lnTo>
                  <a:lnTo>
                    <a:pt x="72" y="283"/>
                  </a:lnTo>
                  <a:lnTo>
                    <a:pt x="75" y="283"/>
                  </a:lnTo>
                  <a:lnTo>
                    <a:pt x="75" y="289"/>
                  </a:lnTo>
                  <a:lnTo>
                    <a:pt x="86" y="289"/>
                  </a:lnTo>
                  <a:lnTo>
                    <a:pt x="86" y="296"/>
                  </a:lnTo>
                  <a:lnTo>
                    <a:pt x="86" y="296"/>
                  </a:lnTo>
                  <a:lnTo>
                    <a:pt x="86" y="302"/>
                  </a:lnTo>
                  <a:lnTo>
                    <a:pt x="99" y="302"/>
                  </a:lnTo>
                  <a:lnTo>
                    <a:pt x="99" y="310"/>
                  </a:lnTo>
                  <a:lnTo>
                    <a:pt x="100" y="310"/>
                  </a:lnTo>
                  <a:lnTo>
                    <a:pt x="100" y="318"/>
                  </a:lnTo>
                  <a:lnTo>
                    <a:pt x="151" y="318"/>
                  </a:lnTo>
                  <a:lnTo>
                    <a:pt x="151" y="330"/>
                  </a:lnTo>
                  <a:lnTo>
                    <a:pt x="173" y="330"/>
                  </a:lnTo>
                  <a:lnTo>
                    <a:pt x="173" y="347"/>
                  </a:lnTo>
                  <a:lnTo>
                    <a:pt x="495" y="347"/>
                  </a:lnTo>
                  <a:lnTo>
                    <a:pt x="495" y="347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0" name="Line 36">
              <a:extLst>
                <a:ext uri="{FF2B5EF4-FFF2-40B4-BE49-F238E27FC236}">
                  <a16:creationId xmlns:a16="http://schemas.microsoft.com/office/drawing/2014/main" id="{5F28DBB1-5165-A242-A17F-511C61FB6D3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69552" y="2307222"/>
              <a:ext cx="6985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1" name="Line 37">
              <a:extLst>
                <a:ext uri="{FF2B5EF4-FFF2-40B4-BE49-F238E27FC236}">
                  <a16:creationId xmlns:a16="http://schemas.microsoft.com/office/drawing/2014/main" id="{45AE62A0-665D-C641-8EE8-8E6BFF1C7F1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04477" y="2272297"/>
              <a:ext cx="0" cy="714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2" name="Line 38">
              <a:extLst>
                <a:ext uri="{FF2B5EF4-FFF2-40B4-BE49-F238E27FC236}">
                  <a16:creationId xmlns:a16="http://schemas.microsoft.com/office/drawing/2014/main" id="{DB4C5744-0656-A24A-B66B-DB8132E7E88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83840" y="2526297"/>
              <a:ext cx="7778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3" name="Line 39">
              <a:extLst>
                <a:ext uri="{FF2B5EF4-FFF2-40B4-BE49-F238E27FC236}">
                  <a16:creationId xmlns:a16="http://schemas.microsoft.com/office/drawing/2014/main" id="{3F3FE189-BAD8-F142-8D12-D9B160D76EF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25115" y="2491372"/>
              <a:ext cx="0" cy="714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4" name="Line 40">
              <a:extLst>
                <a:ext uri="{FF2B5EF4-FFF2-40B4-BE49-F238E27FC236}">
                  <a16:creationId xmlns:a16="http://schemas.microsoft.com/office/drawing/2014/main" id="{5CCDEDF3-F9A7-1C4A-BBFD-B82A559CB90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25115" y="2710447"/>
              <a:ext cx="7143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5" name="Line 41">
              <a:extLst>
                <a:ext uri="{FF2B5EF4-FFF2-40B4-BE49-F238E27FC236}">
                  <a16:creationId xmlns:a16="http://schemas.microsoft.com/office/drawing/2014/main" id="{772F9A37-11F2-804C-AD36-16E1E784B2E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61627" y="2675522"/>
              <a:ext cx="0" cy="714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6" name="Line 42">
              <a:extLst>
                <a:ext uri="{FF2B5EF4-FFF2-40B4-BE49-F238E27FC236}">
                  <a16:creationId xmlns:a16="http://schemas.microsoft.com/office/drawing/2014/main" id="{7DD9A730-B0A9-BD40-89B5-3419EB9BE8C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75915" y="3205747"/>
              <a:ext cx="7778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7" name="Line 43">
              <a:extLst>
                <a:ext uri="{FF2B5EF4-FFF2-40B4-BE49-F238E27FC236}">
                  <a16:creationId xmlns:a16="http://schemas.microsoft.com/office/drawing/2014/main" id="{E6C2ADD6-C34F-0946-82E0-5E299F5BAEB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10840" y="3170822"/>
              <a:ext cx="0" cy="714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8" name="Line 44">
              <a:extLst>
                <a:ext uri="{FF2B5EF4-FFF2-40B4-BE49-F238E27FC236}">
                  <a16:creationId xmlns:a16="http://schemas.microsoft.com/office/drawing/2014/main" id="{F88AB104-9FBA-1A45-BB03-F6387AA3C6F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82277" y="3439110"/>
              <a:ext cx="6985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9" name="Line 45">
              <a:extLst>
                <a:ext uri="{FF2B5EF4-FFF2-40B4-BE49-F238E27FC236}">
                  <a16:creationId xmlns:a16="http://schemas.microsoft.com/office/drawing/2014/main" id="{65411AFC-44D6-B944-B8BF-51727910C5F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17202" y="3404185"/>
              <a:ext cx="0" cy="714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0" name="Line 46">
              <a:extLst>
                <a:ext uri="{FF2B5EF4-FFF2-40B4-BE49-F238E27FC236}">
                  <a16:creationId xmlns:a16="http://schemas.microsoft.com/office/drawing/2014/main" id="{08586B43-500A-9844-8E01-24D6508F17B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09265" y="3481972"/>
              <a:ext cx="7143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1" name="Line 47">
              <a:extLst>
                <a:ext uri="{FF2B5EF4-FFF2-40B4-BE49-F238E27FC236}">
                  <a16:creationId xmlns:a16="http://schemas.microsoft.com/office/drawing/2014/main" id="{BD95D49E-DEB0-B341-AD09-23643AEDC2E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45777" y="3439110"/>
              <a:ext cx="0" cy="7778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2" name="Line 48">
              <a:extLst>
                <a:ext uri="{FF2B5EF4-FFF2-40B4-BE49-F238E27FC236}">
                  <a16:creationId xmlns:a16="http://schemas.microsoft.com/office/drawing/2014/main" id="{9A2EAD46-0D4D-A448-B9AF-E051B2DF8A8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60065" y="3516897"/>
              <a:ext cx="6985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3" name="Line 49">
              <a:extLst>
                <a:ext uri="{FF2B5EF4-FFF2-40B4-BE49-F238E27FC236}">
                  <a16:creationId xmlns:a16="http://schemas.microsoft.com/office/drawing/2014/main" id="{727C59D7-DA78-1E49-A46A-A7C41207B78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94990" y="3481972"/>
              <a:ext cx="0" cy="714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4" name="Line 50">
              <a:extLst>
                <a:ext uri="{FF2B5EF4-FFF2-40B4-BE49-F238E27FC236}">
                  <a16:creationId xmlns:a16="http://schemas.microsoft.com/office/drawing/2014/main" id="{E0299506-28FB-7F46-AAC2-059A88484E4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93427" y="3991560"/>
              <a:ext cx="6985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5" name="Line 51">
              <a:extLst>
                <a:ext uri="{FF2B5EF4-FFF2-40B4-BE49-F238E27FC236}">
                  <a16:creationId xmlns:a16="http://schemas.microsoft.com/office/drawing/2014/main" id="{1F5943F1-CF19-0B4A-B7DD-F68CEB83494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28352" y="3956635"/>
              <a:ext cx="0" cy="6985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6" name="Line 52">
              <a:extLst>
                <a:ext uri="{FF2B5EF4-FFF2-40B4-BE49-F238E27FC236}">
                  <a16:creationId xmlns:a16="http://schemas.microsoft.com/office/drawing/2014/main" id="{22178865-71C7-C841-A08D-E4233C933B9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93427" y="3991560"/>
              <a:ext cx="6985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7" name="Line 53">
              <a:extLst>
                <a:ext uri="{FF2B5EF4-FFF2-40B4-BE49-F238E27FC236}">
                  <a16:creationId xmlns:a16="http://schemas.microsoft.com/office/drawing/2014/main" id="{6C4DE63E-15C2-CE48-B2B5-92401BAE5C9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28352" y="3956635"/>
              <a:ext cx="0" cy="6985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8" name="Line 54">
              <a:extLst>
                <a:ext uri="{FF2B5EF4-FFF2-40B4-BE49-F238E27FC236}">
                  <a16:creationId xmlns:a16="http://schemas.microsoft.com/office/drawing/2014/main" id="{50AD4A32-5B20-0849-A929-21B3F65F453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99790" y="4083635"/>
              <a:ext cx="6985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9" name="Line 55">
              <a:extLst>
                <a:ext uri="{FF2B5EF4-FFF2-40B4-BE49-F238E27FC236}">
                  <a16:creationId xmlns:a16="http://schemas.microsoft.com/office/drawing/2014/main" id="{64BD3B4C-8292-E245-8865-8FFB7346BE7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34715" y="4048710"/>
              <a:ext cx="0" cy="6985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0" name="Line 56">
              <a:extLst>
                <a:ext uri="{FF2B5EF4-FFF2-40B4-BE49-F238E27FC236}">
                  <a16:creationId xmlns:a16="http://schemas.microsoft.com/office/drawing/2014/main" id="{68BCDF39-BCE1-6442-82ED-7B041046030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06140" y="4083635"/>
              <a:ext cx="7143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1" name="Line 57">
              <a:extLst>
                <a:ext uri="{FF2B5EF4-FFF2-40B4-BE49-F238E27FC236}">
                  <a16:creationId xmlns:a16="http://schemas.microsoft.com/office/drawing/2014/main" id="{DD7B79CB-0B99-8146-BC05-432973460F4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41065" y="4048710"/>
              <a:ext cx="0" cy="6985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2" name="Line 58">
              <a:extLst>
                <a:ext uri="{FF2B5EF4-FFF2-40B4-BE49-F238E27FC236}">
                  <a16:creationId xmlns:a16="http://schemas.microsoft.com/office/drawing/2014/main" id="{438AF519-0D62-6242-9BAF-3B28BC36EFC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82352" y="4196347"/>
              <a:ext cx="7778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3" name="Line 59">
              <a:extLst>
                <a:ext uri="{FF2B5EF4-FFF2-40B4-BE49-F238E27FC236}">
                  <a16:creationId xmlns:a16="http://schemas.microsoft.com/office/drawing/2014/main" id="{CC07F788-597A-C64C-A388-537F5E52481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25215" y="4161422"/>
              <a:ext cx="0" cy="714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4" name="Line 60">
              <a:extLst>
                <a:ext uri="{FF2B5EF4-FFF2-40B4-BE49-F238E27FC236}">
                  <a16:creationId xmlns:a16="http://schemas.microsoft.com/office/drawing/2014/main" id="{296E1179-C381-AE48-B370-DDDFF809601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25215" y="4196347"/>
              <a:ext cx="7778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5" name="Line 61">
              <a:extLst>
                <a:ext uri="{FF2B5EF4-FFF2-40B4-BE49-F238E27FC236}">
                  <a16:creationId xmlns:a16="http://schemas.microsoft.com/office/drawing/2014/main" id="{9130EC61-D221-0443-B566-ADFB899CB0F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68077" y="4161422"/>
              <a:ext cx="0" cy="714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6" name="Line 62">
              <a:extLst>
                <a:ext uri="{FF2B5EF4-FFF2-40B4-BE49-F238E27FC236}">
                  <a16:creationId xmlns:a16="http://schemas.microsoft.com/office/drawing/2014/main" id="{A48CF6A3-8AE5-9441-B2E4-F20C317D08F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53790" y="4196347"/>
              <a:ext cx="7143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7" name="Line 63">
              <a:extLst>
                <a:ext uri="{FF2B5EF4-FFF2-40B4-BE49-F238E27FC236}">
                  <a16:creationId xmlns:a16="http://schemas.microsoft.com/office/drawing/2014/main" id="{EAE5484B-D25B-F947-BC18-56D22F8FBB8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88715" y="4161422"/>
              <a:ext cx="0" cy="714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8" name="Line 64">
              <a:extLst>
                <a:ext uri="{FF2B5EF4-FFF2-40B4-BE49-F238E27FC236}">
                  <a16:creationId xmlns:a16="http://schemas.microsoft.com/office/drawing/2014/main" id="{EC7B90D4-E38B-E443-B3FA-CD2B8C7766D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66515" y="4282072"/>
              <a:ext cx="6985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9" name="Line 65">
              <a:extLst>
                <a:ext uri="{FF2B5EF4-FFF2-40B4-BE49-F238E27FC236}">
                  <a16:creationId xmlns:a16="http://schemas.microsoft.com/office/drawing/2014/main" id="{003256CC-A8A8-B540-8AF3-6A4FAB1F754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01440" y="4239210"/>
              <a:ext cx="0" cy="7778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0" name="Line 66">
              <a:extLst>
                <a:ext uri="{FF2B5EF4-FFF2-40B4-BE49-F238E27FC236}">
                  <a16:creationId xmlns:a16="http://schemas.microsoft.com/office/drawing/2014/main" id="{9D264D7E-6309-5E4C-9A58-1955961361B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36365" y="4282072"/>
              <a:ext cx="7143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1" name="Line 67">
              <a:extLst>
                <a:ext uri="{FF2B5EF4-FFF2-40B4-BE49-F238E27FC236}">
                  <a16:creationId xmlns:a16="http://schemas.microsoft.com/office/drawing/2014/main" id="{C3D1709C-FBFF-B344-AD46-89CED203AFC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72877" y="4239210"/>
              <a:ext cx="0" cy="7778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2" name="Line 68">
              <a:extLst>
                <a:ext uri="{FF2B5EF4-FFF2-40B4-BE49-F238E27FC236}">
                  <a16:creationId xmlns:a16="http://schemas.microsoft.com/office/drawing/2014/main" id="{DB3FA84B-B844-5B41-9FD2-4BF7CD1D8D1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492040" y="4402722"/>
              <a:ext cx="7778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3" name="Line 69">
              <a:extLst>
                <a:ext uri="{FF2B5EF4-FFF2-40B4-BE49-F238E27FC236}">
                  <a16:creationId xmlns:a16="http://schemas.microsoft.com/office/drawing/2014/main" id="{FACE883D-8D55-6F44-A76F-4D1EAFB45A7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526965" y="4359860"/>
              <a:ext cx="0" cy="7778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4" name="Line 70">
              <a:extLst>
                <a:ext uri="{FF2B5EF4-FFF2-40B4-BE49-F238E27FC236}">
                  <a16:creationId xmlns:a16="http://schemas.microsoft.com/office/drawing/2014/main" id="{2E87A684-92DE-2948-8718-1BD2F1171BA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23827" y="4402722"/>
              <a:ext cx="7778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5" name="Line 71">
              <a:extLst>
                <a:ext uri="{FF2B5EF4-FFF2-40B4-BE49-F238E27FC236}">
                  <a16:creationId xmlns:a16="http://schemas.microsoft.com/office/drawing/2014/main" id="{6B7D5D68-E6DE-2749-9E93-7C59DE17CE4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866690" y="4359860"/>
              <a:ext cx="0" cy="7778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6" name="Line 72">
              <a:extLst>
                <a:ext uri="{FF2B5EF4-FFF2-40B4-BE49-F238E27FC236}">
                  <a16:creationId xmlns:a16="http://schemas.microsoft.com/office/drawing/2014/main" id="{4FB52A62-0A4B-1241-AEA9-E250AC5FF7D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814427" y="4402722"/>
              <a:ext cx="7143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7" name="Line 73">
              <a:extLst>
                <a:ext uri="{FF2B5EF4-FFF2-40B4-BE49-F238E27FC236}">
                  <a16:creationId xmlns:a16="http://schemas.microsoft.com/office/drawing/2014/main" id="{6CB0AE83-9CB6-E942-B794-6CFF069A7E6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850940" y="4359860"/>
              <a:ext cx="0" cy="7778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8" name="Freeform 74">
              <a:extLst>
                <a:ext uri="{FF2B5EF4-FFF2-40B4-BE49-F238E27FC236}">
                  <a16:creationId xmlns:a16="http://schemas.microsoft.com/office/drawing/2014/main" id="{84DB9E7A-18AE-F544-9973-89AF9FD9E9A9}"/>
                </a:ext>
              </a:extLst>
            </p:cNvPr>
            <p:cNvSpPr>
              <a:spLocks/>
            </p:cNvSpPr>
            <p:nvPr/>
          </p:nvSpPr>
          <p:spPr bwMode="auto">
            <a:xfrm>
              <a:off x="2347327" y="1946860"/>
              <a:ext cx="2660650" cy="2363788"/>
            </a:xfrm>
            <a:custGeom>
              <a:avLst/>
              <a:gdLst>
                <a:gd name="T0" fmla="*/ 0 w 376"/>
                <a:gd name="T1" fmla="*/ 0 h 334"/>
                <a:gd name="T2" fmla="*/ 3 w 376"/>
                <a:gd name="T3" fmla="*/ 0 h 334"/>
                <a:gd name="T4" fmla="*/ 3 w 376"/>
                <a:gd name="T5" fmla="*/ 40 h 334"/>
                <a:gd name="T6" fmla="*/ 50 w 376"/>
                <a:gd name="T7" fmla="*/ 40 h 334"/>
                <a:gd name="T8" fmla="*/ 50 w 376"/>
                <a:gd name="T9" fmla="*/ 91 h 334"/>
                <a:gd name="T10" fmla="*/ 60 w 376"/>
                <a:gd name="T11" fmla="*/ 91 h 334"/>
                <a:gd name="T12" fmla="*/ 60 w 376"/>
                <a:gd name="T13" fmla="*/ 142 h 334"/>
                <a:gd name="T14" fmla="*/ 108 w 376"/>
                <a:gd name="T15" fmla="*/ 142 h 334"/>
                <a:gd name="T16" fmla="*/ 108 w 376"/>
                <a:gd name="T17" fmla="*/ 206 h 334"/>
                <a:gd name="T18" fmla="*/ 177 w 376"/>
                <a:gd name="T19" fmla="*/ 206 h 334"/>
                <a:gd name="T20" fmla="*/ 177 w 376"/>
                <a:gd name="T21" fmla="*/ 270 h 334"/>
                <a:gd name="T22" fmla="*/ 178 w 376"/>
                <a:gd name="T23" fmla="*/ 270 h 334"/>
                <a:gd name="T24" fmla="*/ 178 w 376"/>
                <a:gd name="T25" fmla="*/ 334 h 334"/>
                <a:gd name="T26" fmla="*/ 376 w 376"/>
                <a:gd name="T27" fmla="*/ 334 h 334"/>
                <a:gd name="T28" fmla="*/ 376 w 376"/>
                <a:gd name="T29" fmla="*/ 334 h 3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</a:cxnLst>
              <a:rect l="0" t="0" r="r" b="b"/>
              <a:pathLst>
                <a:path w="376" h="334">
                  <a:moveTo>
                    <a:pt x="0" y="0"/>
                  </a:moveTo>
                  <a:lnTo>
                    <a:pt x="3" y="0"/>
                  </a:lnTo>
                  <a:lnTo>
                    <a:pt x="3" y="40"/>
                  </a:lnTo>
                  <a:lnTo>
                    <a:pt x="50" y="40"/>
                  </a:lnTo>
                  <a:lnTo>
                    <a:pt x="50" y="91"/>
                  </a:lnTo>
                  <a:lnTo>
                    <a:pt x="60" y="91"/>
                  </a:lnTo>
                  <a:lnTo>
                    <a:pt x="60" y="142"/>
                  </a:lnTo>
                  <a:lnTo>
                    <a:pt x="108" y="142"/>
                  </a:lnTo>
                  <a:lnTo>
                    <a:pt x="108" y="206"/>
                  </a:lnTo>
                  <a:lnTo>
                    <a:pt x="177" y="206"/>
                  </a:lnTo>
                  <a:lnTo>
                    <a:pt x="177" y="270"/>
                  </a:lnTo>
                  <a:lnTo>
                    <a:pt x="178" y="270"/>
                  </a:lnTo>
                  <a:lnTo>
                    <a:pt x="178" y="334"/>
                  </a:lnTo>
                  <a:lnTo>
                    <a:pt x="376" y="334"/>
                  </a:lnTo>
                  <a:lnTo>
                    <a:pt x="376" y="334"/>
                  </a:lnTo>
                </a:path>
              </a:pathLst>
            </a:custGeom>
            <a:noFill/>
            <a:ln w="635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9" name="Line 75">
              <a:extLst>
                <a:ext uri="{FF2B5EF4-FFF2-40B4-BE49-F238E27FC236}">
                  <a16:creationId xmlns:a16="http://schemas.microsoft.com/office/drawing/2014/main" id="{CAB5EBBA-9B41-2041-81E3-B66E7B1B2C5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67977" y="2229435"/>
              <a:ext cx="77787" cy="0"/>
            </a:xfrm>
            <a:prstGeom prst="line">
              <a:avLst/>
            </a:prstGeom>
            <a:noFill/>
            <a:ln w="635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0" name="Line 76">
              <a:extLst>
                <a:ext uri="{FF2B5EF4-FFF2-40B4-BE49-F238E27FC236}">
                  <a16:creationId xmlns:a16="http://schemas.microsoft.com/office/drawing/2014/main" id="{4C9AFA86-23B0-2043-896B-44DF86CC7E4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04490" y="2194510"/>
              <a:ext cx="0" cy="71438"/>
            </a:xfrm>
            <a:prstGeom prst="line">
              <a:avLst/>
            </a:prstGeom>
            <a:noFill/>
            <a:ln w="635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1" name="Line 77">
              <a:extLst>
                <a:ext uri="{FF2B5EF4-FFF2-40B4-BE49-F238E27FC236}">
                  <a16:creationId xmlns:a16="http://schemas.microsoft.com/office/drawing/2014/main" id="{4B4C1624-C3FD-7048-9E50-28EBB55AC4C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31477" y="2229435"/>
              <a:ext cx="71437" cy="0"/>
            </a:xfrm>
            <a:prstGeom prst="line">
              <a:avLst/>
            </a:prstGeom>
            <a:noFill/>
            <a:ln w="635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2" name="Line 78">
              <a:extLst>
                <a:ext uri="{FF2B5EF4-FFF2-40B4-BE49-F238E27FC236}">
                  <a16:creationId xmlns:a16="http://schemas.microsoft.com/office/drawing/2014/main" id="{524D123F-BEB6-C04B-9BAC-EB4B504C1AE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67990" y="2194510"/>
              <a:ext cx="0" cy="71438"/>
            </a:xfrm>
            <a:prstGeom prst="line">
              <a:avLst/>
            </a:prstGeom>
            <a:noFill/>
            <a:ln w="635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3" name="Line 79">
              <a:extLst>
                <a:ext uri="{FF2B5EF4-FFF2-40B4-BE49-F238E27FC236}">
                  <a16:creationId xmlns:a16="http://schemas.microsoft.com/office/drawing/2014/main" id="{50A4C0F5-5796-7B49-A1DC-943F88D037A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91852" y="2951747"/>
              <a:ext cx="71437" cy="0"/>
            </a:xfrm>
            <a:prstGeom prst="line">
              <a:avLst/>
            </a:prstGeom>
            <a:noFill/>
            <a:ln w="635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4" name="Line 80">
              <a:extLst>
                <a:ext uri="{FF2B5EF4-FFF2-40B4-BE49-F238E27FC236}">
                  <a16:creationId xmlns:a16="http://schemas.microsoft.com/office/drawing/2014/main" id="{09AC9016-D337-A54E-BB28-6B2E2589B6E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26777" y="2916822"/>
              <a:ext cx="0" cy="69850"/>
            </a:xfrm>
            <a:prstGeom prst="line">
              <a:avLst/>
            </a:prstGeom>
            <a:noFill/>
            <a:ln w="635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5" name="Line 81">
              <a:extLst>
                <a:ext uri="{FF2B5EF4-FFF2-40B4-BE49-F238E27FC236}">
                  <a16:creationId xmlns:a16="http://schemas.microsoft.com/office/drawing/2014/main" id="{D17AA8A1-036D-194D-992F-8C566DA0480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973052" y="4310647"/>
              <a:ext cx="71437" cy="0"/>
            </a:xfrm>
            <a:prstGeom prst="line">
              <a:avLst/>
            </a:prstGeom>
            <a:noFill/>
            <a:ln w="635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6" name="Line 82">
              <a:extLst>
                <a:ext uri="{FF2B5EF4-FFF2-40B4-BE49-F238E27FC236}">
                  <a16:creationId xmlns:a16="http://schemas.microsoft.com/office/drawing/2014/main" id="{7310F0DA-B574-EC48-ABEE-6D9ABA83D20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007977" y="4274135"/>
              <a:ext cx="0" cy="71438"/>
            </a:xfrm>
            <a:prstGeom prst="line">
              <a:avLst/>
            </a:prstGeom>
            <a:noFill/>
            <a:ln w="635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7" name="Freeform 83">
              <a:extLst>
                <a:ext uri="{FF2B5EF4-FFF2-40B4-BE49-F238E27FC236}">
                  <a16:creationId xmlns:a16="http://schemas.microsoft.com/office/drawing/2014/main" id="{4D3CFC2E-15AF-AF45-AA42-5B1583A405D8}"/>
                </a:ext>
              </a:extLst>
            </p:cNvPr>
            <p:cNvSpPr>
              <a:spLocks/>
            </p:cNvSpPr>
            <p:nvPr/>
          </p:nvSpPr>
          <p:spPr bwMode="auto">
            <a:xfrm>
              <a:off x="2347327" y="1946860"/>
              <a:ext cx="1798637" cy="2511425"/>
            </a:xfrm>
            <a:custGeom>
              <a:avLst/>
              <a:gdLst>
                <a:gd name="T0" fmla="*/ 0 w 254"/>
                <a:gd name="T1" fmla="*/ 0 h 355"/>
                <a:gd name="T2" fmla="*/ 9 w 254"/>
                <a:gd name="T3" fmla="*/ 0 h 355"/>
                <a:gd name="T4" fmla="*/ 9 w 254"/>
                <a:gd name="T5" fmla="*/ 47 h 355"/>
                <a:gd name="T6" fmla="*/ 12 w 254"/>
                <a:gd name="T7" fmla="*/ 47 h 355"/>
                <a:gd name="T8" fmla="*/ 12 w 254"/>
                <a:gd name="T9" fmla="*/ 70 h 355"/>
                <a:gd name="T10" fmla="*/ 18 w 254"/>
                <a:gd name="T11" fmla="*/ 70 h 355"/>
                <a:gd name="T12" fmla="*/ 18 w 254"/>
                <a:gd name="T13" fmla="*/ 94 h 355"/>
                <a:gd name="T14" fmla="*/ 19 w 254"/>
                <a:gd name="T15" fmla="*/ 94 h 355"/>
                <a:gd name="T16" fmla="*/ 19 w 254"/>
                <a:gd name="T17" fmla="*/ 117 h 355"/>
                <a:gd name="T18" fmla="*/ 23 w 254"/>
                <a:gd name="T19" fmla="*/ 117 h 355"/>
                <a:gd name="T20" fmla="*/ 23 w 254"/>
                <a:gd name="T21" fmla="*/ 140 h 355"/>
                <a:gd name="T22" fmla="*/ 42 w 254"/>
                <a:gd name="T23" fmla="*/ 140 h 355"/>
                <a:gd name="T24" fmla="*/ 42 w 254"/>
                <a:gd name="T25" fmla="*/ 169 h 355"/>
                <a:gd name="T26" fmla="*/ 48 w 254"/>
                <a:gd name="T27" fmla="*/ 169 h 355"/>
                <a:gd name="T28" fmla="*/ 48 w 254"/>
                <a:gd name="T29" fmla="*/ 198 h 355"/>
                <a:gd name="T30" fmla="*/ 53 w 254"/>
                <a:gd name="T31" fmla="*/ 198 h 355"/>
                <a:gd name="T32" fmla="*/ 53 w 254"/>
                <a:gd name="T33" fmla="*/ 226 h 355"/>
                <a:gd name="T34" fmla="*/ 91 w 254"/>
                <a:gd name="T35" fmla="*/ 226 h 355"/>
                <a:gd name="T36" fmla="*/ 91 w 254"/>
                <a:gd name="T37" fmla="*/ 269 h 355"/>
                <a:gd name="T38" fmla="*/ 123 w 254"/>
                <a:gd name="T39" fmla="*/ 269 h 355"/>
                <a:gd name="T40" fmla="*/ 123 w 254"/>
                <a:gd name="T41" fmla="*/ 312 h 355"/>
                <a:gd name="T42" fmla="*/ 130 w 254"/>
                <a:gd name="T43" fmla="*/ 312 h 355"/>
                <a:gd name="T44" fmla="*/ 130 w 254"/>
                <a:gd name="T45" fmla="*/ 355 h 355"/>
                <a:gd name="T46" fmla="*/ 254 w 254"/>
                <a:gd name="T47" fmla="*/ 355 h 355"/>
                <a:gd name="T48" fmla="*/ 254 w 254"/>
                <a:gd name="T49" fmla="*/ 355 h 3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254" h="355">
                  <a:moveTo>
                    <a:pt x="0" y="0"/>
                  </a:moveTo>
                  <a:lnTo>
                    <a:pt x="9" y="0"/>
                  </a:lnTo>
                  <a:lnTo>
                    <a:pt x="9" y="47"/>
                  </a:lnTo>
                  <a:lnTo>
                    <a:pt x="12" y="47"/>
                  </a:lnTo>
                  <a:lnTo>
                    <a:pt x="12" y="70"/>
                  </a:lnTo>
                  <a:lnTo>
                    <a:pt x="18" y="70"/>
                  </a:lnTo>
                  <a:lnTo>
                    <a:pt x="18" y="94"/>
                  </a:lnTo>
                  <a:lnTo>
                    <a:pt x="19" y="94"/>
                  </a:lnTo>
                  <a:lnTo>
                    <a:pt x="19" y="117"/>
                  </a:lnTo>
                  <a:lnTo>
                    <a:pt x="23" y="117"/>
                  </a:lnTo>
                  <a:lnTo>
                    <a:pt x="23" y="140"/>
                  </a:lnTo>
                  <a:lnTo>
                    <a:pt x="42" y="140"/>
                  </a:lnTo>
                  <a:lnTo>
                    <a:pt x="42" y="169"/>
                  </a:lnTo>
                  <a:lnTo>
                    <a:pt x="48" y="169"/>
                  </a:lnTo>
                  <a:lnTo>
                    <a:pt x="48" y="198"/>
                  </a:lnTo>
                  <a:lnTo>
                    <a:pt x="53" y="198"/>
                  </a:lnTo>
                  <a:lnTo>
                    <a:pt x="53" y="226"/>
                  </a:lnTo>
                  <a:lnTo>
                    <a:pt x="91" y="226"/>
                  </a:lnTo>
                  <a:lnTo>
                    <a:pt x="91" y="269"/>
                  </a:lnTo>
                  <a:lnTo>
                    <a:pt x="123" y="269"/>
                  </a:lnTo>
                  <a:lnTo>
                    <a:pt x="123" y="312"/>
                  </a:lnTo>
                  <a:lnTo>
                    <a:pt x="130" y="312"/>
                  </a:lnTo>
                  <a:lnTo>
                    <a:pt x="130" y="355"/>
                  </a:lnTo>
                  <a:lnTo>
                    <a:pt x="254" y="355"/>
                  </a:lnTo>
                  <a:lnTo>
                    <a:pt x="254" y="355"/>
                  </a:lnTo>
                </a:path>
              </a:pathLst>
            </a:custGeom>
            <a:noFill/>
            <a:ln w="6350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8" name="Line 84">
              <a:extLst>
                <a:ext uri="{FF2B5EF4-FFF2-40B4-BE49-F238E27FC236}">
                  <a16:creationId xmlns:a16="http://schemas.microsoft.com/office/drawing/2014/main" id="{7DAABDC6-55AC-F24D-A956-574FA537DE3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17190" y="2937460"/>
              <a:ext cx="71437" cy="0"/>
            </a:xfrm>
            <a:prstGeom prst="line">
              <a:avLst/>
            </a:prstGeom>
            <a:noFill/>
            <a:ln w="6350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9" name="Line 85">
              <a:extLst>
                <a:ext uri="{FF2B5EF4-FFF2-40B4-BE49-F238E27FC236}">
                  <a16:creationId xmlns:a16="http://schemas.microsoft.com/office/drawing/2014/main" id="{D75E764B-08E2-D945-AFB5-4355E933AE4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53702" y="2902535"/>
              <a:ext cx="0" cy="69850"/>
            </a:xfrm>
            <a:prstGeom prst="line">
              <a:avLst/>
            </a:prstGeom>
            <a:noFill/>
            <a:ln w="6350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0" name="Line 86">
              <a:extLst>
                <a:ext uri="{FF2B5EF4-FFF2-40B4-BE49-F238E27FC236}">
                  <a16:creationId xmlns:a16="http://schemas.microsoft.com/office/drawing/2014/main" id="{85C85C66-C477-374E-B6C2-564574F2300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82277" y="2937460"/>
              <a:ext cx="69850" cy="0"/>
            </a:xfrm>
            <a:prstGeom prst="line">
              <a:avLst/>
            </a:prstGeom>
            <a:noFill/>
            <a:ln w="6350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1" name="Line 87">
              <a:extLst>
                <a:ext uri="{FF2B5EF4-FFF2-40B4-BE49-F238E27FC236}">
                  <a16:creationId xmlns:a16="http://schemas.microsoft.com/office/drawing/2014/main" id="{8CCE564E-2526-1A49-A71D-F9478E75050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17202" y="2902535"/>
              <a:ext cx="0" cy="69850"/>
            </a:xfrm>
            <a:prstGeom prst="line">
              <a:avLst/>
            </a:prstGeom>
            <a:noFill/>
            <a:ln w="6350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2" name="Line 88">
              <a:extLst>
                <a:ext uri="{FF2B5EF4-FFF2-40B4-BE49-F238E27FC236}">
                  <a16:creationId xmlns:a16="http://schemas.microsoft.com/office/drawing/2014/main" id="{9315CE0E-2FE3-E047-ABC3-8864F006D07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58490" y="3545472"/>
              <a:ext cx="77787" cy="0"/>
            </a:xfrm>
            <a:prstGeom prst="line">
              <a:avLst/>
            </a:prstGeom>
            <a:noFill/>
            <a:ln w="6350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3" name="Line 89">
              <a:extLst>
                <a:ext uri="{FF2B5EF4-FFF2-40B4-BE49-F238E27FC236}">
                  <a16:creationId xmlns:a16="http://schemas.microsoft.com/office/drawing/2014/main" id="{B588E0A0-69AE-E542-978C-BB629B7429A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01352" y="3510547"/>
              <a:ext cx="0" cy="71438"/>
            </a:xfrm>
            <a:prstGeom prst="line">
              <a:avLst/>
            </a:prstGeom>
            <a:noFill/>
            <a:ln w="6350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4" name="Line 90">
              <a:extLst>
                <a:ext uri="{FF2B5EF4-FFF2-40B4-BE49-F238E27FC236}">
                  <a16:creationId xmlns:a16="http://schemas.microsoft.com/office/drawing/2014/main" id="{DAB3FD82-054F-824E-9333-956636CC9C9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34702" y="3545472"/>
              <a:ext cx="77787" cy="0"/>
            </a:xfrm>
            <a:prstGeom prst="line">
              <a:avLst/>
            </a:prstGeom>
            <a:noFill/>
            <a:ln w="6350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5" name="Line 91">
              <a:extLst>
                <a:ext uri="{FF2B5EF4-FFF2-40B4-BE49-F238E27FC236}">
                  <a16:creationId xmlns:a16="http://schemas.microsoft.com/office/drawing/2014/main" id="{1F19A2D7-4973-EB4A-A232-2D446792606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71215" y="3510547"/>
              <a:ext cx="0" cy="71438"/>
            </a:xfrm>
            <a:prstGeom prst="line">
              <a:avLst/>
            </a:prstGeom>
            <a:noFill/>
            <a:ln w="6350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6" name="Line 92">
              <a:extLst>
                <a:ext uri="{FF2B5EF4-FFF2-40B4-BE49-F238E27FC236}">
                  <a16:creationId xmlns:a16="http://schemas.microsoft.com/office/drawing/2014/main" id="{19E0C3C2-21A2-784E-B9D5-81AFC3DA9E0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09452" y="4458285"/>
              <a:ext cx="71437" cy="0"/>
            </a:xfrm>
            <a:prstGeom prst="line">
              <a:avLst/>
            </a:prstGeom>
            <a:noFill/>
            <a:ln w="6350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7" name="Line 93">
              <a:extLst>
                <a:ext uri="{FF2B5EF4-FFF2-40B4-BE49-F238E27FC236}">
                  <a16:creationId xmlns:a16="http://schemas.microsoft.com/office/drawing/2014/main" id="{11A7FEAC-0418-EF4A-B2AF-288B88CB75A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45965" y="4423360"/>
              <a:ext cx="0" cy="71438"/>
            </a:xfrm>
            <a:prstGeom prst="line">
              <a:avLst/>
            </a:prstGeom>
            <a:noFill/>
            <a:ln w="6350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638" name="グループ化 637">
            <a:extLst>
              <a:ext uri="{FF2B5EF4-FFF2-40B4-BE49-F238E27FC236}">
                <a16:creationId xmlns:a16="http://schemas.microsoft.com/office/drawing/2014/main" id="{37D03A2A-FCF8-A144-A112-454CE927EB0D}"/>
              </a:ext>
            </a:extLst>
          </p:cNvPr>
          <p:cNvGrpSpPr/>
          <p:nvPr/>
        </p:nvGrpSpPr>
        <p:grpSpPr>
          <a:xfrm>
            <a:off x="5383199" y="4993181"/>
            <a:ext cx="3385811" cy="676275"/>
            <a:chOff x="2171909" y="5918785"/>
            <a:chExt cx="3662982" cy="423763"/>
          </a:xfrm>
        </p:grpSpPr>
        <p:sp>
          <p:nvSpPr>
            <p:cNvPr id="639" name="Rectangle 94">
              <a:extLst>
                <a:ext uri="{FF2B5EF4-FFF2-40B4-BE49-F238E27FC236}">
                  <a16:creationId xmlns:a16="http://schemas.microsoft.com/office/drawing/2014/main" id="{BEA69AAC-B1CC-8744-9846-47D46CB7A30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71909" y="5918785"/>
              <a:ext cx="138738" cy="964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r>
                <a:rPr kumimoji="1" lang="en-US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endParaRPr kumimoji="1" lang="ja-JP" altLang="ja-JP" sz="2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0" name="Rectangle 95">
              <a:extLst>
                <a:ext uri="{FF2B5EF4-FFF2-40B4-BE49-F238E27FC236}">
                  <a16:creationId xmlns:a16="http://schemas.microsoft.com/office/drawing/2014/main" id="{643B7239-BEC3-8E4C-B42F-F0AEE57162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79934" y="5918785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kumimoji="1" lang="ja-JP" altLang="ja-JP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1" name="Rectangle 96">
              <a:extLst>
                <a:ext uri="{FF2B5EF4-FFF2-40B4-BE49-F238E27FC236}">
                  <a16:creationId xmlns:a16="http://schemas.microsoft.com/office/drawing/2014/main" id="{5F669E21-9C24-494F-A4A4-2B1AE6D6934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26059" y="5918785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endParaRPr kumimoji="1" lang="ja-JP" altLang="ja-JP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2" name="Rectangle 97">
              <a:extLst>
                <a:ext uri="{FF2B5EF4-FFF2-40B4-BE49-F238E27FC236}">
                  <a16:creationId xmlns:a16="http://schemas.microsoft.com/office/drawing/2014/main" id="{8CCF5AC3-F21B-E14F-A45B-15DBC5C6F78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40434" y="5918785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endParaRPr kumimoji="1" lang="ja-JP" altLang="ja-JP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3" name="Rectangle 98">
              <a:extLst>
                <a:ext uri="{FF2B5EF4-FFF2-40B4-BE49-F238E27FC236}">
                  <a16:creationId xmlns:a16="http://schemas.microsoft.com/office/drawing/2014/main" id="{62F8C704-AEFF-6948-9A37-5DDDCBB87F3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56396" y="5918785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1" lang="ja-JP" altLang="ja-JP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4" name="Rectangle 99">
              <a:extLst>
                <a:ext uri="{FF2B5EF4-FFF2-40B4-BE49-F238E27FC236}">
                  <a16:creationId xmlns:a16="http://schemas.microsoft.com/office/drawing/2014/main" id="{2D1EAE37-C8D6-0F4E-B0B5-F1AB435E8DA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70771" y="5918785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ja-JP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5" name="Rectangle 100">
              <a:extLst>
                <a:ext uri="{FF2B5EF4-FFF2-40B4-BE49-F238E27FC236}">
                  <a16:creationId xmlns:a16="http://schemas.microsoft.com/office/drawing/2014/main" id="{7336C8B9-5DE1-8244-A85D-B99FC927279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71909" y="6053722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kumimoji="1" lang="ja-JP" altLang="ja-JP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6" name="Rectangle 101">
              <a:extLst>
                <a:ext uri="{FF2B5EF4-FFF2-40B4-BE49-F238E27FC236}">
                  <a16:creationId xmlns:a16="http://schemas.microsoft.com/office/drawing/2014/main" id="{845F4093-4B53-6D45-A319-543DCD385CA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11684" y="6053722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kumimoji="1" lang="ja-JP" altLang="ja-JP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7" name="Rectangle 102">
              <a:extLst>
                <a:ext uri="{FF2B5EF4-FFF2-40B4-BE49-F238E27FC236}">
                  <a16:creationId xmlns:a16="http://schemas.microsoft.com/office/drawing/2014/main" id="{3D3978ED-1E61-2A41-98CC-5B73A93AC0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26059" y="6053722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1" lang="ja-JP" altLang="ja-JP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8" name="Rectangle 103">
              <a:extLst>
                <a:ext uri="{FF2B5EF4-FFF2-40B4-BE49-F238E27FC236}">
                  <a16:creationId xmlns:a16="http://schemas.microsoft.com/office/drawing/2014/main" id="{7990755C-B1F5-5145-A7A7-8CA42CB109C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40434" y="6053722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1" lang="ja-JP" altLang="ja-JP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9" name="Rectangle 104">
              <a:extLst>
                <a:ext uri="{FF2B5EF4-FFF2-40B4-BE49-F238E27FC236}">
                  <a16:creationId xmlns:a16="http://schemas.microsoft.com/office/drawing/2014/main" id="{18BEE8BC-D1E8-5A40-90D5-8F17E1ECC43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56396" y="6053722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ja-JP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0" name="Rectangle 105">
              <a:extLst>
                <a:ext uri="{FF2B5EF4-FFF2-40B4-BE49-F238E27FC236}">
                  <a16:creationId xmlns:a16="http://schemas.microsoft.com/office/drawing/2014/main" id="{B9479435-37FF-1043-A469-1F7D516A4C1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70771" y="6053722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ja-JP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1" name="Rectangle 106">
              <a:extLst>
                <a:ext uri="{FF2B5EF4-FFF2-40B4-BE49-F238E27FC236}">
                  <a16:creationId xmlns:a16="http://schemas.microsoft.com/office/drawing/2014/main" id="{49DC825C-1622-2248-B34F-030A83D6BC8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71909" y="6188660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7</a:t>
              </a:r>
              <a:endParaRPr kumimoji="1" lang="ja-JP" altLang="ja-JP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2" name="Rectangle 107">
              <a:extLst>
                <a:ext uri="{FF2B5EF4-FFF2-40B4-BE49-F238E27FC236}">
                  <a16:creationId xmlns:a16="http://schemas.microsoft.com/office/drawing/2014/main" id="{D249B4ED-13DF-024F-BBB3-AE5A3ADF8E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11684" y="6188660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endParaRPr kumimoji="1" lang="ja-JP" altLang="ja-JP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3" name="Rectangle 108">
              <a:extLst>
                <a:ext uri="{FF2B5EF4-FFF2-40B4-BE49-F238E27FC236}">
                  <a16:creationId xmlns:a16="http://schemas.microsoft.com/office/drawing/2014/main" id="{E0C8A516-7431-9E48-A0F0-9E5305F85A8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26059" y="6188660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1" lang="ja-JP" altLang="ja-JP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4" name="Rectangle 109">
              <a:extLst>
                <a:ext uri="{FF2B5EF4-FFF2-40B4-BE49-F238E27FC236}">
                  <a16:creationId xmlns:a16="http://schemas.microsoft.com/office/drawing/2014/main" id="{E4EA4E17-8EDF-E84B-A63A-B43111CECF4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40434" y="6188660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ja-JP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5" name="Rectangle 110">
              <a:extLst>
                <a:ext uri="{FF2B5EF4-FFF2-40B4-BE49-F238E27FC236}">
                  <a16:creationId xmlns:a16="http://schemas.microsoft.com/office/drawing/2014/main" id="{FCC13528-371B-094F-B340-B9339C9F05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56396" y="6188660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ja-JP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6" name="Rectangle 111">
              <a:extLst>
                <a:ext uri="{FF2B5EF4-FFF2-40B4-BE49-F238E27FC236}">
                  <a16:creationId xmlns:a16="http://schemas.microsoft.com/office/drawing/2014/main" id="{05DC6A03-72AF-8C48-8382-2581D0DFA33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70771" y="6188660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ja-JP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658" name="Rectangle 108">
            <a:extLst>
              <a:ext uri="{FF2B5EF4-FFF2-40B4-BE49-F238E27FC236}">
                <a16:creationId xmlns:a16="http://schemas.microsoft.com/office/drawing/2014/main" id="{6DC15D6D-C580-1A4B-A323-CC8ABAC8C040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441" y="5189267"/>
            <a:ext cx="21480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LD</a:t>
            </a:r>
            <a:endParaRPr kumimoji="1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9" name="Rectangle 109">
            <a:extLst>
              <a:ext uri="{FF2B5EF4-FFF2-40B4-BE49-F238E27FC236}">
                <a16:creationId xmlns:a16="http://schemas.microsoft.com/office/drawing/2014/main" id="{887FDC2A-7E02-CC4E-9261-E4109E5564A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296" y="5406132"/>
            <a:ext cx="1462959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IrAEs-non-ILD</a:t>
            </a:r>
            <a:endParaRPr kumimoji="1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0" name="Rectangle 107">
            <a:extLst>
              <a:ext uri="{FF2B5EF4-FFF2-40B4-BE49-F238E27FC236}">
                <a16:creationId xmlns:a16="http://schemas.microsoft.com/office/drawing/2014/main" id="{EE97766B-7A86-A641-8B42-E134028DE6E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368" y="5013201"/>
            <a:ext cx="1029923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Non-irAEs</a:t>
            </a:r>
            <a:endParaRPr kumimoji="1" lang="ja-JP" altLang="ja-JP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61" name="グループ化 660">
            <a:extLst>
              <a:ext uri="{FF2B5EF4-FFF2-40B4-BE49-F238E27FC236}">
                <a16:creationId xmlns:a16="http://schemas.microsoft.com/office/drawing/2014/main" id="{57E8746C-22ED-374F-AFE6-65406C0E52A5}"/>
              </a:ext>
            </a:extLst>
          </p:cNvPr>
          <p:cNvGrpSpPr/>
          <p:nvPr/>
        </p:nvGrpSpPr>
        <p:grpSpPr>
          <a:xfrm>
            <a:off x="4520614" y="5006767"/>
            <a:ext cx="1462959" cy="576383"/>
            <a:chOff x="2120967" y="2931083"/>
            <a:chExt cx="1462959" cy="576383"/>
          </a:xfrm>
        </p:grpSpPr>
        <p:sp>
          <p:nvSpPr>
            <p:cNvPr id="662" name="Rectangle 108">
              <a:extLst>
                <a:ext uri="{FF2B5EF4-FFF2-40B4-BE49-F238E27FC236}">
                  <a16:creationId xmlns:a16="http://schemas.microsoft.com/office/drawing/2014/main" id="{CB58E479-3A62-5449-B6FC-990B8C3C58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20967" y="3136927"/>
              <a:ext cx="21480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LD</a:t>
              </a:r>
              <a:endParaRPr kumimoji="1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3" name="Rectangle 109">
              <a:extLst>
                <a:ext uri="{FF2B5EF4-FFF2-40B4-BE49-F238E27FC236}">
                  <a16:creationId xmlns:a16="http://schemas.microsoft.com/office/drawing/2014/main" id="{41FF98AF-8ADC-654C-A631-AC04FF28DD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20967" y="3353578"/>
              <a:ext cx="146295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en-US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IrAEs-non-ILD</a:t>
              </a:r>
              <a:endParaRPr kumimoji="1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4" name="Rectangle 107">
              <a:extLst>
                <a:ext uri="{FF2B5EF4-FFF2-40B4-BE49-F238E27FC236}">
                  <a16:creationId xmlns:a16="http://schemas.microsoft.com/office/drawing/2014/main" id="{D13B9369-A703-F040-8B55-5CB92EC024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26629" y="2931083"/>
              <a:ext cx="102992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en-US" altLang="ja-JP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on-irAEs</a:t>
              </a:r>
              <a:endParaRPr kumimoji="1" lang="ja-JP" altLang="ja-JP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665" name="正方形/長方形 664">
            <a:extLst>
              <a:ext uri="{FF2B5EF4-FFF2-40B4-BE49-F238E27FC236}">
                <a16:creationId xmlns:a16="http://schemas.microsoft.com/office/drawing/2014/main" id="{08695D23-1AE0-1344-A2AF-22010E7A9B5F}"/>
              </a:ext>
            </a:extLst>
          </p:cNvPr>
          <p:cNvSpPr/>
          <p:nvPr/>
        </p:nvSpPr>
        <p:spPr>
          <a:xfrm>
            <a:off x="58091" y="245781"/>
            <a:ext cx="304744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b="1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</a:rPr>
              <a:t>Supplementary</a:t>
            </a:r>
            <a:r>
              <a:rPr lang="en-US" altLang="ja-JP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</a:rPr>
              <a:t> </a:t>
            </a:r>
            <a:r>
              <a:rPr lang="en-US" altLang="ja-JP" b="1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gure 2 </a:t>
            </a:r>
            <a:endParaRPr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ja-JP" altLang="en-US" dirty="0"/>
          </a:p>
        </p:txBody>
      </p:sp>
      <p:sp>
        <p:nvSpPr>
          <p:cNvPr id="666" name="テキスト ボックス 665">
            <a:extLst>
              <a:ext uri="{FF2B5EF4-FFF2-40B4-BE49-F238E27FC236}">
                <a16:creationId xmlns:a16="http://schemas.microsoft.com/office/drawing/2014/main" id="{13E679A5-7343-F646-9B92-409F2C79C336}"/>
              </a:ext>
            </a:extLst>
          </p:cNvPr>
          <p:cNvSpPr txBox="1"/>
          <p:nvPr/>
        </p:nvSpPr>
        <p:spPr>
          <a:xfrm>
            <a:off x="1038689" y="1496699"/>
            <a:ext cx="29626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Untreated</a:t>
            </a:r>
            <a:endParaRPr kumimoji="1" lang="ja-JP" altLang="en-US" sz="1200" b="1" u="sng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7" name="テキスト ボックス 666">
            <a:extLst>
              <a:ext uri="{FF2B5EF4-FFF2-40B4-BE49-F238E27FC236}">
                <a16:creationId xmlns:a16="http://schemas.microsoft.com/office/drawing/2014/main" id="{2561E9AE-E190-C842-A1CE-37B17741A4D1}"/>
              </a:ext>
            </a:extLst>
          </p:cNvPr>
          <p:cNvSpPr txBox="1"/>
          <p:nvPr/>
        </p:nvSpPr>
        <p:spPr>
          <a:xfrm>
            <a:off x="5921133" y="1496699"/>
            <a:ext cx="29626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viously treated</a:t>
            </a:r>
            <a:endParaRPr kumimoji="1" lang="ja-JP" altLang="en-US" sz="1200" b="1" u="sng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8" name="Rectangle 108">
            <a:extLst>
              <a:ext uri="{FF2B5EF4-FFF2-40B4-BE49-F238E27FC236}">
                <a16:creationId xmlns:a16="http://schemas.microsoft.com/office/drawing/2014/main" id="{8868CC95-EF98-6C41-998E-BB89F51FBBD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54483" y="2823760"/>
            <a:ext cx="14507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dian 8.7m (0.9-NA) </a:t>
            </a:r>
            <a:endParaRPr kumimoji="1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9" name="Rectangle 108">
            <a:extLst>
              <a:ext uri="{FF2B5EF4-FFF2-40B4-BE49-F238E27FC236}">
                <a16:creationId xmlns:a16="http://schemas.microsoft.com/office/drawing/2014/main" id="{2DABD9AA-3339-1744-8086-FC017D02858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53074" y="2117997"/>
            <a:ext cx="152766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dian 15.9m (1.2-NA) </a:t>
            </a:r>
            <a:endParaRPr kumimoji="1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0" name="Rectangle 108">
            <a:extLst>
              <a:ext uri="{FF2B5EF4-FFF2-40B4-BE49-F238E27FC236}">
                <a16:creationId xmlns:a16="http://schemas.microsoft.com/office/drawing/2014/main" id="{B65CECC9-70A9-AF46-87F2-FC2576D97F8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53074" y="2472048"/>
            <a:ext cx="135133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dian NR (3.8-NA) </a:t>
            </a:r>
            <a:endParaRPr kumimoji="1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1" name="Rectangle 108">
            <a:extLst>
              <a:ext uri="{FF2B5EF4-FFF2-40B4-BE49-F238E27FC236}">
                <a16:creationId xmlns:a16="http://schemas.microsoft.com/office/drawing/2014/main" id="{B34C9532-CB17-8A46-A761-0C41E392DDA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26661" y="2390537"/>
            <a:ext cx="152766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dian 15.9m (0.3-NA) </a:t>
            </a:r>
            <a:endParaRPr kumimoji="1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2" name="Rectangle 108">
            <a:extLst>
              <a:ext uri="{FF2B5EF4-FFF2-40B4-BE49-F238E27FC236}">
                <a16:creationId xmlns:a16="http://schemas.microsoft.com/office/drawing/2014/main" id="{8AD95F42-66E3-CE4B-BBDA-C67B349A2C2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26661" y="3130456"/>
            <a:ext cx="142186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dian 3.1m (2.1-5.9) </a:t>
            </a:r>
            <a:endParaRPr kumimoji="1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3" name="Rectangle 108">
            <a:extLst>
              <a:ext uri="{FF2B5EF4-FFF2-40B4-BE49-F238E27FC236}">
                <a16:creationId xmlns:a16="http://schemas.microsoft.com/office/drawing/2014/main" id="{69460CB3-A042-9446-85B2-82C5F221513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42621" y="2772976"/>
            <a:ext cx="149880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dian 5.4m (1.9-12.4) </a:t>
            </a:r>
            <a:endParaRPr kumimoji="1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4396890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コンテンツ プレースホルダー 3">
            <a:extLst>
              <a:ext uri="{FF2B5EF4-FFF2-40B4-BE49-F238E27FC236}">
                <a16:creationId xmlns:a16="http://schemas.microsoft.com/office/drawing/2014/main" id="{B60349A8-1A6E-B148-8D25-042CADDD8CE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6069" t="18868" r="4678" b="25537"/>
          <a:stretch/>
        </p:blipFill>
        <p:spPr>
          <a:xfrm>
            <a:off x="4874932" y="2546430"/>
            <a:ext cx="3982917" cy="2662178"/>
          </a:xfrm>
          <a:prstGeom prst="rect">
            <a:avLst/>
          </a:prstGeom>
        </p:spPr>
      </p:pic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6A89B102-0545-534C-8089-66785119788E}"/>
              </a:ext>
            </a:extLst>
          </p:cNvPr>
          <p:cNvSpPr/>
          <p:nvPr/>
        </p:nvSpPr>
        <p:spPr>
          <a:xfrm>
            <a:off x="81240" y="523573"/>
            <a:ext cx="304744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b="1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</a:rPr>
              <a:t>Supplementary</a:t>
            </a:r>
            <a:r>
              <a:rPr lang="en-US" altLang="ja-JP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</a:rPr>
              <a:t> </a:t>
            </a:r>
            <a:r>
              <a:rPr lang="en-US" altLang="ja-JP" b="1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gure 3</a:t>
            </a:r>
            <a:endParaRPr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4863F232-5643-CE46-AA4F-0A867D3430E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5817" t="18371" r="5441" b="19048"/>
          <a:stretch/>
        </p:blipFill>
        <p:spPr>
          <a:xfrm>
            <a:off x="372379" y="2546430"/>
            <a:ext cx="3982917" cy="2662178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8C9AA4B1-F557-2B44-9D9F-828BFB97AC58}"/>
              </a:ext>
            </a:extLst>
          </p:cNvPr>
          <p:cNvSpPr txBox="1"/>
          <p:nvPr/>
        </p:nvSpPr>
        <p:spPr>
          <a:xfrm>
            <a:off x="4719560" y="1950737"/>
            <a:ext cx="4442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17254FED-8E2E-0342-8BBB-69E70DACF95B}"/>
              </a:ext>
            </a:extLst>
          </p:cNvPr>
          <p:cNvSpPr txBox="1"/>
          <p:nvPr/>
        </p:nvSpPr>
        <p:spPr>
          <a:xfrm>
            <a:off x="304921" y="1950737"/>
            <a:ext cx="4442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0979902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正方形/長方形 58">
            <a:extLst>
              <a:ext uri="{FF2B5EF4-FFF2-40B4-BE49-F238E27FC236}">
                <a16:creationId xmlns:a16="http://schemas.microsoft.com/office/drawing/2014/main" id="{0F58EC83-AF3F-594B-B8F5-517D5DA98B1C}"/>
              </a:ext>
            </a:extLst>
          </p:cNvPr>
          <p:cNvSpPr/>
          <p:nvPr/>
        </p:nvSpPr>
        <p:spPr>
          <a:xfrm>
            <a:off x="58091" y="245781"/>
            <a:ext cx="304744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b="1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</a:rPr>
              <a:t>Supplementary</a:t>
            </a:r>
            <a:r>
              <a:rPr lang="en-US" altLang="ja-JP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</a:rPr>
              <a:t> </a:t>
            </a:r>
            <a:r>
              <a:rPr lang="en-US" altLang="ja-JP" b="1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gure 4</a:t>
            </a:r>
            <a:endParaRPr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AutoShape 4">
            <a:extLst>
              <a:ext uri="{FF2B5EF4-FFF2-40B4-BE49-F238E27FC236}">
                <a16:creationId xmlns:a16="http://schemas.microsoft.com/office/drawing/2014/main" id="{8794E87F-4FEB-C941-B628-D0EDDB43374D}"/>
              </a:ext>
            </a:extLst>
          </p:cNvPr>
          <p:cNvSpPr>
            <a:spLocks noChangeAspect="1" noChangeArrowheads="1" noTextEdit="1"/>
          </p:cNvSpPr>
          <p:nvPr/>
        </p:nvSpPr>
        <p:spPr bwMode="auto">
          <a:xfrm>
            <a:off x="904293" y="799779"/>
            <a:ext cx="6536168" cy="536143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010AB925-B7C7-1D4E-8902-2F924F94C6FF}"/>
              </a:ext>
            </a:extLst>
          </p:cNvPr>
          <p:cNvGrpSpPr/>
          <p:nvPr/>
        </p:nvGrpSpPr>
        <p:grpSpPr>
          <a:xfrm>
            <a:off x="744777" y="1422088"/>
            <a:ext cx="7625094" cy="4786108"/>
            <a:chOff x="744777" y="1422088"/>
            <a:chExt cx="7625094" cy="4786108"/>
          </a:xfrm>
        </p:grpSpPr>
        <p:sp>
          <p:nvSpPr>
            <p:cNvPr id="62" name="Rectangle 108">
              <a:extLst>
                <a:ext uri="{FF2B5EF4-FFF2-40B4-BE49-F238E27FC236}">
                  <a16:creationId xmlns:a16="http://schemas.microsoft.com/office/drawing/2014/main" id="{4EE145E6-30E0-424D-BAC4-2804956C82B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94119" y="1930164"/>
              <a:ext cx="157575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defPPr>
                <a:defRPr lang="ja-JP"/>
              </a:defPPr>
              <a:lvl1pPr marL="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edian 17.9m (5.0-18.8) </a:t>
              </a:r>
              <a:endParaRPr kumimoji="1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" name="Rectangle 108">
              <a:extLst>
                <a:ext uri="{FF2B5EF4-FFF2-40B4-BE49-F238E27FC236}">
                  <a16:creationId xmlns:a16="http://schemas.microsoft.com/office/drawing/2014/main" id="{8F65F26F-F13E-F040-A27A-622CC096E84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13444" y="2283376"/>
              <a:ext cx="1527662" cy="2018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defPPr>
                <a:defRPr lang="ja-JP"/>
              </a:defPPr>
              <a:lvl1pPr marL="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edian 15.9m (0.3-NA) </a:t>
              </a:r>
              <a:endParaRPr kumimoji="1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" name="Rectangle 58">
              <a:extLst>
                <a:ext uri="{FF2B5EF4-FFF2-40B4-BE49-F238E27FC236}">
                  <a16:creationId xmlns:a16="http://schemas.microsoft.com/office/drawing/2014/main" id="{8526114C-DCB5-054D-914C-CEE3D12FA2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4777" y="6023530"/>
              <a:ext cx="101220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on-OP pattern </a:t>
              </a:r>
              <a:endParaRPr kumimoji="1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" name="Rectangle 58">
              <a:extLst>
                <a:ext uri="{FF2B5EF4-FFF2-40B4-BE49-F238E27FC236}">
                  <a16:creationId xmlns:a16="http://schemas.microsoft.com/office/drawing/2014/main" id="{66781220-6F80-E348-809A-6F671DFF8E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60568" y="5830721"/>
              <a:ext cx="69640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P pattern </a:t>
              </a:r>
              <a:endParaRPr kumimoji="1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1" name="Line 6">
              <a:extLst>
                <a:ext uri="{FF2B5EF4-FFF2-40B4-BE49-F238E27FC236}">
                  <a16:creationId xmlns:a16="http://schemas.microsoft.com/office/drawing/2014/main" id="{8EC09990-2634-314F-8161-6B67B5F1AE4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42287" y="5004357"/>
              <a:ext cx="4522795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2" name="Line 7">
              <a:extLst>
                <a:ext uri="{FF2B5EF4-FFF2-40B4-BE49-F238E27FC236}">
                  <a16:creationId xmlns:a16="http://schemas.microsoft.com/office/drawing/2014/main" id="{D1E072FC-4E97-BD4F-941F-BDBC9545410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42287" y="5004357"/>
              <a:ext cx="0" cy="71805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3" name="Line 8">
              <a:extLst>
                <a:ext uri="{FF2B5EF4-FFF2-40B4-BE49-F238E27FC236}">
                  <a16:creationId xmlns:a16="http://schemas.microsoft.com/office/drawing/2014/main" id="{5FA7380C-5F7F-FD4C-8F34-0A5712AB7C4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84232" y="5004357"/>
              <a:ext cx="0" cy="71805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" name="Line 9">
              <a:extLst>
                <a:ext uri="{FF2B5EF4-FFF2-40B4-BE49-F238E27FC236}">
                  <a16:creationId xmlns:a16="http://schemas.microsoft.com/office/drawing/2014/main" id="{06020FE9-33F3-6C41-A6AC-E2BAA292A59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35903" y="5004357"/>
              <a:ext cx="0" cy="71805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" name="Line 10">
              <a:extLst>
                <a:ext uri="{FF2B5EF4-FFF2-40B4-BE49-F238E27FC236}">
                  <a16:creationId xmlns:a16="http://schemas.microsoft.com/office/drawing/2014/main" id="{36B18E22-BD0B-2E4B-B7FE-CDF4C68C78E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77848" y="5004357"/>
              <a:ext cx="0" cy="71805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" name="Line 11">
              <a:extLst>
                <a:ext uri="{FF2B5EF4-FFF2-40B4-BE49-F238E27FC236}">
                  <a16:creationId xmlns:a16="http://schemas.microsoft.com/office/drawing/2014/main" id="{F950F186-9A82-334B-83B5-FAF431B441C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29520" y="5004357"/>
              <a:ext cx="0" cy="71805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" name="Line 12">
              <a:extLst>
                <a:ext uri="{FF2B5EF4-FFF2-40B4-BE49-F238E27FC236}">
                  <a16:creationId xmlns:a16="http://schemas.microsoft.com/office/drawing/2014/main" id="{E12E420B-889E-D74A-B0B0-BCDAF0089E3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71465" y="5004357"/>
              <a:ext cx="0" cy="71805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" name="Line 13">
              <a:extLst>
                <a:ext uri="{FF2B5EF4-FFF2-40B4-BE49-F238E27FC236}">
                  <a16:creationId xmlns:a16="http://schemas.microsoft.com/office/drawing/2014/main" id="{63B337CB-56F5-DA4A-9717-ECD3B084901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913410" y="5004357"/>
              <a:ext cx="0" cy="71805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" name="Line 14">
              <a:extLst>
                <a:ext uri="{FF2B5EF4-FFF2-40B4-BE49-F238E27FC236}">
                  <a16:creationId xmlns:a16="http://schemas.microsoft.com/office/drawing/2014/main" id="{A42F2762-3190-CC4E-AE93-5B5313A7F56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565081" y="5004357"/>
              <a:ext cx="0" cy="71805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" name="Rectangle 15">
              <a:extLst>
                <a:ext uri="{FF2B5EF4-FFF2-40B4-BE49-F238E27FC236}">
                  <a16:creationId xmlns:a16="http://schemas.microsoft.com/office/drawing/2014/main" id="{EF6662F7-0963-3C4B-8B54-44F1E72E5E3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64475" y="5171902"/>
              <a:ext cx="94022" cy="1848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" name="Rectangle 16">
              <a:extLst>
                <a:ext uri="{FF2B5EF4-FFF2-40B4-BE49-F238E27FC236}">
                  <a16:creationId xmlns:a16="http://schemas.microsoft.com/office/drawing/2014/main" id="{9182F267-3586-E54E-9204-47E8A4FD79A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06420" y="5171902"/>
              <a:ext cx="94022" cy="1848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kumimoji="1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" name="Rectangle 17">
              <a:extLst>
                <a:ext uri="{FF2B5EF4-FFF2-40B4-BE49-F238E27FC236}">
                  <a16:creationId xmlns:a16="http://schemas.microsoft.com/office/drawing/2014/main" id="{765641B4-1415-5349-B2BE-1EDF4892CC0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14323" y="5171902"/>
              <a:ext cx="188045" cy="1848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kumimoji="1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" name="Rectangle 18">
              <a:extLst>
                <a:ext uri="{FF2B5EF4-FFF2-40B4-BE49-F238E27FC236}">
                  <a16:creationId xmlns:a16="http://schemas.microsoft.com/office/drawing/2014/main" id="{6C13635D-3658-E540-B264-30C062E77E8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56268" y="5171902"/>
              <a:ext cx="188045" cy="1848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kumimoji="1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" name="Rectangle 19">
              <a:extLst>
                <a:ext uri="{FF2B5EF4-FFF2-40B4-BE49-F238E27FC236}">
                  <a16:creationId xmlns:a16="http://schemas.microsoft.com/office/drawing/2014/main" id="{D4DE2C2B-4204-8C43-8491-36130B461C5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07939" y="5171902"/>
              <a:ext cx="188045" cy="1848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</a:t>
              </a:r>
              <a:endParaRPr kumimoji="1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" name="Rectangle 20">
              <a:extLst>
                <a:ext uri="{FF2B5EF4-FFF2-40B4-BE49-F238E27FC236}">
                  <a16:creationId xmlns:a16="http://schemas.microsoft.com/office/drawing/2014/main" id="{FDB8A006-9F6E-FC43-90AF-90BE5DBDFC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49884" y="5171902"/>
              <a:ext cx="188045" cy="1848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kumimoji="1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" name="Rectangle 21">
              <a:extLst>
                <a:ext uri="{FF2B5EF4-FFF2-40B4-BE49-F238E27FC236}">
                  <a16:creationId xmlns:a16="http://schemas.microsoft.com/office/drawing/2014/main" id="{BE8AC68B-432A-2543-A069-B04CC03845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91829" y="5171902"/>
              <a:ext cx="188045" cy="1848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0</a:t>
              </a:r>
              <a:endParaRPr kumimoji="1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" name="Rectangle 22">
              <a:extLst>
                <a:ext uri="{FF2B5EF4-FFF2-40B4-BE49-F238E27FC236}">
                  <a16:creationId xmlns:a16="http://schemas.microsoft.com/office/drawing/2014/main" id="{87C92D83-5634-2242-9DB2-752B4F44CF9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43501" y="5171902"/>
              <a:ext cx="188045" cy="1848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5</a:t>
              </a:r>
              <a:endParaRPr kumimoji="1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8" name="Line 23">
              <a:extLst>
                <a:ext uri="{FF2B5EF4-FFF2-40B4-BE49-F238E27FC236}">
                  <a16:creationId xmlns:a16="http://schemas.microsoft.com/office/drawing/2014/main" id="{F5E1DB98-C584-9A4B-B777-74B0B5CFB53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042287" y="1557720"/>
              <a:ext cx="0" cy="3311005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" name="Line 24">
              <a:extLst>
                <a:ext uri="{FF2B5EF4-FFF2-40B4-BE49-F238E27FC236}">
                  <a16:creationId xmlns:a16="http://schemas.microsoft.com/office/drawing/2014/main" id="{793A3070-EF82-AF44-9639-78D1677D573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945022" y="4868725"/>
              <a:ext cx="9726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" name="Line 25">
              <a:extLst>
                <a:ext uri="{FF2B5EF4-FFF2-40B4-BE49-F238E27FC236}">
                  <a16:creationId xmlns:a16="http://schemas.microsoft.com/office/drawing/2014/main" id="{1E0C74FA-6053-E84A-8E7F-3EF8D6BFDDD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945022" y="4206524"/>
              <a:ext cx="9726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1" name="Line 26">
              <a:extLst>
                <a:ext uri="{FF2B5EF4-FFF2-40B4-BE49-F238E27FC236}">
                  <a16:creationId xmlns:a16="http://schemas.microsoft.com/office/drawing/2014/main" id="{40802F63-B697-B64E-9476-AC96B40C738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945022" y="3544323"/>
              <a:ext cx="9726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" name="Line 27">
              <a:extLst>
                <a:ext uri="{FF2B5EF4-FFF2-40B4-BE49-F238E27FC236}">
                  <a16:creationId xmlns:a16="http://schemas.microsoft.com/office/drawing/2014/main" id="{BDEE7682-2510-D542-8B5B-03463280D30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945022" y="2882122"/>
              <a:ext cx="9726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" name="Line 28">
              <a:extLst>
                <a:ext uri="{FF2B5EF4-FFF2-40B4-BE49-F238E27FC236}">
                  <a16:creationId xmlns:a16="http://schemas.microsoft.com/office/drawing/2014/main" id="{2DA86002-7C23-7D4A-B81F-E0D1BE1D9C1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945022" y="2219921"/>
              <a:ext cx="9726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" name="Line 29">
              <a:extLst>
                <a:ext uri="{FF2B5EF4-FFF2-40B4-BE49-F238E27FC236}">
                  <a16:creationId xmlns:a16="http://schemas.microsoft.com/office/drawing/2014/main" id="{AB1AD629-FB9C-254A-BE13-67FCBD58BBB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945022" y="1557720"/>
              <a:ext cx="9726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5" name="Rectangle 30">
              <a:extLst>
                <a:ext uri="{FF2B5EF4-FFF2-40B4-BE49-F238E27FC236}">
                  <a16:creationId xmlns:a16="http://schemas.microsoft.com/office/drawing/2014/main" id="{7538141B-1EA6-554D-A86C-8C0D37814F7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65691" y="4812877"/>
              <a:ext cx="235056" cy="1848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</a:t>
              </a:r>
              <a:endParaRPr kumimoji="1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6" name="Rectangle 31">
              <a:extLst>
                <a:ext uri="{FF2B5EF4-FFF2-40B4-BE49-F238E27FC236}">
                  <a16:creationId xmlns:a16="http://schemas.microsoft.com/office/drawing/2014/main" id="{9D74F358-1AEB-394C-8646-23B72EAF963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65691" y="4150676"/>
              <a:ext cx="235056" cy="1848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  <a:endParaRPr kumimoji="1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7" name="Rectangle 32">
              <a:extLst>
                <a:ext uri="{FF2B5EF4-FFF2-40B4-BE49-F238E27FC236}">
                  <a16:creationId xmlns:a16="http://schemas.microsoft.com/office/drawing/2014/main" id="{DE9AB1EB-BC6B-6D42-9967-BA29589262D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65691" y="3488475"/>
              <a:ext cx="235056" cy="1848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  <a:endParaRPr kumimoji="1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8" name="Rectangle 33">
              <a:extLst>
                <a:ext uri="{FF2B5EF4-FFF2-40B4-BE49-F238E27FC236}">
                  <a16:creationId xmlns:a16="http://schemas.microsoft.com/office/drawing/2014/main" id="{58E5C3DC-FF5F-4146-A294-A114FCFF71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65691" y="2826274"/>
              <a:ext cx="235056" cy="1848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6</a:t>
              </a:r>
              <a:endParaRPr kumimoji="1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9" name="Rectangle 34">
              <a:extLst>
                <a:ext uri="{FF2B5EF4-FFF2-40B4-BE49-F238E27FC236}">
                  <a16:creationId xmlns:a16="http://schemas.microsoft.com/office/drawing/2014/main" id="{A14BE998-C864-1144-9209-6A117402F2B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65691" y="2164073"/>
              <a:ext cx="235056" cy="1848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8</a:t>
              </a:r>
              <a:endParaRPr kumimoji="1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0" name="Rectangle 35">
              <a:extLst>
                <a:ext uri="{FF2B5EF4-FFF2-40B4-BE49-F238E27FC236}">
                  <a16:creationId xmlns:a16="http://schemas.microsoft.com/office/drawing/2014/main" id="{FE356072-5785-3347-9516-DC745D61B03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65691" y="1501872"/>
              <a:ext cx="235056" cy="1848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0</a:t>
              </a:r>
              <a:endParaRPr kumimoji="1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1" name="Freeform 36">
              <a:extLst>
                <a:ext uri="{FF2B5EF4-FFF2-40B4-BE49-F238E27FC236}">
                  <a16:creationId xmlns:a16="http://schemas.microsoft.com/office/drawing/2014/main" id="{3437E0A2-B4D6-5F45-9533-FC6620487675}"/>
                </a:ext>
              </a:extLst>
            </p:cNvPr>
            <p:cNvSpPr>
              <a:spLocks/>
            </p:cNvSpPr>
            <p:nvPr/>
          </p:nvSpPr>
          <p:spPr bwMode="auto">
            <a:xfrm>
              <a:off x="2042287" y="1422088"/>
              <a:ext cx="5009117" cy="3582268"/>
            </a:xfrm>
            <a:custGeom>
              <a:avLst/>
              <a:gdLst>
                <a:gd name="T0" fmla="*/ 0 w 515"/>
                <a:gd name="T1" fmla="*/ 0 h 449"/>
                <a:gd name="T2" fmla="*/ 0 w 515"/>
                <a:gd name="T3" fmla="*/ 449 h 449"/>
                <a:gd name="T4" fmla="*/ 515 w 515"/>
                <a:gd name="T5" fmla="*/ 449 h 4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5" h="449">
                  <a:moveTo>
                    <a:pt x="0" y="0"/>
                  </a:moveTo>
                  <a:lnTo>
                    <a:pt x="0" y="449"/>
                  </a:lnTo>
                  <a:lnTo>
                    <a:pt x="515" y="449"/>
                  </a:lnTo>
                </a:path>
              </a:pathLst>
            </a:cu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" name="Freeform 39">
              <a:extLst>
                <a:ext uri="{FF2B5EF4-FFF2-40B4-BE49-F238E27FC236}">
                  <a16:creationId xmlns:a16="http://schemas.microsoft.com/office/drawing/2014/main" id="{E5E91D7A-0221-4A42-9D05-DF6B7C6E61EE}"/>
                </a:ext>
              </a:extLst>
            </p:cNvPr>
            <p:cNvSpPr>
              <a:spLocks/>
            </p:cNvSpPr>
            <p:nvPr/>
          </p:nvSpPr>
          <p:spPr bwMode="auto">
            <a:xfrm>
              <a:off x="2042287" y="1557720"/>
              <a:ext cx="2023100" cy="3311005"/>
            </a:xfrm>
            <a:custGeom>
              <a:avLst/>
              <a:gdLst>
                <a:gd name="T0" fmla="*/ 0 w 208"/>
                <a:gd name="T1" fmla="*/ 0 h 415"/>
                <a:gd name="T2" fmla="*/ 4 w 208"/>
                <a:gd name="T3" fmla="*/ 0 h 415"/>
                <a:gd name="T4" fmla="*/ 4 w 208"/>
                <a:gd name="T5" fmla="*/ 59 h 415"/>
                <a:gd name="T6" fmla="*/ 16 w 208"/>
                <a:gd name="T7" fmla="*/ 59 h 415"/>
                <a:gd name="T8" fmla="*/ 16 w 208"/>
                <a:gd name="T9" fmla="*/ 178 h 415"/>
                <a:gd name="T10" fmla="*/ 208 w 208"/>
                <a:gd name="T11" fmla="*/ 178 h 415"/>
                <a:gd name="T12" fmla="*/ 208 w 208"/>
                <a:gd name="T13" fmla="*/ 415 h 4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208" h="415">
                  <a:moveTo>
                    <a:pt x="0" y="0"/>
                  </a:moveTo>
                  <a:lnTo>
                    <a:pt x="4" y="0"/>
                  </a:lnTo>
                  <a:lnTo>
                    <a:pt x="4" y="59"/>
                  </a:lnTo>
                  <a:lnTo>
                    <a:pt x="16" y="59"/>
                  </a:lnTo>
                  <a:lnTo>
                    <a:pt x="16" y="178"/>
                  </a:lnTo>
                  <a:lnTo>
                    <a:pt x="208" y="178"/>
                  </a:lnTo>
                  <a:lnTo>
                    <a:pt x="208" y="415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" name="Line 40">
              <a:extLst>
                <a:ext uri="{FF2B5EF4-FFF2-40B4-BE49-F238E27FC236}">
                  <a16:creationId xmlns:a16="http://schemas.microsoft.com/office/drawing/2014/main" id="{2FBD7A24-5D06-6149-951C-80E2D47E7CF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85448" y="2977862"/>
              <a:ext cx="9726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" name="Line 41">
              <a:extLst>
                <a:ext uri="{FF2B5EF4-FFF2-40B4-BE49-F238E27FC236}">
                  <a16:creationId xmlns:a16="http://schemas.microsoft.com/office/drawing/2014/main" id="{6A2DDEBC-FD1E-3248-A071-47B882919EF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34080" y="2937970"/>
              <a:ext cx="0" cy="79783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7" name="Line 42">
              <a:extLst>
                <a:ext uri="{FF2B5EF4-FFF2-40B4-BE49-F238E27FC236}">
                  <a16:creationId xmlns:a16="http://schemas.microsoft.com/office/drawing/2014/main" id="{9CD840F9-921A-D14B-AFAF-8BEB77B8231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92438" y="2977862"/>
              <a:ext cx="9726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8" name="Line 43">
              <a:extLst>
                <a:ext uri="{FF2B5EF4-FFF2-40B4-BE49-F238E27FC236}">
                  <a16:creationId xmlns:a16="http://schemas.microsoft.com/office/drawing/2014/main" id="{6C702A17-372D-5440-8B68-B2401E277CD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41071" y="2937970"/>
              <a:ext cx="0" cy="79783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" name="Line 44">
              <a:extLst>
                <a:ext uri="{FF2B5EF4-FFF2-40B4-BE49-F238E27FC236}">
                  <a16:creationId xmlns:a16="http://schemas.microsoft.com/office/drawing/2014/main" id="{013E7CB0-DF43-DE43-8A36-19D3ABF5349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28912" y="2977862"/>
              <a:ext cx="9726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" name="Line 45">
              <a:extLst>
                <a:ext uri="{FF2B5EF4-FFF2-40B4-BE49-F238E27FC236}">
                  <a16:creationId xmlns:a16="http://schemas.microsoft.com/office/drawing/2014/main" id="{AF67DE56-6C03-9F4E-888A-D398E828AD9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77544" y="2937970"/>
              <a:ext cx="0" cy="79783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1" name="Freeform 46">
              <a:extLst>
                <a:ext uri="{FF2B5EF4-FFF2-40B4-BE49-F238E27FC236}">
                  <a16:creationId xmlns:a16="http://schemas.microsoft.com/office/drawing/2014/main" id="{CAEACCDC-ECEF-B04E-8A7D-8BC1BAB85C66}"/>
                </a:ext>
              </a:extLst>
            </p:cNvPr>
            <p:cNvSpPr>
              <a:spLocks/>
            </p:cNvSpPr>
            <p:nvPr/>
          </p:nvSpPr>
          <p:spPr bwMode="auto">
            <a:xfrm>
              <a:off x="2042287" y="1557720"/>
              <a:ext cx="4814588" cy="2792414"/>
            </a:xfrm>
            <a:custGeom>
              <a:avLst/>
              <a:gdLst>
                <a:gd name="T0" fmla="*/ 0 w 495"/>
                <a:gd name="T1" fmla="*/ 0 h 350"/>
                <a:gd name="T2" fmla="*/ 66 w 495"/>
                <a:gd name="T3" fmla="*/ 0 h 350"/>
                <a:gd name="T4" fmla="*/ 66 w 495"/>
                <a:gd name="T5" fmla="*/ 46 h 350"/>
                <a:gd name="T6" fmla="*/ 80 w 495"/>
                <a:gd name="T7" fmla="*/ 46 h 350"/>
                <a:gd name="T8" fmla="*/ 80 w 495"/>
                <a:gd name="T9" fmla="*/ 92 h 350"/>
                <a:gd name="T10" fmla="*/ 142 w 495"/>
                <a:gd name="T11" fmla="*/ 92 h 350"/>
                <a:gd name="T12" fmla="*/ 142 w 495"/>
                <a:gd name="T13" fmla="*/ 157 h 350"/>
                <a:gd name="T14" fmla="*/ 234 w 495"/>
                <a:gd name="T15" fmla="*/ 157 h 350"/>
                <a:gd name="T16" fmla="*/ 234 w 495"/>
                <a:gd name="T17" fmla="*/ 221 h 350"/>
                <a:gd name="T18" fmla="*/ 235 w 495"/>
                <a:gd name="T19" fmla="*/ 221 h 350"/>
                <a:gd name="T20" fmla="*/ 235 w 495"/>
                <a:gd name="T21" fmla="*/ 286 h 350"/>
                <a:gd name="T22" fmla="*/ 246 w 495"/>
                <a:gd name="T23" fmla="*/ 286 h 350"/>
                <a:gd name="T24" fmla="*/ 246 w 495"/>
                <a:gd name="T25" fmla="*/ 350 h 350"/>
                <a:gd name="T26" fmla="*/ 495 w 495"/>
                <a:gd name="T27" fmla="*/ 350 h 350"/>
                <a:gd name="T28" fmla="*/ 495 w 495"/>
                <a:gd name="T29" fmla="*/ 350 h 3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</a:cxnLst>
              <a:rect l="0" t="0" r="r" b="b"/>
              <a:pathLst>
                <a:path w="495" h="350">
                  <a:moveTo>
                    <a:pt x="0" y="0"/>
                  </a:moveTo>
                  <a:lnTo>
                    <a:pt x="66" y="0"/>
                  </a:lnTo>
                  <a:lnTo>
                    <a:pt x="66" y="46"/>
                  </a:lnTo>
                  <a:lnTo>
                    <a:pt x="80" y="46"/>
                  </a:lnTo>
                  <a:lnTo>
                    <a:pt x="80" y="92"/>
                  </a:lnTo>
                  <a:lnTo>
                    <a:pt x="142" y="92"/>
                  </a:lnTo>
                  <a:lnTo>
                    <a:pt x="142" y="157"/>
                  </a:lnTo>
                  <a:lnTo>
                    <a:pt x="234" y="157"/>
                  </a:lnTo>
                  <a:lnTo>
                    <a:pt x="234" y="221"/>
                  </a:lnTo>
                  <a:lnTo>
                    <a:pt x="235" y="221"/>
                  </a:lnTo>
                  <a:lnTo>
                    <a:pt x="235" y="286"/>
                  </a:lnTo>
                  <a:lnTo>
                    <a:pt x="246" y="286"/>
                  </a:lnTo>
                  <a:lnTo>
                    <a:pt x="246" y="350"/>
                  </a:lnTo>
                  <a:lnTo>
                    <a:pt x="495" y="350"/>
                  </a:lnTo>
                  <a:lnTo>
                    <a:pt x="495" y="350"/>
                  </a:lnTo>
                </a:path>
              </a:pathLst>
            </a:cu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2" name="Line 47">
              <a:extLst>
                <a:ext uri="{FF2B5EF4-FFF2-40B4-BE49-F238E27FC236}">
                  <a16:creationId xmlns:a16="http://schemas.microsoft.com/office/drawing/2014/main" id="{041B465F-6D42-464B-91A6-A6DC3006284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00949" y="2291726"/>
              <a:ext cx="106991" cy="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3" name="Line 48">
              <a:extLst>
                <a:ext uri="{FF2B5EF4-FFF2-40B4-BE49-F238E27FC236}">
                  <a16:creationId xmlns:a16="http://schemas.microsoft.com/office/drawing/2014/main" id="{D554CDA8-F921-F447-8AED-3F604CCD42D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49581" y="2251834"/>
              <a:ext cx="0" cy="79783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4" name="Line 49">
              <a:extLst>
                <a:ext uri="{FF2B5EF4-FFF2-40B4-BE49-F238E27FC236}">
                  <a16:creationId xmlns:a16="http://schemas.microsoft.com/office/drawing/2014/main" id="{AFBD1E83-97BE-724A-8A3D-55878575913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80280" y="2291726"/>
              <a:ext cx="97264" cy="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5" name="Line 50">
              <a:extLst>
                <a:ext uri="{FF2B5EF4-FFF2-40B4-BE49-F238E27FC236}">
                  <a16:creationId xmlns:a16="http://schemas.microsoft.com/office/drawing/2014/main" id="{82CB96CC-D721-E540-B3B1-759E5A7E105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28912" y="2251834"/>
              <a:ext cx="0" cy="79783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6" name="Line 51">
              <a:extLst>
                <a:ext uri="{FF2B5EF4-FFF2-40B4-BE49-F238E27FC236}">
                  <a16:creationId xmlns:a16="http://schemas.microsoft.com/office/drawing/2014/main" id="{D7BE05C9-1B19-7444-B59E-57DEFE84BB0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808242" y="4350134"/>
              <a:ext cx="97264" cy="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7" name="Line 52">
              <a:extLst>
                <a:ext uri="{FF2B5EF4-FFF2-40B4-BE49-F238E27FC236}">
                  <a16:creationId xmlns:a16="http://schemas.microsoft.com/office/drawing/2014/main" id="{A47F46B1-EB4D-944E-BEB1-9672AB56BEC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856875" y="4310242"/>
              <a:ext cx="0" cy="79783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8" name="Rectangle 53">
              <a:extLst>
                <a:ext uri="{FF2B5EF4-FFF2-40B4-BE49-F238E27FC236}">
                  <a16:creationId xmlns:a16="http://schemas.microsoft.com/office/drawing/2014/main" id="{8945F55F-1891-A643-B06F-89580052CB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64475" y="6021433"/>
              <a:ext cx="94022" cy="1848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kumimoji="1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9" name="Rectangle 54">
              <a:extLst>
                <a:ext uri="{FF2B5EF4-FFF2-40B4-BE49-F238E27FC236}">
                  <a16:creationId xmlns:a16="http://schemas.microsoft.com/office/drawing/2014/main" id="{27B6A663-78E4-2C45-8975-6FF8772A863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06420" y="6021433"/>
              <a:ext cx="94022" cy="1848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kumimoji="1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0" name="Rectangle 55">
              <a:extLst>
                <a:ext uri="{FF2B5EF4-FFF2-40B4-BE49-F238E27FC236}">
                  <a16:creationId xmlns:a16="http://schemas.microsoft.com/office/drawing/2014/main" id="{E20C2FB2-6165-C647-B8AB-951349A0BE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58092" y="6021433"/>
              <a:ext cx="94022" cy="1848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1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1" name="Rectangle 56">
              <a:extLst>
                <a:ext uri="{FF2B5EF4-FFF2-40B4-BE49-F238E27FC236}">
                  <a16:creationId xmlns:a16="http://schemas.microsoft.com/office/drawing/2014/main" id="{48C77F63-AC20-DF4C-84B2-19BDE9008F8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00037" y="6021433"/>
              <a:ext cx="94022" cy="1848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1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2" name="Rectangle 57">
              <a:extLst>
                <a:ext uri="{FF2B5EF4-FFF2-40B4-BE49-F238E27FC236}">
                  <a16:creationId xmlns:a16="http://schemas.microsoft.com/office/drawing/2014/main" id="{513CFE5C-6CB2-FC47-9EBC-1805C7F721E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51708" y="6021433"/>
              <a:ext cx="94022" cy="1848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3" name="Rectangle 58">
              <a:extLst>
                <a:ext uri="{FF2B5EF4-FFF2-40B4-BE49-F238E27FC236}">
                  <a16:creationId xmlns:a16="http://schemas.microsoft.com/office/drawing/2014/main" id="{13F68A2E-AF2E-7542-ACDA-6A2EB5A799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93653" y="6021433"/>
              <a:ext cx="94022" cy="1848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4" name="Rectangle 59">
              <a:extLst>
                <a:ext uri="{FF2B5EF4-FFF2-40B4-BE49-F238E27FC236}">
                  <a16:creationId xmlns:a16="http://schemas.microsoft.com/office/drawing/2014/main" id="{33A2A187-6791-724C-B8D7-53359BD2C9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35598" y="6021433"/>
              <a:ext cx="94022" cy="1848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5" name="Rectangle 60">
              <a:extLst>
                <a:ext uri="{FF2B5EF4-FFF2-40B4-BE49-F238E27FC236}">
                  <a16:creationId xmlns:a16="http://schemas.microsoft.com/office/drawing/2014/main" id="{1D583B0D-6534-C84E-8076-FAB2F58D62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87270" y="6021433"/>
              <a:ext cx="94022" cy="1848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6" name="Rectangle 61">
              <a:extLst>
                <a:ext uri="{FF2B5EF4-FFF2-40B4-BE49-F238E27FC236}">
                  <a16:creationId xmlns:a16="http://schemas.microsoft.com/office/drawing/2014/main" id="{DB58F1A4-70DC-9244-B923-503C01D1BA7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64475" y="5830556"/>
              <a:ext cx="94022" cy="1848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</a:t>
              </a:r>
              <a:endParaRPr kumimoji="1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7" name="Rectangle 62">
              <a:extLst>
                <a:ext uri="{FF2B5EF4-FFF2-40B4-BE49-F238E27FC236}">
                  <a16:creationId xmlns:a16="http://schemas.microsoft.com/office/drawing/2014/main" id="{8871D3F6-86B1-CE41-A3BD-91CB474365B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06420" y="5830556"/>
              <a:ext cx="94022" cy="1848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  <a:endParaRPr kumimoji="1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8" name="Rectangle 63">
              <a:extLst>
                <a:ext uri="{FF2B5EF4-FFF2-40B4-BE49-F238E27FC236}">
                  <a16:creationId xmlns:a16="http://schemas.microsoft.com/office/drawing/2014/main" id="{27E941A4-599B-2645-A973-CBC0417795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58092" y="5830556"/>
              <a:ext cx="94022" cy="1848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kumimoji="1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9" name="Rectangle 64">
              <a:extLst>
                <a:ext uri="{FF2B5EF4-FFF2-40B4-BE49-F238E27FC236}">
                  <a16:creationId xmlns:a16="http://schemas.microsoft.com/office/drawing/2014/main" id="{18EFC71F-9FC3-EE40-9E27-E024B47D20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00037" y="5830556"/>
              <a:ext cx="94022" cy="1848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kumimoji="1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0" name="Rectangle 65">
              <a:extLst>
                <a:ext uri="{FF2B5EF4-FFF2-40B4-BE49-F238E27FC236}">
                  <a16:creationId xmlns:a16="http://schemas.microsoft.com/office/drawing/2014/main" id="{0DC9C20B-AF48-A940-B02E-F9EE56331AC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51708" y="5830556"/>
              <a:ext cx="94022" cy="1848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1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1" name="Rectangle 66">
              <a:extLst>
                <a:ext uri="{FF2B5EF4-FFF2-40B4-BE49-F238E27FC236}">
                  <a16:creationId xmlns:a16="http://schemas.microsoft.com/office/drawing/2014/main" id="{6FCA2001-1146-1142-B4BC-3AD99E6D71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93653" y="5830556"/>
              <a:ext cx="94022" cy="1848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1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2" name="Rectangle 67">
              <a:extLst>
                <a:ext uri="{FF2B5EF4-FFF2-40B4-BE49-F238E27FC236}">
                  <a16:creationId xmlns:a16="http://schemas.microsoft.com/office/drawing/2014/main" id="{008FCCB2-9022-3040-A95D-F110B2AC619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35598" y="5830556"/>
              <a:ext cx="94022" cy="1848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1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3" name="Rectangle 68">
              <a:extLst>
                <a:ext uri="{FF2B5EF4-FFF2-40B4-BE49-F238E27FC236}">
                  <a16:creationId xmlns:a16="http://schemas.microsoft.com/office/drawing/2014/main" id="{CE002EAD-CC20-FE44-8B68-C23770FE1C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87270" y="5830556"/>
              <a:ext cx="94022" cy="1848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1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6" name="Rectangle 71">
              <a:extLst>
                <a:ext uri="{FF2B5EF4-FFF2-40B4-BE49-F238E27FC236}">
                  <a16:creationId xmlns:a16="http://schemas.microsoft.com/office/drawing/2014/main" id="{BEB85FDD-3CEB-8947-9561-206C31D532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4777" y="5554861"/>
              <a:ext cx="1128267" cy="1848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umber at risk</a:t>
              </a:r>
              <a:endParaRPr kumimoji="1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7" name="Line 72">
              <a:extLst>
                <a:ext uri="{FF2B5EF4-FFF2-40B4-BE49-F238E27FC236}">
                  <a16:creationId xmlns:a16="http://schemas.microsoft.com/office/drawing/2014/main" id="{97206C31-5424-1044-A07D-7B2029FEED4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970788" y="2424752"/>
              <a:ext cx="282067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8" name="Line 73">
              <a:extLst>
                <a:ext uri="{FF2B5EF4-FFF2-40B4-BE49-F238E27FC236}">
                  <a16:creationId xmlns:a16="http://schemas.microsoft.com/office/drawing/2014/main" id="{391946FD-D09E-2C4E-9BBB-27BB5E339EC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965666" y="2022497"/>
              <a:ext cx="282067" cy="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2" name="Rectangle 30">
              <a:extLst>
                <a:ext uri="{FF2B5EF4-FFF2-40B4-BE49-F238E27FC236}">
                  <a16:creationId xmlns:a16="http://schemas.microsoft.com/office/drawing/2014/main" id="{D8A1F692-DB55-184F-A500-9B51782A22B8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62592" y="3205072"/>
              <a:ext cx="1822615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en-US" altLang="ja-JP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rogression-free survival (%)</a:t>
              </a:r>
              <a:endParaRPr kumimoji="1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3" name="正方形/長方形 142">
              <a:extLst>
                <a:ext uri="{FF2B5EF4-FFF2-40B4-BE49-F238E27FC236}">
                  <a16:creationId xmlns:a16="http://schemas.microsoft.com/office/drawing/2014/main" id="{602988C5-F56E-3F4A-A645-2BDF2D0ED1B6}"/>
                </a:ext>
              </a:extLst>
            </p:cNvPr>
            <p:cNvSpPr/>
            <p:nvPr/>
          </p:nvSpPr>
          <p:spPr>
            <a:xfrm>
              <a:off x="4965666" y="2922014"/>
              <a:ext cx="162095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g-rank test: </a:t>
              </a:r>
              <a:r>
                <a:rPr lang="en-US" altLang="ja-JP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= 0.08</a:t>
              </a:r>
              <a:endPara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2" name="Rectangle 108">
              <a:extLst>
                <a:ext uri="{FF2B5EF4-FFF2-40B4-BE49-F238E27FC236}">
                  <a16:creationId xmlns:a16="http://schemas.microsoft.com/office/drawing/2014/main" id="{A0B03B9D-A0B0-174A-8E1A-6522F9B4CF6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83854" y="1930164"/>
              <a:ext cx="103945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defPPr>
                <a:defRPr lang="ja-JP"/>
              </a:defPPr>
              <a:lvl1pPr marL="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P pattern (n=9)</a:t>
              </a:r>
              <a:endParaRPr kumimoji="1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" name="Rectangle 108">
              <a:extLst>
                <a:ext uri="{FF2B5EF4-FFF2-40B4-BE49-F238E27FC236}">
                  <a16:creationId xmlns:a16="http://schemas.microsoft.com/office/drawing/2014/main" id="{E31792A6-2B6F-5B40-89F6-494B940D428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72698" y="2291725"/>
              <a:ext cx="135524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defPPr>
                <a:defRPr lang="ja-JP"/>
              </a:defPPr>
              <a:lvl1pPr marL="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on-OP pattern (n=7)</a:t>
              </a:r>
              <a:endParaRPr kumimoji="1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8125542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554</Words>
  <Application>Microsoft Macintosh PowerPoint</Application>
  <PresentationFormat>画面に合わせる (4:3)</PresentationFormat>
  <Paragraphs>216</Paragraphs>
  <Slides>4</Slides>
  <Notes>3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13" baseType="lpstr">
      <vt:lpstr>ＭＳ Ｐゴシック</vt:lpstr>
      <vt:lpstr>游ゴシック</vt:lpstr>
      <vt:lpstr>游ゴシック Light</vt:lpstr>
      <vt:lpstr>游明朝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subject/>
  <dc:creator/>
  <cp:keywords/>
  <dc:description/>
  <cp:lastModifiedBy/>
  <cp:revision>1</cp:revision>
  <dcterms:created xsi:type="dcterms:W3CDTF">2020-02-05T05:18:44Z</dcterms:created>
  <dcterms:modified xsi:type="dcterms:W3CDTF">2020-02-05T09:36:31Z</dcterms:modified>
  <cp:category/>
</cp:coreProperties>
</file>